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6" r:id="rId3"/>
    <p:sldId id="263" r:id="rId4"/>
    <p:sldId id="285" r:id="rId5"/>
    <p:sldId id="284" r:id="rId6"/>
    <p:sldId id="287" r:id="rId7"/>
    <p:sldId id="275" r:id="rId8"/>
    <p:sldId id="276" r:id="rId9"/>
    <p:sldId id="278" r:id="rId10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9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39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626" y="114"/>
      </p:cViewPr>
      <p:guideLst>
        <p:guide orient="horz" pos="2659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375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086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595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0728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780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852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786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8764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933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0695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392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F9735-B86D-492E-B588-05EAD26FB8E8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96389-F79C-42E7-B04B-B279750745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323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9E341EDD-1C8F-DF08-E6FD-5996B494550E}"/>
              </a:ext>
            </a:extLst>
          </p:cNvPr>
          <p:cNvGrpSpPr/>
          <p:nvPr/>
        </p:nvGrpSpPr>
        <p:grpSpPr>
          <a:xfrm>
            <a:off x="1989983" y="858710"/>
            <a:ext cx="4337705" cy="3694376"/>
            <a:chOff x="1671201" y="1726971"/>
            <a:chExt cx="4337705" cy="3694376"/>
          </a:xfrm>
        </p:grpSpPr>
        <p:sp>
          <p:nvSpPr>
            <p:cNvPr id="7" name="Line 5">
              <a:extLst>
                <a:ext uri="{FF2B5EF4-FFF2-40B4-BE49-F238E27FC236}">
                  <a16:creationId xmlns:a16="http://schemas.microsoft.com/office/drawing/2014/main" id="{7F87FB98-9DA1-4AAC-BA46-497619AAEE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84706" y="4554056"/>
              <a:ext cx="27813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Line 6">
              <a:extLst>
                <a:ext uri="{FF2B5EF4-FFF2-40B4-BE49-F238E27FC236}">
                  <a16:creationId xmlns:a16="http://schemas.microsoft.com/office/drawing/2014/main" id="{927FA4A8-0E0A-4EDF-83E8-0F47001D6F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84706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7">
              <a:extLst>
                <a:ext uri="{FF2B5EF4-FFF2-40B4-BE49-F238E27FC236}">
                  <a16:creationId xmlns:a16="http://schemas.microsoft.com/office/drawing/2014/main" id="{4FE9624E-A8FA-40F0-B5A9-B133394BD3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5081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8">
              <a:extLst>
                <a:ext uri="{FF2B5EF4-FFF2-40B4-BE49-F238E27FC236}">
                  <a16:creationId xmlns:a16="http://schemas.microsoft.com/office/drawing/2014/main" id="{EDBB5355-D253-4812-B7C5-8690F97842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1806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9">
              <a:extLst>
                <a:ext uri="{FF2B5EF4-FFF2-40B4-BE49-F238E27FC236}">
                  <a16:creationId xmlns:a16="http://schemas.microsoft.com/office/drawing/2014/main" id="{472277AA-A1D2-47E4-ACB8-8EE3B8FD15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72181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10">
              <a:extLst>
                <a:ext uri="{FF2B5EF4-FFF2-40B4-BE49-F238E27FC236}">
                  <a16:creationId xmlns:a16="http://schemas.microsoft.com/office/drawing/2014/main" id="{F3FA5E6C-A4F4-4202-8EA8-8C5E512C97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38906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1">
              <a:extLst>
                <a:ext uri="{FF2B5EF4-FFF2-40B4-BE49-F238E27FC236}">
                  <a16:creationId xmlns:a16="http://schemas.microsoft.com/office/drawing/2014/main" id="{A54F333A-E6CD-476B-BBDB-4338B05E8C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4044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2">
              <a:extLst>
                <a:ext uri="{FF2B5EF4-FFF2-40B4-BE49-F238E27FC236}">
                  <a16:creationId xmlns:a16="http://schemas.microsoft.com/office/drawing/2014/main" id="{15A27AB6-02F1-4495-869F-5DDE668902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6006" y="4554056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3">
              <a:extLst>
                <a:ext uri="{FF2B5EF4-FFF2-40B4-BE49-F238E27FC236}">
                  <a16:creationId xmlns:a16="http://schemas.microsoft.com/office/drawing/2014/main" id="{65062447-C847-4FA3-B907-2A023C769E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669" y="467629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4">
              <a:extLst>
                <a:ext uri="{FF2B5EF4-FFF2-40B4-BE49-F238E27FC236}">
                  <a16:creationId xmlns:a16="http://schemas.microsoft.com/office/drawing/2014/main" id="{9010F186-207F-4E4F-87C8-398E569D0A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0469" y="467629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5">
              <a:extLst>
                <a:ext uri="{FF2B5EF4-FFF2-40B4-BE49-F238E27FC236}">
                  <a16:creationId xmlns:a16="http://schemas.microsoft.com/office/drawing/2014/main" id="{F0B247A3-E86E-4B0C-A74E-7510EB26CC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7194" y="467629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6">
              <a:extLst>
                <a:ext uri="{FF2B5EF4-FFF2-40B4-BE49-F238E27FC236}">
                  <a16:creationId xmlns:a16="http://schemas.microsoft.com/office/drawing/2014/main" id="{778D098B-CF9B-497D-82A2-3E823E8F6B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7569" y="467629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7">
              <a:extLst>
                <a:ext uri="{FF2B5EF4-FFF2-40B4-BE49-F238E27FC236}">
                  <a16:creationId xmlns:a16="http://schemas.microsoft.com/office/drawing/2014/main" id="{CA8060B5-D8BB-42B5-B079-3302C560C0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4294" y="467629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8">
              <a:extLst>
                <a:ext uri="{FF2B5EF4-FFF2-40B4-BE49-F238E27FC236}">
                  <a16:creationId xmlns:a16="http://schemas.microsoft.com/office/drawing/2014/main" id="{C453B9E0-7862-4963-B9DF-2C9B86466C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2444" y="4676294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9">
              <a:extLst>
                <a:ext uri="{FF2B5EF4-FFF2-40B4-BE49-F238E27FC236}">
                  <a16:creationId xmlns:a16="http://schemas.microsoft.com/office/drawing/2014/main" id="{D8A8752B-6319-40AE-89E7-95976C23F8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4406" y="4676294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20">
              <a:extLst>
                <a:ext uri="{FF2B5EF4-FFF2-40B4-BE49-F238E27FC236}">
                  <a16:creationId xmlns:a16="http://schemas.microsoft.com/office/drawing/2014/main" id="{5F27003D-D030-46E1-8927-F944C0D4BF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3581" y="2034694"/>
              <a:ext cx="0" cy="24193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1">
              <a:extLst>
                <a:ext uri="{FF2B5EF4-FFF2-40B4-BE49-F238E27FC236}">
                  <a16:creationId xmlns:a16="http://schemas.microsoft.com/office/drawing/2014/main" id="{9EA8CFD1-044D-48FC-9CE9-9C0A8D3964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14844" y="4454044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2">
              <a:extLst>
                <a:ext uri="{FF2B5EF4-FFF2-40B4-BE49-F238E27FC236}">
                  <a16:creationId xmlns:a16="http://schemas.microsoft.com/office/drawing/2014/main" id="{90108C31-AC97-43E7-95B4-59BC921247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14844" y="3969856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3">
              <a:extLst>
                <a:ext uri="{FF2B5EF4-FFF2-40B4-BE49-F238E27FC236}">
                  <a16:creationId xmlns:a16="http://schemas.microsoft.com/office/drawing/2014/main" id="{15528126-164F-434C-92D8-D265855616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14844" y="3485669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4">
              <a:extLst>
                <a:ext uri="{FF2B5EF4-FFF2-40B4-BE49-F238E27FC236}">
                  <a16:creationId xmlns:a16="http://schemas.microsoft.com/office/drawing/2014/main" id="{4EB568FD-04A9-4AAE-89C0-752A36EDA4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14844" y="3003069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5">
              <a:extLst>
                <a:ext uri="{FF2B5EF4-FFF2-40B4-BE49-F238E27FC236}">
                  <a16:creationId xmlns:a16="http://schemas.microsoft.com/office/drawing/2014/main" id="{A767CC82-D351-44ED-9C9A-17298C133D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14844" y="2518881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6">
              <a:extLst>
                <a:ext uri="{FF2B5EF4-FFF2-40B4-BE49-F238E27FC236}">
                  <a16:creationId xmlns:a16="http://schemas.microsoft.com/office/drawing/2014/main" id="{B19F6D39-E22F-49B4-ABF7-C7690CD910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714844" y="2034694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7">
              <a:extLst>
                <a:ext uri="{FF2B5EF4-FFF2-40B4-BE49-F238E27FC236}">
                  <a16:creationId xmlns:a16="http://schemas.microsoft.com/office/drawing/2014/main" id="{8EBEA3A8-3C85-4D5F-9D0D-4DDE08658D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107" y="437011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8">
              <a:extLst>
                <a:ext uri="{FF2B5EF4-FFF2-40B4-BE49-F238E27FC236}">
                  <a16:creationId xmlns:a16="http://schemas.microsoft.com/office/drawing/2014/main" id="{03588E1D-9191-4407-BD3B-C0E73639DA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107" y="3885925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9">
              <a:extLst>
                <a:ext uri="{FF2B5EF4-FFF2-40B4-BE49-F238E27FC236}">
                  <a16:creationId xmlns:a16="http://schemas.microsoft.com/office/drawing/2014/main" id="{7FDC4B1F-5896-452E-B295-15B36CE027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107" y="340173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0">
              <a:extLst>
                <a:ext uri="{FF2B5EF4-FFF2-40B4-BE49-F238E27FC236}">
                  <a16:creationId xmlns:a16="http://schemas.microsoft.com/office/drawing/2014/main" id="{C24226B6-15B3-46C3-8DC6-236FB3DCF8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107" y="291755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1">
              <a:extLst>
                <a:ext uri="{FF2B5EF4-FFF2-40B4-BE49-F238E27FC236}">
                  <a16:creationId xmlns:a16="http://schemas.microsoft.com/office/drawing/2014/main" id="{D9D17A66-12CD-4C6D-991F-23D399CA6E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107" y="243336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2">
              <a:extLst>
                <a:ext uri="{FF2B5EF4-FFF2-40B4-BE49-F238E27FC236}">
                  <a16:creationId xmlns:a16="http://schemas.microsoft.com/office/drawing/2014/main" id="{DD8E6276-C516-407D-87DE-14BDCD713C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107" y="195076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33">
              <a:extLst>
                <a:ext uri="{FF2B5EF4-FFF2-40B4-BE49-F238E27FC236}">
                  <a16:creationId xmlns:a16="http://schemas.microsoft.com/office/drawing/2014/main" id="{F03655FE-E4BA-49CD-823B-1A57FBF2C5E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3581" y="1934681"/>
              <a:ext cx="3001963" cy="2619375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6">
              <a:extLst>
                <a:ext uri="{FF2B5EF4-FFF2-40B4-BE49-F238E27FC236}">
                  <a16:creationId xmlns:a16="http://schemas.microsoft.com/office/drawing/2014/main" id="{2D81DF23-C6D3-4043-9733-458D8211275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05671" y="3220396"/>
              <a:ext cx="74263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7">
              <a:extLst>
                <a:ext uri="{FF2B5EF4-FFF2-40B4-BE49-F238E27FC236}">
                  <a16:creationId xmlns:a16="http://schemas.microsoft.com/office/drawing/2014/main" id="{1CF5601F-0E1E-4956-92CF-B7AE96AE9F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4706" y="2034694"/>
              <a:ext cx="3124200" cy="198438"/>
            </a:xfrm>
            <a:custGeom>
              <a:avLst/>
              <a:gdLst>
                <a:gd name="T0" fmla="*/ 0 w 536"/>
                <a:gd name="T1" fmla="*/ 0 h 34"/>
                <a:gd name="T2" fmla="*/ 28 w 536"/>
                <a:gd name="T3" fmla="*/ 0 h 34"/>
                <a:gd name="T4" fmla="*/ 28 w 536"/>
                <a:gd name="T5" fmla="*/ 1 h 34"/>
                <a:gd name="T6" fmla="*/ 43 w 536"/>
                <a:gd name="T7" fmla="*/ 1 h 34"/>
                <a:gd name="T8" fmla="*/ 43 w 536"/>
                <a:gd name="T9" fmla="*/ 3 h 34"/>
                <a:gd name="T10" fmla="*/ 47 w 536"/>
                <a:gd name="T11" fmla="*/ 3 h 34"/>
                <a:gd name="T12" fmla="*/ 47 w 536"/>
                <a:gd name="T13" fmla="*/ 4 h 34"/>
                <a:gd name="T14" fmla="*/ 51 w 536"/>
                <a:gd name="T15" fmla="*/ 4 h 34"/>
                <a:gd name="T16" fmla="*/ 51 w 536"/>
                <a:gd name="T17" fmla="*/ 6 h 34"/>
                <a:gd name="T18" fmla="*/ 95 w 536"/>
                <a:gd name="T19" fmla="*/ 6 h 34"/>
                <a:gd name="T20" fmla="*/ 95 w 536"/>
                <a:gd name="T21" fmla="*/ 7 h 34"/>
                <a:gd name="T22" fmla="*/ 123 w 536"/>
                <a:gd name="T23" fmla="*/ 7 h 34"/>
                <a:gd name="T24" fmla="*/ 123 w 536"/>
                <a:gd name="T25" fmla="*/ 9 h 34"/>
                <a:gd name="T26" fmla="*/ 135 w 536"/>
                <a:gd name="T27" fmla="*/ 9 h 34"/>
                <a:gd name="T28" fmla="*/ 135 w 536"/>
                <a:gd name="T29" fmla="*/ 10 h 34"/>
                <a:gd name="T30" fmla="*/ 167 w 536"/>
                <a:gd name="T31" fmla="*/ 10 h 34"/>
                <a:gd name="T32" fmla="*/ 167 w 536"/>
                <a:gd name="T33" fmla="*/ 12 h 34"/>
                <a:gd name="T34" fmla="*/ 171 w 536"/>
                <a:gd name="T35" fmla="*/ 12 h 34"/>
                <a:gd name="T36" fmla="*/ 171 w 536"/>
                <a:gd name="T37" fmla="*/ 14 h 34"/>
                <a:gd name="T38" fmla="*/ 207 w 536"/>
                <a:gd name="T39" fmla="*/ 14 h 34"/>
                <a:gd name="T40" fmla="*/ 207 w 536"/>
                <a:gd name="T41" fmla="*/ 17 h 34"/>
                <a:gd name="T42" fmla="*/ 211 w 536"/>
                <a:gd name="T43" fmla="*/ 17 h 34"/>
                <a:gd name="T44" fmla="*/ 211 w 536"/>
                <a:gd name="T45" fmla="*/ 21 h 34"/>
                <a:gd name="T46" fmla="*/ 219 w 536"/>
                <a:gd name="T47" fmla="*/ 21 h 34"/>
                <a:gd name="T48" fmla="*/ 219 w 536"/>
                <a:gd name="T49" fmla="*/ 23 h 34"/>
                <a:gd name="T50" fmla="*/ 226 w 536"/>
                <a:gd name="T51" fmla="*/ 23 h 34"/>
                <a:gd name="T52" fmla="*/ 226 w 536"/>
                <a:gd name="T53" fmla="*/ 26 h 34"/>
                <a:gd name="T54" fmla="*/ 282 w 536"/>
                <a:gd name="T55" fmla="*/ 26 h 34"/>
                <a:gd name="T56" fmla="*/ 282 w 536"/>
                <a:gd name="T57" fmla="*/ 29 h 34"/>
                <a:gd name="T58" fmla="*/ 330 w 536"/>
                <a:gd name="T59" fmla="*/ 29 h 34"/>
                <a:gd name="T60" fmla="*/ 330 w 536"/>
                <a:gd name="T61" fmla="*/ 34 h 34"/>
                <a:gd name="T62" fmla="*/ 536 w 536"/>
                <a:gd name="T63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536" h="34">
                  <a:moveTo>
                    <a:pt x="0" y="0"/>
                  </a:moveTo>
                  <a:lnTo>
                    <a:pt x="28" y="0"/>
                  </a:lnTo>
                  <a:lnTo>
                    <a:pt x="28" y="1"/>
                  </a:lnTo>
                  <a:lnTo>
                    <a:pt x="43" y="1"/>
                  </a:lnTo>
                  <a:lnTo>
                    <a:pt x="43" y="3"/>
                  </a:lnTo>
                  <a:lnTo>
                    <a:pt x="47" y="3"/>
                  </a:lnTo>
                  <a:lnTo>
                    <a:pt x="47" y="4"/>
                  </a:lnTo>
                  <a:lnTo>
                    <a:pt x="51" y="4"/>
                  </a:lnTo>
                  <a:lnTo>
                    <a:pt x="51" y="6"/>
                  </a:lnTo>
                  <a:lnTo>
                    <a:pt x="95" y="6"/>
                  </a:lnTo>
                  <a:lnTo>
                    <a:pt x="95" y="7"/>
                  </a:lnTo>
                  <a:lnTo>
                    <a:pt x="123" y="7"/>
                  </a:lnTo>
                  <a:lnTo>
                    <a:pt x="123" y="9"/>
                  </a:lnTo>
                  <a:lnTo>
                    <a:pt x="135" y="9"/>
                  </a:lnTo>
                  <a:lnTo>
                    <a:pt x="135" y="10"/>
                  </a:lnTo>
                  <a:lnTo>
                    <a:pt x="167" y="10"/>
                  </a:lnTo>
                  <a:lnTo>
                    <a:pt x="167" y="12"/>
                  </a:lnTo>
                  <a:lnTo>
                    <a:pt x="171" y="12"/>
                  </a:lnTo>
                  <a:lnTo>
                    <a:pt x="171" y="14"/>
                  </a:lnTo>
                  <a:lnTo>
                    <a:pt x="207" y="14"/>
                  </a:lnTo>
                  <a:lnTo>
                    <a:pt x="207" y="17"/>
                  </a:lnTo>
                  <a:lnTo>
                    <a:pt x="211" y="17"/>
                  </a:lnTo>
                  <a:lnTo>
                    <a:pt x="211" y="21"/>
                  </a:lnTo>
                  <a:lnTo>
                    <a:pt x="219" y="21"/>
                  </a:lnTo>
                  <a:lnTo>
                    <a:pt x="219" y="23"/>
                  </a:lnTo>
                  <a:lnTo>
                    <a:pt x="226" y="23"/>
                  </a:lnTo>
                  <a:lnTo>
                    <a:pt x="226" y="26"/>
                  </a:lnTo>
                  <a:lnTo>
                    <a:pt x="282" y="26"/>
                  </a:lnTo>
                  <a:lnTo>
                    <a:pt x="282" y="29"/>
                  </a:lnTo>
                  <a:lnTo>
                    <a:pt x="330" y="29"/>
                  </a:lnTo>
                  <a:lnTo>
                    <a:pt x="330" y="34"/>
                  </a:lnTo>
                  <a:lnTo>
                    <a:pt x="536" y="34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38">
              <a:extLst>
                <a:ext uri="{FF2B5EF4-FFF2-40B4-BE49-F238E27FC236}">
                  <a16:creationId xmlns:a16="http://schemas.microsoft.com/office/drawing/2014/main" id="{F641AAF7-98BC-4662-B66C-C3CB7EAD9599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4706" y="2034694"/>
              <a:ext cx="3124200" cy="80963"/>
            </a:xfrm>
            <a:custGeom>
              <a:avLst/>
              <a:gdLst>
                <a:gd name="T0" fmla="*/ 0 w 536"/>
                <a:gd name="T1" fmla="*/ 0 h 14"/>
                <a:gd name="T2" fmla="*/ 49 w 536"/>
                <a:gd name="T3" fmla="*/ 0 h 14"/>
                <a:gd name="T4" fmla="*/ 49 w 536"/>
                <a:gd name="T5" fmla="*/ 2 h 14"/>
                <a:gd name="T6" fmla="*/ 114 w 536"/>
                <a:gd name="T7" fmla="*/ 2 h 14"/>
                <a:gd name="T8" fmla="*/ 114 w 536"/>
                <a:gd name="T9" fmla="*/ 4 h 14"/>
                <a:gd name="T10" fmla="*/ 134 w 536"/>
                <a:gd name="T11" fmla="*/ 4 h 14"/>
                <a:gd name="T12" fmla="*/ 134 w 536"/>
                <a:gd name="T13" fmla="*/ 6 h 14"/>
                <a:gd name="T14" fmla="*/ 190 w 536"/>
                <a:gd name="T15" fmla="*/ 6 h 14"/>
                <a:gd name="T16" fmla="*/ 190 w 536"/>
                <a:gd name="T17" fmla="*/ 8 h 14"/>
                <a:gd name="T18" fmla="*/ 230 w 536"/>
                <a:gd name="T19" fmla="*/ 8 h 14"/>
                <a:gd name="T20" fmla="*/ 230 w 536"/>
                <a:gd name="T21" fmla="*/ 11 h 14"/>
                <a:gd name="T22" fmla="*/ 261 w 536"/>
                <a:gd name="T23" fmla="*/ 11 h 14"/>
                <a:gd name="T24" fmla="*/ 261 w 536"/>
                <a:gd name="T25" fmla="*/ 14 h 14"/>
                <a:gd name="T26" fmla="*/ 536 w 536"/>
                <a:gd name="T27" fmla="*/ 14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536" h="14">
                  <a:moveTo>
                    <a:pt x="0" y="0"/>
                  </a:moveTo>
                  <a:lnTo>
                    <a:pt x="49" y="0"/>
                  </a:lnTo>
                  <a:lnTo>
                    <a:pt x="49" y="2"/>
                  </a:lnTo>
                  <a:lnTo>
                    <a:pt x="114" y="2"/>
                  </a:lnTo>
                  <a:lnTo>
                    <a:pt x="114" y="4"/>
                  </a:lnTo>
                  <a:lnTo>
                    <a:pt x="134" y="4"/>
                  </a:lnTo>
                  <a:lnTo>
                    <a:pt x="134" y="6"/>
                  </a:lnTo>
                  <a:lnTo>
                    <a:pt x="190" y="6"/>
                  </a:lnTo>
                  <a:lnTo>
                    <a:pt x="190" y="8"/>
                  </a:lnTo>
                  <a:lnTo>
                    <a:pt x="230" y="8"/>
                  </a:lnTo>
                  <a:lnTo>
                    <a:pt x="230" y="11"/>
                  </a:lnTo>
                  <a:lnTo>
                    <a:pt x="261" y="11"/>
                  </a:lnTo>
                  <a:lnTo>
                    <a:pt x="261" y="14"/>
                  </a:lnTo>
                  <a:lnTo>
                    <a:pt x="536" y="14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39">
              <a:extLst>
                <a:ext uri="{FF2B5EF4-FFF2-40B4-BE49-F238E27FC236}">
                  <a16:creationId xmlns:a16="http://schemas.microsoft.com/office/drawing/2014/main" id="{74473E7F-E5B9-4D89-BDF0-6CE0E79DED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6" y="497455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5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0">
              <a:extLst>
                <a:ext uri="{FF2B5EF4-FFF2-40B4-BE49-F238E27FC236}">
                  <a16:creationId xmlns:a16="http://schemas.microsoft.com/office/drawing/2014/main" id="{9A021DFB-AB2E-4F11-9936-6FA69B23E5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3481" y="497455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4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1">
              <a:extLst>
                <a:ext uri="{FF2B5EF4-FFF2-40B4-BE49-F238E27FC236}">
                  <a16:creationId xmlns:a16="http://schemas.microsoft.com/office/drawing/2014/main" id="{82904203-9C62-4190-8EFD-8B6E307425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0206" y="497455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2">
              <a:extLst>
                <a:ext uri="{FF2B5EF4-FFF2-40B4-BE49-F238E27FC236}">
                  <a16:creationId xmlns:a16="http://schemas.microsoft.com/office/drawing/2014/main" id="{60D9E47F-C282-4C21-8C35-0633EF4886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0581" y="497455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7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3">
              <a:extLst>
                <a:ext uri="{FF2B5EF4-FFF2-40B4-BE49-F238E27FC236}">
                  <a16:creationId xmlns:a16="http://schemas.microsoft.com/office/drawing/2014/main" id="{B30474CA-8244-4991-8F65-F49119402E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4294" y="497455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4">
              <a:extLst>
                <a:ext uri="{FF2B5EF4-FFF2-40B4-BE49-F238E27FC236}">
                  <a16:creationId xmlns:a16="http://schemas.microsoft.com/office/drawing/2014/main" id="{274F33C0-E07D-4814-8DE2-05025445A3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9431" y="497455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5">
              <a:extLst>
                <a:ext uri="{FF2B5EF4-FFF2-40B4-BE49-F238E27FC236}">
                  <a16:creationId xmlns:a16="http://schemas.microsoft.com/office/drawing/2014/main" id="{49CA7A78-D592-4AB0-B412-8C88C974C6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1394" y="497455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6">
              <a:extLst>
                <a:ext uri="{FF2B5EF4-FFF2-40B4-BE49-F238E27FC236}">
                  <a16:creationId xmlns:a16="http://schemas.microsoft.com/office/drawing/2014/main" id="{49602890-1229-44CD-91B1-700FAA36E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6" y="5236681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4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7">
              <a:extLst>
                <a:ext uri="{FF2B5EF4-FFF2-40B4-BE49-F238E27FC236}">
                  <a16:creationId xmlns:a16="http://schemas.microsoft.com/office/drawing/2014/main" id="{801C61EE-640C-46C6-8CDC-26B79F9650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3481" y="5236681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9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DB55107C-A925-41F6-A8BB-FD94DFA100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0206" y="5236681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89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49">
              <a:extLst>
                <a:ext uri="{FF2B5EF4-FFF2-40B4-BE49-F238E27FC236}">
                  <a16:creationId xmlns:a16="http://schemas.microsoft.com/office/drawing/2014/main" id="{FBD3526D-148E-41AB-9879-D5668FE38C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0581" y="5236681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0">
              <a:extLst>
                <a:ext uri="{FF2B5EF4-FFF2-40B4-BE49-F238E27FC236}">
                  <a16:creationId xmlns:a16="http://schemas.microsoft.com/office/drawing/2014/main" id="{1EF0957A-1864-4686-9282-828515D4E7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4294" y="5236681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3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1">
              <a:extLst>
                <a:ext uri="{FF2B5EF4-FFF2-40B4-BE49-F238E27FC236}">
                  <a16:creationId xmlns:a16="http://schemas.microsoft.com/office/drawing/2014/main" id="{EE1337CD-81C5-4CEE-B81F-0E11BE4243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9431" y="5236681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2">
              <a:extLst>
                <a:ext uri="{FF2B5EF4-FFF2-40B4-BE49-F238E27FC236}">
                  <a16:creationId xmlns:a16="http://schemas.microsoft.com/office/drawing/2014/main" id="{AEF70253-CA0B-4D9E-B131-22D51F540E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1394" y="5236681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3">
              <a:extLst>
                <a:ext uri="{FF2B5EF4-FFF2-40B4-BE49-F238E27FC236}">
                  <a16:creationId xmlns:a16="http://schemas.microsoft.com/office/drawing/2014/main" id="{EF4317CB-E601-401E-AEF6-722C72B97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6826" y="4974558"/>
              <a:ext cx="5903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54">
              <a:extLst>
                <a:ext uri="{FF2B5EF4-FFF2-40B4-BE49-F238E27FC236}">
                  <a16:creationId xmlns:a16="http://schemas.microsoft.com/office/drawing/2014/main" id="{DA27BDE9-6C11-4D2D-AD99-7669F0BDC7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3414" y="5236681"/>
              <a:ext cx="412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Line 55">
              <a:extLst>
                <a:ext uri="{FF2B5EF4-FFF2-40B4-BE49-F238E27FC236}">
                  <a16:creationId xmlns:a16="http://schemas.microsoft.com/office/drawing/2014/main" id="{2D5D7725-8815-4C15-B23F-9ADB23D58D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4827" y="2988240"/>
              <a:ext cx="163513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Line 56">
              <a:extLst>
                <a:ext uri="{FF2B5EF4-FFF2-40B4-BE49-F238E27FC236}">
                  <a16:creationId xmlns:a16="http://schemas.microsoft.com/office/drawing/2014/main" id="{0B08EC64-3724-4017-B48D-3244923928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4827" y="3216370"/>
              <a:ext cx="163513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58">
              <a:extLst>
                <a:ext uri="{FF2B5EF4-FFF2-40B4-BE49-F238E27FC236}">
                  <a16:creationId xmlns:a16="http://schemas.microsoft.com/office/drawing/2014/main" id="{DD55D958-D3EA-4C53-8AC3-124C55A460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5652" y="2888243"/>
              <a:ext cx="5903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59">
              <a:extLst>
                <a:ext uri="{FF2B5EF4-FFF2-40B4-BE49-F238E27FC236}">
                  <a16:creationId xmlns:a16="http://schemas.microsoft.com/office/drawing/2014/main" id="{A822D72B-A08E-4F98-9B7E-2998536BEE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5652" y="3117960"/>
              <a:ext cx="412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F798F2C6-2CFC-4E58-93A1-7E4E80B44D52}"/>
                </a:ext>
              </a:extLst>
            </p:cNvPr>
            <p:cNvSpPr txBox="1"/>
            <p:nvPr/>
          </p:nvSpPr>
          <p:spPr>
            <a:xfrm>
              <a:off x="3243481" y="3395205"/>
              <a:ext cx="1509241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696</a:t>
              </a:r>
            </a:p>
          </p:txBody>
        </p:sp>
        <p:sp>
          <p:nvSpPr>
            <p:cNvPr id="59" name="Rectangle 35">
              <a:extLst>
                <a:ext uri="{FF2B5EF4-FFF2-40B4-BE49-F238E27FC236}">
                  <a16:creationId xmlns:a16="http://schemas.microsoft.com/office/drawing/2014/main" id="{139D471E-4C53-47F5-A8B9-99B4FEAA15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6967" y="4262472"/>
              <a:ext cx="48571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72">
              <a:extLst>
                <a:ext uri="{FF2B5EF4-FFF2-40B4-BE49-F238E27FC236}">
                  <a16:creationId xmlns:a16="http://schemas.microsoft.com/office/drawing/2014/main" id="{A38E06C0-C0C6-4D05-87B9-61E97B826F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1201" y="4667654"/>
              <a:ext cx="1421840" cy="226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E3AA7A6D-7869-B559-353A-B1F254F5DECD}"/>
                </a:ext>
              </a:extLst>
            </p:cNvPr>
            <p:cNvSpPr txBox="1"/>
            <p:nvPr/>
          </p:nvSpPr>
          <p:spPr>
            <a:xfrm>
              <a:off x="1799599" y="1726971"/>
              <a:ext cx="44114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kumimoji="1"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75404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FA18B5B6-3426-4C78-8FCA-20E02511BD3B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5345" y="4151385"/>
            <a:ext cx="27813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9C11D532-3393-468C-8D59-B0ECD1F0232F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5345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1FAB9FA1-D1DE-4534-AEA0-EB752FFE7372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5720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CE99FF24-75B7-4A76-8B3B-04369F92B479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2445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5337591E-7303-42A4-BA47-01B61D29C6B4}"/>
              </a:ext>
            </a:extLst>
          </p:cNvPr>
          <p:cNvSpPr>
            <a:spLocks noChangeShapeType="1"/>
          </p:cNvSpPr>
          <p:nvPr/>
        </p:nvSpPr>
        <p:spPr bwMode="auto">
          <a:xfrm>
            <a:off x="4242820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5DDD1E5E-403D-415F-93C9-5AF996FDE94F}"/>
              </a:ext>
            </a:extLst>
          </p:cNvPr>
          <p:cNvSpPr>
            <a:spLocks noChangeShapeType="1"/>
          </p:cNvSpPr>
          <p:nvPr/>
        </p:nvSpPr>
        <p:spPr bwMode="auto">
          <a:xfrm>
            <a:off x="4709545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D4DD816E-7A41-47CF-AC66-C4EB27CD0F64}"/>
              </a:ext>
            </a:extLst>
          </p:cNvPr>
          <p:cNvSpPr>
            <a:spLocks noChangeShapeType="1"/>
          </p:cNvSpPr>
          <p:nvPr/>
        </p:nvSpPr>
        <p:spPr bwMode="auto">
          <a:xfrm>
            <a:off x="5174683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2">
            <a:extLst>
              <a:ext uri="{FF2B5EF4-FFF2-40B4-BE49-F238E27FC236}">
                <a16:creationId xmlns:a16="http://schemas.microsoft.com/office/drawing/2014/main" id="{3B3234BA-007B-467A-9B62-2A5170801014}"/>
              </a:ext>
            </a:extLst>
          </p:cNvPr>
          <p:cNvSpPr>
            <a:spLocks noChangeShapeType="1"/>
          </p:cNvSpPr>
          <p:nvPr/>
        </p:nvSpPr>
        <p:spPr bwMode="auto">
          <a:xfrm>
            <a:off x="5636645" y="415138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04EEB2A-21B7-4DBE-A8A7-2BC6E5CC40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09308" y="427362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3F6BA1A-0FFD-4FA6-BBB6-D9A017CE42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1108" y="427362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2E8DD70-57CC-4322-B15C-1424408B6A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7833" y="427362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8477262-F7FA-430A-B4D1-B1377E62A2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8208" y="427362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E9369A3-38FE-4103-B664-9622D98398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4933" y="427362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67DE9E8-5013-4405-B95E-94F4EE5766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3083" y="4273623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0FB3159C-D98B-4A72-A8F2-C253E2E2C6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5045" y="4273623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FA4E9E07-0D2C-4116-8814-D6ADE646AA8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44220" y="1632023"/>
            <a:ext cx="0" cy="241935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01D1EA16-6682-4188-BCC4-81DF5EE63D0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5483" y="4051373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A36291F3-AB35-4DF8-A180-744A2916FE5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5483" y="3567185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2520FC96-20FC-4F79-8EC1-E70DF7A2252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5483" y="3082998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8E539204-A901-42C7-A5B1-35D1F010097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5483" y="2600398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5">
            <a:extLst>
              <a:ext uri="{FF2B5EF4-FFF2-40B4-BE49-F238E27FC236}">
                <a16:creationId xmlns:a16="http://schemas.microsoft.com/office/drawing/2014/main" id="{C3B4B4E4-3EBD-4B92-A724-0E29F5277A4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5483" y="2116210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6">
            <a:extLst>
              <a:ext uri="{FF2B5EF4-FFF2-40B4-BE49-F238E27FC236}">
                <a16:creationId xmlns:a16="http://schemas.microsoft.com/office/drawing/2014/main" id="{4D638151-022F-47C2-AC3D-5F5F3A121AE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5483" y="1632023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BA291E0-3201-48B1-8CEA-D9918469D9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2120" y="3967441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84208C5-82CC-4926-AF9E-913181F054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2120" y="3483254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B9B5780-26B6-4DB0-8C3A-B3D03AE4E1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2120" y="2999066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40B8E5D1-0B26-486F-BC9D-9AD9449876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2120" y="2514879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A16ECBB-E83F-4122-94D6-B04C7878B2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2120" y="2030691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A0C8842-6508-4279-8E4B-FAF8108F84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2120" y="1548091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Freeform 33">
            <a:extLst>
              <a:ext uri="{FF2B5EF4-FFF2-40B4-BE49-F238E27FC236}">
                <a16:creationId xmlns:a16="http://schemas.microsoft.com/office/drawing/2014/main" id="{A62D41E2-450D-4EC3-AC48-FDF52789DF1F}"/>
              </a:ext>
            </a:extLst>
          </p:cNvPr>
          <p:cNvSpPr>
            <a:spLocks/>
          </p:cNvSpPr>
          <p:nvPr/>
        </p:nvSpPr>
        <p:spPr bwMode="auto">
          <a:xfrm>
            <a:off x="2744220" y="1532010"/>
            <a:ext cx="3001963" cy="2619375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C3D35622-56F7-4325-AECA-B2F13206E3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3790" y="3851457"/>
            <a:ext cx="4857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4D709F5D-6D04-4807-BC6E-A769734B2F0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798472" y="2749363"/>
            <a:ext cx="74263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reeform 37">
            <a:extLst>
              <a:ext uri="{FF2B5EF4-FFF2-40B4-BE49-F238E27FC236}">
                <a16:creationId xmlns:a16="http://schemas.microsoft.com/office/drawing/2014/main" id="{5AA7EC90-7E93-417A-A198-66F189F0B9D1}"/>
              </a:ext>
            </a:extLst>
          </p:cNvPr>
          <p:cNvSpPr>
            <a:spLocks/>
          </p:cNvSpPr>
          <p:nvPr/>
        </p:nvSpPr>
        <p:spPr bwMode="auto">
          <a:xfrm>
            <a:off x="2855345" y="1632023"/>
            <a:ext cx="3124200" cy="203200"/>
          </a:xfrm>
          <a:custGeom>
            <a:avLst/>
            <a:gdLst>
              <a:gd name="T0" fmla="*/ 0 w 536"/>
              <a:gd name="T1" fmla="*/ 0 h 35"/>
              <a:gd name="T2" fmla="*/ 32 w 536"/>
              <a:gd name="T3" fmla="*/ 0 h 35"/>
              <a:gd name="T4" fmla="*/ 32 w 536"/>
              <a:gd name="T5" fmla="*/ 1 h 35"/>
              <a:gd name="T6" fmla="*/ 87 w 536"/>
              <a:gd name="T7" fmla="*/ 1 h 35"/>
              <a:gd name="T8" fmla="*/ 87 w 536"/>
              <a:gd name="T9" fmla="*/ 1 h 35"/>
              <a:gd name="T10" fmla="*/ 107 w 536"/>
              <a:gd name="T11" fmla="*/ 1 h 35"/>
              <a:gd name="T12" fmla="*/ 107 w 536"/>
              <a:gd name="T13" fmla="*/ 2 h 35"/>
              <a:gd name="T14" fmla="*/ 115 w 536"/>
              <a:gd name="T15" fmla="*/ 2 h 35"/>
              <a:gd name="T16" fmla="*/ 115 w 536"/>
              <a:gd name="T17" fmla="*/ 3 h 35"/>
              <a:gd name="T18" fmla="*/ 159 w 536"/>
              <a:gd name="T19" fmla="*/ 3 h 35"/>
              <a:gd name="T20" fmla="*/ 159 w 536"/>
              <a:gd name="T21" fmla="*/ 4 h 35"/>
              <a:gd name="T22" fmla="*/ 163 w 536"/>
              <a:gd name="T23" fmla="*/ 4 h 35"/>
              <a:gd name="T24" fmla="*/ 163 w 536"/>
              <a:gd name="T25" fmla="*/ 5 h 35"/>
              <a:gd name="T26" fmla="*/ 167 w 536"/>
              <a:gd name="T27" fmla="*/ 5 h 35"/>
              <a:gd name="T28" fmla="*/ 167 w 536"/>
              <a:gd name="T29" fmla="*/ 6 h 35"/>
              <a:gd name="T30" fmla="*/ 183 w 536"/>
              <a:gd name="T31" fmla="*/ 6 h 35"/>
              <a:gd name="T32" fmla="*/ 183 w 536"/>
              <a:gd name="T33" fmla="*/ 7 h 35"/>
              <a:gd name="T34" fmla="*/ 230 w 536"/>
              <a:gd name="T35" fmla="*/ 7 h 35"/>
              <a:gd name="T36" fmla="*/ 230 w 536"/>
              <a:gd name="T37" fmla="*/ 8 h 35"/>
              <a:gd name="T38" fmla="*/ 238 w 536"/>
              <a:gd name="T39" fmla="*/ 8 h 35"/>
              <a:gd name="T40" fmla="*/ 238 w 536"/>
              <a:gd name="T41" fmla="*/ 10 h 35"/>
              <a:gd name="T42" fmla="*/ 242 w 536"/>
              <a:gd name="T43" fmla="*/ 10 h 35"/>
              <a:gd name="T44" fmla="*/ 242 w 536"/>
              <a:gd name="T45" fmla="*/ 11 h 35"/>
              <a:gd name="T46" fmla="*/ 254 w 536"/>
              <a:gd name="T47" fmla="*/ 11 h 35"/>
              <a:gd name="T48" fmla="*/ 254 w 536"/>
              <a:gd name="T49" fmla="*/ 14 h 35"/>
              <a:gd name="T50" fmla="*/ 298 w 536"/>
              <a:gd name="T51" fmla="*/ 14 h 35"/>
              <a:gd name="T52" fmla="*/ 298 w 536"/>
              <a:gd name="T53" fmla="*/ 16 h 35"/>
              <a:gd name="T54" fmla="*/ 314 w 536"/>
              <a:gd name="T55" fmla="*/ 16 h 35"/>
              <a:gd name="T56" fmla="*/ 314 w 536"/>
              <a:gd name="T57" fmla="*/ 18 h 35"/>
              <a:gd name="T58" fmla="*/ 326 w 536"/>
              <a:gd name="T59" fmla="*/ 18 h 35"/>
              <a:gd name="T60" fmla="*/ 326 w 536"/>
              <a:gd name="T61" fmla="*/ 20 h 35"/>
              <a:gd name="T62" fmla="*/ 405 w 536"/>
              <a:gd name="T63" fmla="*/ 20 h 35"/>
              <a:gd name="T64" fmla="*/ 405 w 536"/>
              <a:gd name="T65" fmla="*/ 24 h 35"/>
              <a:gd name="T66" fmla="*/ 409 w 536"/>
              <a:gd name="T67" fmla="*/ 24 h 35"/>
              <a:gd name="T68" fmla="*/ 409 w 536"/>
              <a:gd name="T69" fmla="*/ 28 h 35"/>
              <a:gd name="T70" fmla="*/ 473 w 536"/>
              <a:gd name="T71" fmla="*/ 28 h 35"/>
              <a:gd name="T72" fmla="*/ 473 w 536"/>
              <a:gd name="T73" fmla="*/ 35 h 35"/>
              <a:gd name="T74" fmla="*/ 536 w 536"/>
              <a:gd name="T75" fmla="*/ 35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</a:cxnLst>
            <a:rect l="0" t="0" r="r" b="b"/>
            <a:pathLst>
              <a:path w="536" h="35">
                <a:moveTo>
                  <a:pt x="0" y="0"/>
                </a:moveTo>
                <a:lnTo>
                  <a:pt x="32" y="0"/>
                </a:lnTo>
                <a:lnTo>
                  <a:pt x="32" y="1"/>
                </a:lnTo>
                <a:lnTo>
                  <a:pt x="87" y="1"/>
                </a:lnTo>
                <a:lnTo>
                  <a:pt x="87" y="1"/>
                </a:lnTo>
                <a:lnTo>
                  <a:pt x="107" y="1"/>
                </a:lnTo>
                <a:lnTo>
                  <a:pt x="107" y="2"/>
                </a:lnTo>
                <a:lnTo>
                  <a:pt x="115" y="2"/>
                </a:lnTo>
                <a:lnTo>
                  <a:pt x="115" y="3"/>
                </a:lnTo>
                <a:lnTo>
                  <a:pt x="159" y="3"/>
                </a:lnTo>
                <a:lnTo>
                  <a:pt x="159" y="4"/>
                </a:lnTo>
                <a:lnTo>
                  <a:pt x="163" y="4"/>
                </a:lnTo>
                <a:lnTo>
                  <a:pt x="163" y="5"/>
                </a:lnTo>
                <a:lnTo>
                  <a:pt x="167" y="5"/>
                </a:lnTo>
                <a:lnTo>
                  <a:pt x="167" y="6"/>
                </a:lnTo>
                <a:lnTo>
                  <a:pt x="183" y="6"/>
                </a:lnTo>
                <a:lnTo>
                  <a:pt x="183" y="7"/>
                </a:lnTo>
                <a:lnTo>
                  <a:pt x="230" y="7"/>
                </a:lnTo>
                <a:lnTo>
                  <a:pt x="230" y="8"/>
                </a:lnTo>
                <a:lnTo>
                  <a:pt x="238" y="8"/>
                </a:lnTo>
                <a:lnTo>
                  <a:pt x="238" y="10"/>
                </a:lnTo>
                <a:lnTo>
                  <a:pt x="242" y="10"/>
                </a:lnTo>
                <a:lnTo>
                  <a:pt x="242" y="11"/>
                </a:lnTo>
                <a:lnTo>
                  <a:pt x="254" y="11"/>
                </a:lnTo>
                <a:lnTo>
                  <a:pt x="254" y="14"/>
                </a:lnTo>
                <a:lnTo>
                  <a:pt x="298" y="14"/>
                </a:lnTo>
                <a:lnTo>
                  <a:pt x="298" y="16"/>
                </a:lnTo>
                <a:lnTo>
                  <a:pt x="314" y="16"/>
                </a:lnTo>
                <a:lnTo>
                  <a:pt x="314" y="18"/>
                </a:lnTo>
                <a:lnTo>
                  <a:pt x="326" y="18"/>
                </a:lnTo>
                <a:lnTo>
                  <a:pt x="326" y="20"/>
                </a:lnTo>
                <a:lnTo>
                  <a:pt x="405" y="20"/>
                </a:lnTo>
                <a:lnTo>
                  <a:pt x="405" y="24"/>
                </a:lnTo>
                <a:lnTo>
                  <a:pt x="409" y="24"/>
                </a:lnTo>
                <a:lnTo>
                  <a:pt x="409" y="28"/>
                </a:lnTo>
                <a:lnTo>
                  <a:pt x="473" y="28"/>
                </a:lnTo>
                <a:lnTo>
                  <a:pt x="473" y="35"/>
                </a:lnTo>
                <a:lnTo>
                  <a:pt x="536" y="35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Freeform 38">
            <a:extLst>
              <a:ext uri="{FF2B5EF4-FFF2-40B4-BE49-F238E27FC236}">
                <a16:creationId xmlns:a16="http://schemas.microsoft.com/office/drawing/2014/main" id="{EF5FDE97-4BAC-49B7-A626-46C9381B3A34}"/>
              </a:ext>
            </a:extLst>
          </p:cNvPr>
          <p:cNvSpPr>
            <a:spLocks/>
          </p:cNvSpPr>
          <p:nvPr/>
        </p:nvSpPr>
        <p:spPr bwMode="auto">
          <a:xfrm>
            <a:off x="2855345" y="1632023"/>
            <a:ext cx="3124200" cy="139700"/>
          </a:xfrm>
          <a:custGeom>
            <a:avLst/>
            <a:gdLst>
              <a:gd name="T0" fmla="*/ 0 w 536"/>
              <a:gd name="T1" fmla="*/ 0 h 24"/>
              <a:gd name="T2" fmla="*/ 28 w 536"/>
              <a:gd name="T3" fmla="*/ 0 h 24"/>
              <a:gd name="T4" fmla="*/ 28 w 536"/>
              <a:gd name="T5" fmla="*/ 1 h 24"/>
              <a:gd name="T6" fmla="*/ 143 w 536"/>
              <a:gd name="T7" fmla="*/ 1 h 24"/>
              <a:gd name="T8" fmla="*/ 143 w 536"/>
              <a:gd name="T9" fmla="*/ 3 h 24"/>
              <a:gd name="T10" fmla="*/ 296 w 536"/>
              <a:gd name="T11" fmla="*/ 3 h 24"/>
              <a:gd name="T12" fmla="*/ 296 w 536"/>
              <a:gd name="T13" fmla="*/ 7 h 24"/>
              <a:gd name="T14" fmla="*/ 352 w 536"/>
              <a:gd name="T15" fmla="*/ 7 h 24"/>
              <a:gd name="T16" fmla="*/ 352 w 536"/>
              <a:gd name="T17" fmla="*/ 14 h 24"/>
              <a:gd name="T18" fmla="*/ 441 w 536"/>
              <a:gd name="T19" fmla="*/ 14 h 24"/>
              <a:gd name="T20" fmla="*/ 441 w 536"/>
              <a:gd name="T21" fmla="*/ 24 h 24"/>
              <a:gd name="T22" fmla="*/ 536 w 536"/>
              <a:gd name="T23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536" h="24">
                <a:moveTo>
                  <a:pt x="0" y="0"/>
                </a:moveTo>
                <a:lnTo>
                  <a:pt x="28" y="0"/>
                </a:lnTo>
                <a:lnTo>
                  <a:pt x="28" y="1"/>
                </a:lnTo>
                <a:lnTo>
                  <a:pt x="143" y="1"/>
                </a:lnTo>
                <a:lnTo>
                  <a:pt x="143" y="3"/>
                </a:lnTo>
                <a:lnTo>
                  <a:pt x="296" y="3"/>
                </a:lnTo>
                <a:lnTo>
                  <a:pt x="296" y="7"/>
                </a:lnTo>
                <a:lnTo>
                  <a:pt x="352" y="7"/>
                </a:lnTo>
                <a:lnTo>
                  <a:pt x="352" y="14"/>
                </a:lnTo>
                <a:lnTo>
                  <a:pt x="441" y="14"/>
                </a:lnTo>
                <a:lnTo>
                  <a:pt x="441" y="24"/>
                </a:lnTo>
                <a:lnTo>
                  <a:pt x="536" y="24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CE9EDEB3-569B-4AC6-B7B0-EBA4D5FFF6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3745" y="460125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9F200C72-E14F-4775-B014-31E1187AA4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4120" y="460125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98AF9BA8-02A0-419F-A8D3-7959F5297A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0845" y="460125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4628D8D6-1371-4833-939D-6E6E510A73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1220" y="460125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491EE1A6-18AF-427A-A80F-F7CB1C74D3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7945" y="460125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BF8CC6B-C2E0-4777-A7FF-4175B25A94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3083" y="460125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73B16B3-1D10-47BF-BD66-052ACC7A11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2033" y="460125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5A8C7495-E1C6-497B-BD76-7FC2927ED4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3745" y="483401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73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DC9FC5C-4FCB-4C60-8EC1-0ACC60F548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4120" y="483401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69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9F5027AF-C894-4B75-951A-F56B7EDA75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0845" y="483401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9C18039-B52C-435C-AEE7-5B41C39EEA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1220" y="483401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6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D940D800-E0E2-4DB8-95E3-A7120CC0B1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4933" y="483401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C9556EAB-7779-4EE9-8740-B53CED8CE1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0070" y="483401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FDD03013-19B6-4455-8390-DB7E517531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2033" y="483401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8C9C345-689B-4460-9EE3-1021331804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1879" y="4584460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750730C-90D3-4E07-A554-F41C260714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0179" y="4831767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55">
            <a:extLst>
              <a:ext uri="{FF2B5EF4-FFF2-40B4-BE49-F238E27FC236}">
                <a16:creationId xmlns:a16="http://schemas.microsoft.com/office/drawing/2014/main" id="{B1B1E30C-E333-49C4-BA17-AD6DB7F4D78B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1278" y="2769009"/>
            <a:ext cx="16351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6">
            <a:extLst>
              <a:ext uri="{FF2B5EF4-FFF2-40B4-BE49-F238E27FC236}">
                <a16:creationId xmlns:a16="http://schemas.microsoft.com/office/drawing/2014/main" id="{B55543A4-3629-4116-A2F6-22BDA39602A8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1278" y="2975017"/>
            <a:ext cx="163513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58">
            <a:extLst>
              <a:ext uri="{FF2B5EF4-FFF2-40B4-BE49-F238E27FC236}">
                <a16:creationId xmlns:a16="http://schemas.microsoft.com/office/drawing/2014/main" id="{12F35BA5-FFDE-48F3-9FC4-68B2C13AFE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2103" y="2669012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59">
            <a:extLst>
              <a:ext uri="{FF2B5EF4-FFF2-40B4-BE49-F238E27FC236}">
                <a16:creationId xmlns:a16="http://schemas.microsoft.com/office/drawing/2014/main" id="{1E4395EB-CB53-4637-9DBA-5976A5632D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2103" y="2876607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C149319-FDDD-4FAD-B328-CDE0CA6B590A}"/>
              </a:ext>
            </a:extLst>
          </p:cNvPr>
          <p:cNvSpPr txBox="1"/>
          <p:nvPr/>
        </p:nvSpPr>
        <p:spPr>
          <a:xfrm>
            <a:off x="3124212" y="2981094"/>
            <a:ext cx="147501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840</a:t>
            </a:r>
          </a:p>
        </p:txBody>
      </p:sp>
      <p:sp>
        <p:nvSpPr>
          <p:cNvPr id="58" name="Rectangle 72">
            <a:extLst>
              <a:ext uri="{FF2B5EF4-FFF2-40B4-BE49-F238E27FC236}">
                <a16:creationId xmlns:a16="http://schemas.microsoft.com/office/drawing/2014/main" id="{34979E2B-4551-4AF8-99CC-FDCB7C449B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03703" y="4262738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8AABA73D-C4CF-36A5-BA3C-E2D836585631}"/>
              </a:ext>
            </a:extLst>
          </p:cNvPr>
          <p:cNvSpPr txBox="1"/>
          <p:nvPr/>
        </p:nvSpPr>
        <p:spPr>
          <a:xfrm>
            <a:off x="1745810" y="1062408"/>
            <a:ext cx="458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48989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5">
            <a:extLst>
              <a:ext uri="{FF2B5EF4-FFF2-40B4-BE49-F238E27FC236}">
                <a16:creationId xmlns:a16="http://schemas.microsoft.com/office/drawing/2014/main" id="{ACDE1B97-CA27-4A3A-B2E9-B799FC83293E}"/>
              </a:ext>
            </a:extLst>
          </p:cNvPr>
          <p:cNvSpPr>
            <a:spLocks noChangeShapeType="1"/>
          </p:cNvSpPr>
          <p:nvPr/>
        </p:nvSpPr>
        <p:spPr bwMode="auto">
          <a:xfrm>
            <a:off x="2892425" y="4181475"/>
            <a:ext cx="27813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6">
            <a:extLst>
              <a:ext uri="{FF2B5EF4-FFF2-40B4-BE49-F238E27FC236}">
                <a16:creationId xmlns:a16="http://schemas.microsoft.com/office/drawing/2014/main" id="{7CE852DF-AEFE-4B4D-B8CA-F34526BCA131}"/>
              </a:ext>
            </a:extLst>
          </p:cNvPr>
          <p:cNvSpPr>
            <a:spLocks noChangeShapeType="1"/>
          </p:cNvSpPr>
          <p:nvPr/>
        </p:nvSpPr>
        <p:spPr bwMode="auto">
          <a:xfrm>
            <a:off x="2892425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7">
            <a:extLst>
              <a:ext uri="{FF2B5EF4-FFF2-40B4-BE49-F238E27FC236}">
                <a16:creationId xmlns:a16="http://schemas.microsoft.com/office/drawing/2014/main" id="{7A9B694F-96C9-4738-B8D4-DDAB995A48D2}"/>
              </a:ext>
            </a:extLst>
          </p:cNvPr>
          <p:cNvSpPr>
            <a:spLocks noChangeShapeType="1"/>
          </p:cNvSpPr>
          <p:nvPr/>
        </p:nvSpPr>
        <p:spPr bwMode="auto">
          <a:xfrm>
            <a:off x="3352800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8">
            <a:extLst>
              <a:ext uri="{FF2B5EF4-FFF2-40B4-BE49-F238E27FC236}">
                <a16:creationId xmlns:a16="http://schemas.microsoft.com/office/drawing/2014/main" id="{4AB28C13-3D19-40D7-B22D-AE8E77942CC4}"/>
              </a:ext>
            </a:extLst>
          </p:cNvPr>
          <p:cNvSpPr>
            <a:spLocks noChangeShapeType="1"/>
          </p:cNvSpPr>
          <p:nvPr/>
        </p:nvSpPr>
        <p:spPr bwMode="auto">
          <a:xfrm>
            <a:off x="3819525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9">
            <a:extLst>
              <a:ext uri="{FF2B5EF4-FFF2-40B4-BE49-F238E27FC236}">
                <a16:creationId xmlns:a16="http://schemas.microsoft.com/office/drawing/2014/main" id="{F573407E-F098-4FFF-8E25-804775D0420A}"/>
              </a:ext>
            </a:extLst>
          </p:cNvPr>
          <p:cNvSpPr>
            <a:spLocks noChangeShapeType="1"/>
          </p:cNvSpPr>
          <p:nvPr/>
        </p:nvSpPr>
        <p:spPr bwMode="auto">
          <a:xfrm>
            <a:off x="4279900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0">
            <a:extLst>
              <a:ext uri="{FF2B5EF4-FFF2-40B4-BE49-F238E27FC236}">
                <a16:creationId xmlns:a16="http://schemas.microsoft.com/office/drawing/2014/main" id="{779E53F5-ADC5-4C45-AFF7-57ECF7453C9F}"/>
              </a:ext>
            </a:extLst>
          </p:cNvPr>
          <p:cNvSpPr>
            <a:spLocks noChangeShapeType="1"/>
          </p:cNvSpPr>
          <p:nvPr/>
        </p:nvSpPr>
        <p:spPr bwMode="auto">
          <a:xfrm>
            <a:off x="4746625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11">
            <a:extLst>
              <a:ext uri="{FF2B5EF4-FFF2-40B4-BE49-F238E27FC236}">
                <a16:creationId xmlns:a16="http://schemas.microsoft.com/office/drawing/2014/main" id="{16FE7041-FAC0-400C-A740-1A945DCCA14F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1763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Line 12">
            <a:extLst>
              <a:ext uri="{FF2B5EF4-FFF2-40B4-BE49-F238E27FC236}">
                <a16:creationId xmlns:a16="http://schemas.microsoft.com/office/drawing/2014/main" id="{CF31AB79-DD64-4F17-B77E-F2B99BEF19FC}"/>
              </a:ext>
            </a:extLst>
          </p:cNvPr>
          <p:cNvSpPr>
            <a:spLocks noChangeShapeType="1"/>
          </p:cNvSpPr>
          <p:nvPr/>
        </p:nvSpPr>
        <p:spPr bwMode="auto">
          <a:xfrm>
            <a:off x="5673725" y="4181475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3">
            <a:extLst>
              <a:ext uri="{FF2B5EF4-FFF2-40B4-BE49-F238E27FC236}">
                <a16:creationId xmlns:a16="http://schemas.microsoft.com/office/drawing/2014/main" id="{77C0C5B0-CBB6-4D75-B7FF-83980744E3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6388" y="4303713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4">
            <a:extLst>
              <a:ext uri="{FF2B5EF4-FFF2-40B4-BE49-F238E27FC236}">
                <a16:creationId xmlns:a16="http://schemas.microsoft.com/office/drawing/2014/main" id="{0F201455-69CE-43D9-B7EB-0A4D320C7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8188" y="430371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5">
            <a:extLst>
              <a:ext uri="{FF2B5EF4-FFF2-40B4-BE49-F238E27FC236}">
                <a16:creationId xmlns:a16="http://schemas.microsoft.com/office/drawing/2014/main" id="{1D85FFF2-D04F-461C-B3E2-5848804A58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4913" y="430371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6">
            <a:extLst>
              <a:ext uri="{FF2B5EF4-FFF2-40B4-BE49-F238E27FC236}">
                <a16:creationId xmlns:a16="http://schemas.microsoft.com/office/drawing/2014/main" id="{95B80A37-C6A9-4954-8D6F-FDA8615875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05288" y="430371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17">
            <a:extLst>
              <a:ext uri="{FF2B5EF4-FFF2-40B4-BE49-F238E27FC236}">
                <a16:creationId xmlns:a16="http://schemas.microsoft.com/office/drawing/2014/main" id="{B544B615-E1B0-43F0-9348-A3B1C2F4BF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2013" y="4303713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18">
            <a:extLst>
              <a:ext uri="{FF2B5EF4-FFF2-40B4-BE49-F238E27FC236}">
                <a16:creationId xmlns:a16="http://schemas.microsoft.com/office/drawing/2014/main" id="{3D536CA9-643B-4926-888D-D9D053F2C7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0163" y="4303713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19">
            <a:extLst>
              <a:ext uri="{FF2B5EF4-FFF2-40B4-BE49-F238E27FC236}">
                <a16:creationId xmlns:a16="http://schemas.microsoft.com/office/drawing/2014/main" id="{6041F6EE-F529-4A72-AE13-678989B7AB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72125" y="4303713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0">
            <a:extLst>
              <a:ext uri="{FF2B5EF4-FFF2-40B4-BE49-F238E27FC236}">
                <a16:creationId xmlns:a16="http://schemas.microsoft.com/office/drawing/2014/main" id="{59EA4477-F511-4393-8F9B-01DA4EA224C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81300" y="1662113"/>
            <a:ext cx="0" cy="241935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1">
            <a:extLst>
              <a:ext uri="{FF2B5EF4-FFF2-40B4-BE49-F238E27FC236}">
                <a16:creationId xmlns:a16="http://schemas.microsoft.com/office/drawing/2014/main" id="{FEB5500F-44BC-4A1A-B1D3-07B7A98536E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22563" y="4081463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2">
            <a:extLst>
              <a:ext uri="{FF2B5EF4-FFF2-40B4-BE49-F238E27FC236}">
                <a16:creationId xmlns:a16="http://schemas.microsoft.com/office/drawing/2014/main" id="{C9C3FA98-9ECD-44F5-B1CE-C658CA2F4A7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22563" y="3597275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3">
            <a:extLst>
              <a:ext uri="{FF2B5EF4-FFF2-40B4-BE49-F238E27FC236}">
                <a16:creationId xmlns:a16="http://schemas.microsoft.com/office/drawing/2014/main" id="{79C3F068-4EEC-492D-B007-9D7492C25B7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22563" y="3113088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Line 24">
            <a:extLst>
              <a:ext uri="{FF2B5EF4-FFF2-40B4-BE49-F238E27FC236}">
                <a16:creationId xmlns:a16="http://schemas.microsoft.com/office/drawing/2014/main" id="{3B5DC20E-A75B-4970-894A-42DE8ED8815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22563" y="2630488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25">
            <a:extLst>
              <a:ext uri="{FF2B5EF4-FFF2-40B4-BE49-F238E27FC236}">
                <a16:creationId xmlns:a16="http://schemas.microsoft.com/office/drawing/2014/main" id="{026FA974-7EA2-48BD-93CB-597FD225B0E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22563" y="2146300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Line 26">
            <a:extLst>
              <a:ext uri="{FF2B5EF4-FFF2-40B4-BE49-F238E27FC236}">
                <a16:creationId xmlns:a16="http://schemas.microsoft.com/office/drawing/2014/main" id="{8C34E30B-8927-426E-8DEA-B832A53E5AD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22563" y="1662113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27">
            <a:extLst>
              <a:ext uri="{FF2B5EF4-FFF2-40B4-BE49-F238E27FC236}">
                <a16:creationId xmlns:a16="http://schemas.microsoft.com/office/drawing/2014/main" id="{E7933A26-6198-4474-856C-990972BA8E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3997531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28">
            <a:extLst>
              <a:ext uri="{FF2B5EF4-FFF2-40B4-BE49-F238E27FC236}">
                <a16:creationId xmlns:a16="http://schemas.microsoft.com/office/drawing/2014/main" id="{12B1F2AA-8533-4B19-8A1D-50FC888809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3513344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29">
            <a:extLst>
              <a:ext uri="{FF2B5EF4-FFF2-40B4-BE49-F238E27FC236}">
                <a16:creationId xmlns:a16="http://schemas.microsoft.com/office/drawing/2014/main" id="{9097F015-EB96-422E-B700-6E6558CC82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3029156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0">
            <a:extLst>
              <a:ext uri="{FF2B5EF4-FFF2-40B4-BE49-F238E27FC236}">
                <a16:creationId xmlns:a16="http://schemas.microsoft.com/office/drawing/2014/main" id="{4FCBCD2E-11D9-4016-B5CE-D627C2934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2544969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1">
            <a:extLst>
              <a:ext uri="{FF2B5EF4-FFF2-40B4-BE49-F238E27FC236}">
                <a16:creationId xmlns:a16="http://schemas.microsoft.com/office/drawing/2014/main" id="{46C83F11-D071-45D0-8176-93CED52A18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2060781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2">
            <a:extLst>
              <a:ext uri="{FF2B5EF4-FFF2-40B4-BE49-F238E27FC236}">
                <a16:creationId xmlns:a16="http://schemas.microsoft.com/office/drawing/2014/main" id="{26A282F0-AE69-48E7-9C84-264229D072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0" y="1578181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Freeform 33">
            <a:extLst>
              <a:ext uri="{FF2B5EF4-FFF2-40B4-BE49-F238E27FC236}">
                <a16:creationId xmlns:a16="http://schemas.microsoft.com/office/drawing/2014/main" id="{C8762A92-CFA7-49CC-A29A-98CE5C7D484C}"/>
              </a:ext>
            </a:extLst>
          </p:cNvPr>
          <p:cNvSpPr>
            <a:spLocks/>
          </p:cNvSpPr>
          <p:nvPr/>
        </p:nvSpPr>
        <p:spPr bwMode="auto">
          <a:xfrm>
            <a:off x="2781300" y="1562100"/>
            <a:ext cx="3001963" cy="2619375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5">
            <a:extLst>
              <a:ext uri="{FF2B5EF4-FFF2-40B4-BE49-F238E27FC236}">
                <a16:creationId xmlns:a16="http://schemas.microsoft.com/office/drawing/2014/main" id="{1D6B9279-335B-4D30-9FBE-AF6F7940A5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3521" y="3911327"/>
            <a:ext cx="4857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6">
            <a:extLst>
              <a:ext uri="{FF2B5EF4-FFF2-40B4-BE49-F238E27FC236}">
                <a16:creationId xmlns:a16="http://schemas.microsoft.com/office/drawing/2014/main" id="{EFAE5A96-5CEF-4343-9069-28E99A87916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750494" y="2825182"/>
            <a:ext cx="74263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Freeform 37">
            <a:extLst>
              <a:ext uri="{FF2B5EF4-FFF2-40B4-BE49-F238E27FC236}">
                <a16:creationId xmlns:a16="http://schemas.microsoft.com/office/drawing/2014/main" id="{033968DB-F39D-4C4D-907B-E9560FD1C48B}"/>
              </a:ext>
            </a:extLst>
          </p:cNvPr>
          <p:cNvSpPr>
            <a:spLocks/>
          </p:cNvSpPr>
          <p:nvPr/>
        </p:nvSpPr>
        <p:spPr bwMode="auto">
          <a:xfrm>
            <a:off x="2892425" y="1662113"/>
            <a:ext cx="3124200" cy="34925"/>
          </a:xfrm>
          <a:custGeom>
            <a:avLst/>
            <a:gdLst>
              <a:gd name="T0" fmla="*/ 0 w 536"/>
              <a:gd name="T1" fmla="*/ 0 h 6"/>
              <a:gd name="T2" fmla="*/ 119 w 536"/>
              <a:gd name="T3" fmla="*/ 0 h 6"/>
              <a:gd name="T4" fmla="*/ 119 w 536"/>
              <a:gd name="T5" fmla="*/ 1 h 6"/>
              <a:gd name="T6" fmla="*/ 402 w 536"/>
              <a:gd name="T7" fmla="*/ 1 h 6"/>
              <a:gd name="T8" fmla="*/ 402 w 536"/>
              <a:gd name="T9" fmla="*/ 6 h 6"/>
              <a:gd name="T10" fmla="*/ 536 w 536"/>
              <a:gd name="T11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36" h="6">
                <a:moveTo>
                  <a:pt x="0" y="0"/>
                </a:moveTo>
                <a:lnTo>
                  <a:pt x="119" y="0"/>
                </a:lnTo>
                <a:lnTo>
                  <a:pt x="119" y="1"/>
                </a:lnTo>
                <a:lnTo>
                  <a:pt x="402" y="1"/>
                </a:lnTo>
                <a:lnTo>
                  <a:pt x="402" y="6"/>
                </a:lnTo>
                <a:lnTo>
                  <a:pt x="536" y="6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Line 38">
            <a:extLst>
              <a:ext uri="{FF2B5EF4-FFF2-40B4-BE49-F238E27FC236}">
                <a16:creationId xmlns:a16="http://schemas.microsoft.com/office/drawing/2014/main" id="{1D51C1FC-9362-4ACA-8AC4-E1F35093DD26}"/>
              </a:ext>
            </a:extLst>
          </p:cNvPr>
          <p:cNvSpPr>
            <a:spLocks noChangeShapeType="1"/>
          </p:cNvSpPr>
          <p:nvPr/>
        </p:nvSpPr>
        <p:spPr bwMode="auto">
          <a:xfrm>
            <a:off x="2892425" y="1662113"/>
            <a:ext cx="3124200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39">
            <a:extLst>
              <a:ext uri="{FF2B5EF4-FFF2-40B4-BE49-F238E27FC236}">
                <a16:creationId xmlns:a16="http://schemas.microsoft.com/office/drawing/2014/main" id="{5BED2568-5BA9-48FA-BB75-FAA0B3CCF0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0825" y="459778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99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0">
            <a:extLst>
              <a:ext uri="{FF2B5EF4-FFF2-40B4-BE49-F238E27FC236}">
                <a16:creationId xmlns:a16="http://schemas.microsoft.com/office/drawing/2014/main" id="{54B4E4AF-7CD7-4830-8CD8-D4D6E05769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1200" y="459778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9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1">
            <a:extLst>
              <a:ext uri="{FF2B5EF4-FFF2-40B4-BE49-F238E27FC236}">
                <a16:creationId xmlns:a16="http://schemas.microsoft.com/office/drawing/2014/main" id="{D1C1A0BF-0D47-4693-8ADD-75E90AF9CB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7925" y="459778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6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2">
            <a:extLst>
              <a:ext uri="{FF2B5EF4-FFF2-40B4-BE49-F238E27FC236}">
                <a16:creationId xmlns:a16="http://schemas.microsoft.com/office/drawing/2014/main" id="{7AB55BD0-54FB-462C-8303-0A584AEC95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8300" y="459778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2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3">
            <a:extLst>
              <a:ext uri="{FF2B5EF4-FFF2-40B4-BE49-F238E27FC236}">
                <a16:creationId xmlns:a16="http://schemas.microsoft.com/office/drawing/2014/main" id="{078A82FC-05F8-4AFC-BD20-D1AA6B9BAD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5025" y="459778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47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4">
            <a:extLst>
              <a:ext uri="{FF2B5EF4-FFF2-40B4-BE49-F238E27FC236}">
                <a16:creationId xmlns:a16="http://schemas.microsoft.com/office/drawing/2014/main" id="{E39D29D8-5BB2-4584-96EF-7C0D5554FF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7150" y="4597784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5">
            <a:extLst>
              <a:ext uri="{FF2B5EF4-FFF2-40B4-BE49-F238E27FC236}">
                <a16:creationId xmlns:a16="http://schemas.microsoft.com/office/drawing/2014/main" id="{2CDEA6A6-25DD-4FA7-9A27-28157AE820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9113" y="4597784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6">
            <a:extLst>
              <a:ext uri="{FF2B5EF4-FFF2-40B4-BE49-F238E27FC236}">
                <a16:creationId xmlns:a16="http://schemas.microsoft.com/office/drawing/2014/main" id="{05B6086B-3416-498C-A187-02C817D33A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0825" y="486410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47">
            <a:extLst>
              <a:ext uri="{FF2B5EF4-FFF2-40B4-BE49-F238E27FC236}">
                <a16:creationId xmlns:a16="http://schemas.microsoft.com/office/drawing/2014/main" id="{DFFB4448-4934-4633-B12B-F73C7158E1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1200" y="486410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4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48">
            <a:extLst>
              <a:ext uri="{FF2B5EF4-FFF2-40B4-BE49-F238E27FC236}">
                <a16:creationId xmlns:a16="http://schemas.microsoft.com/office/drawing/2014/main" id="{085E097B-FECA-4FB6-A234-51D956F105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7925" y="486410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49">
            <a:extLst>
              <a:ext uri="{FF2B5EF4-FFF2-40B4-BE49-F238E27FC236}">
                <a16:creationId xmlns:a16="http://schemas.microsoft.com/office/drawing/2014/main" id="{3A5DB201-3A5C-402E-9C0A-2BC9E40201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8300" y="4864100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5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0">
            <a:extLst>
              <a:ext uri="{FF2B5EF4-FFF2-40B4-BE49-F238E27FC236}">
                <a16:creationId xmlns:a16="http://schemas.microsoft.com/office/drawing/2014/main" id="{3A11C759-CACB-4178-99C0-9EF78B1628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2013" y="48641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51">
            <a:extLst>
              <a:ext uri="{FF2B5EF4-FFF2-40B4-BE49-F238E27FC236}">
                <a16:creationId xmlns:a16="http://schemas.microsoft.com/office/drawing/2014/main" id="{9B043A8A-579E-4544-8EFD-B0036A7CCB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7150" y="48641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52">
            <a:extLst>
              <a:ext uri="{FF2B5EF4-FFF2-40B4-BE49-F238E27FC236}">
                <a16:creationId xmlns:a16="http://schemas.microsoft.com/office/drawing/2014/main" id="{736DE9D2-3C7C-443C-ACA9-B5D999C0FB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9113" y="4864100"/>
            <a:ext cx="14542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tangle 53">
            <a:extLst>
              <a:ext uri="{FF2B5EF4-FFF2-40B4-BE49-F238E27FC236}">
                <a16:creationId xmlns:a16="http://schemas.microsoft.com/office/drawing/2014/main" id="{312C2FD1-CA58-4BF1-839B-94E5732EF8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4371" y="4581833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4">
            <a:extLst>
              <a:ext uri="{FF2B5EF4-FFF2-40B4-BE49-F238E27FC236}">
                <a16:creationId xmlns:a16="http://schemas.microsoft.com/office/drawing/2014/main" id="{E604DE83-0511-4B2D-B5DE-078E6AB731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9479" y="4854425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56">
            <a:extLst>
              <a:ext uri="{FF2B5EF4-FFF2-40B4-BE49-F238E27FC236}">
                <a16:creationId xmlns:a16="http://schemas.microsoft.com/office/drawing/2014/main" id="{B332B566-65C1-48A0-A101-10BD07E8ED2E}"/>
              </a:ext>
            </a:extLst>
          </p:cNvPr>
          <p:cNvSpPr>
            <a:spLocks noChangeShapeType="1"/>
          </p:cNvSpPr>
          <p:nvPr/>
        </p:nvSpPr>
        <p:spPr bwMode="auto">
          <a:xfrm>
            <a:off x="5074321" y="2759941"/>
            <a:ext cx="16351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ine 57">
            <a:extLst>
              <a:ext uri="{FF2B5EF4-FFF2-40B4-BE49-F238E27FC236}">
                <a16:creationId xmlns:a16="http://schemas.microsoft.com/office/drawing/2014/main" id="{D2C6D61D-79E8-4F17-896C-33D2F04F3C3B}"/>
              </a:ext>
            </a:extLst>
          </p:cNvPr>
          <p:cNvSpPr>
            <a:spLocks noChangeShapeType="1"/>
          </p:cNvSpPr>
          <p:nvPr/>
        </p:nvSpPr>
        <p:spPr bwMode="auto">
          <a:xfrm>
            <a:off x="5082397" y="2992266"/>
            <a:ext cx="163513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59">
            <a:extLst>
              <a:ext uri="{FF2B5EF4-FFF2-40B4-BE49-F238E27FC236}">
                <a16:creationId xmlns:a16="http://schemas.microsoft.com/office/drawing/2014/main" id="{40198855-1E0E-4832-990B-400E7A5F56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5146" y="2655752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60">
            <a:extLst>
              <a:ext uri="{FF2B5EF4-FFF2-40B4-BE49-F238E27FC236}">
                <a16:creationId xmlns:a16="http://schemas.microsoft.com/office/drawing/2014/main" id="{0B813528-05C9-4654-9ED9-EA0CC8C559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5146" y="2893083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6A58D86-57F7-402A-8872-B5F9977B272D}"/>
              </a:ext>
            </a:extLst>
          </p:cNvPr>
          <p:cNvSpPr txBox="1"/>
          <p:nvPr/>
        </p:nvSpPr>
        <p:spPr>
          <a:xfrm>
            <a:off x="3366616" y="3006949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304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72">
            <a:extLst>
              <a:ext uri="{FF2B5EF4-FFF2-40B4-BE49-F238E27FC236}">
                <a16:creationId xmlns:a16="http://schemas.microsoft.com/office/drawing/2014/main" id="{EC53F7E0-95F6-4D0C-ABB8-3FA1B27894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8920" y="4296523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F4D0703-AA88-054A-60CC-EA7DF8AB481D}"/>
              </a:ext>
            </a:extLst>
          </p:cNvPr>
          <p:cNvSpPr txBox="1"/>
          <p:nvPr/>
        </p:nvSpPr>
        <p:spPr>
          <a:xfrm>
            <a:off x="1817722" y="1251513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0BDE624-85D0-4B23-B336-F1B654B252E5}"/>
              </a:ext>
            </a:extLst>
          </p:cNvPr>
          <p:cNvSpPr txBox="1"/>
          <p:nvPr/>
        </p:nvSpPr>
        <p:spPr>
          <a:xfrm>
            <a:off x="431800" y="5325533"/>
            <a:ext cx="82634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Distant metastasis-free survival rate (DMFS), </a:t>
            </a:r>
            <a:r>
              <a:rPr lang="en-US" b="1" dirty="0"/>
              <a:t>a</a:t>
            </a:r>
            <a:r>
              <a:rPr lang="en-US" dirty="0"/>
              <a:t>) Comparison of DMFS between EBRT and BT-boost in VHR-1 group. </a:t>
            </a:r>
            <a:r>
              <a:rPr lang="en-US" b="1" dirty="0"/>
              <a:t>b</a:t>
            </a:r>
            <a:r>
              <a:rPr lang="en-US" dirty="0"/>
              <a:t>) Comparison of DMFS between EBRT and BT-boost in VHR-0 group. </a:t>
            </a:r>
            <a:r>
              <a:rPr lang="en-US" b="1" dirty="0"/>
              <a:t>c</a:t>
            </a:r>
            <a:r>
              <a:rPr lang="en-US" dirty="0"/>
              <a:t>) Comparison of DMFS between EBRT and BT-boost in intermediate-risk group</a:t>
            </a:r>
          </a:p>
        </p:txBody>
      </p:sp>
    </p:spTree>
    <p:extLst>
      <p:ext uri="{BB962C8B-B14F-4D97-AF65-F5344CB8AC3E}">
        <p14:creationId xmlns:p14="http://schemas.microsoft.com/office/powerpoint/2010/main" val="29334512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6DD8591C-EEBA-1812-94EB-96BA9BF3A2CA}"/>
              </a:ext>
            </a:extLst>
          </p:cNvPr>
          <p:cNvGrpSpPr/>
          <p:nvPr/>
        </p:nvGrpSpPr>
        <p:grpSpPr>
          <a:xfrm>
            <a:off x="1829700" y="659737"/>
            <a:ext cx="4520786" cy="4007954"/>
            <a:chOff x="1745810" y="1062408"/>
            <a:chExt cx="4520786" cy="4007954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62043C69-D526-4602-8667-6DE61151FED5}"/>
                </a:ext>
              </a:extLst>
            </p:cNvPr>
            <p:cNvGrpSpPr/>
            <p:nvPr/>
          </p:nvGrpSpPr>
          <p:grpSpPr>
            <a:xfrm>
              <a:off x="2130651" y="1583696"/>
              <a:ext cx="4135945" cy="3486666"/>
              <a:chOff x="1961045" y="1745929"/>
              <a:chExt cx="4135945" cy="3486666"/>
            </a:xfrm>
          </p:grpSpPr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E5B80E48-1E8D-40C0-A9B1-AB82DACDC128}"/>
                  </a:ext>
                </a:extLst>
              </p:cNvPr>
              <p:cNvSpPr txBox="1"/>
              <p:nvPr/>
            </p:nvSpPr>
            <p:spPr>
              <a:xfrm>
                <a:off x="3230999" y="3243845"/>
                <a:ext cx="159599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 = </a:t>
                </a:r>
                <a:r>
                  <a:rPr lang="ja-JP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99</a:t>
                </a:r>
              </a:p>
            </p:txBody>
          </p:sp>
          <p:sp>
            <p:nvSpPr>
              <p:cNvPr id="8" name="Line 5">
                <a:extLst>
                  <a:ext uri="{FF2B5EF4-FFF2-40B4-BE49-F238E27FC236}">
                    <a16:creationId xmlns:a16="http://schemas.microsoft.com/office/drawing/2014/main" id="{FB4F160F-1B6D-48C9-9D6F-5B62B88BAD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2790" y="4365304"/>
                <a:ext cx="27813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Line 6">
                <a:extLst>
                  <a:ext uri="{FF2B5EF4-FFF2-40B4-BE49-F238E27FC236}">
                    <a16:creationId xmlns:a16="http://schemas.microsoft.com/office/drawing/2014/main" id="{1A59BF6B-C96F-4DD3-9755-4ED1BFB743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2790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Line 7">
                <a:extLst>
                  <a:ext uri="{FF2B5EF4-FFF2-40B4-BE49-F238E27FC236}">
                    <a16:creationId xmlns:a16="http://schemas.microsoft.com/office/drawing/2014/main" id="{0805169A-AE67-4239-B692-32EBCD6F83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3165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Line 8">
                <a:extLst>
                  <a:ext uri="{FF2B5EF4-FFF2-40B4-BE49-F238E27FC236}">
                    <a16:creationId xmlns:a16="http://schemas.microsoft.com/office/drawing/2014/main" id="{1FE004F7-F1A7-47F5-BCAE-6BB41C9FDB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99890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Line 9">
                <a:extLst>
                  <a:ext uri="{FF2B5EF4-FFF2-40B4-BE49-F238E27FC236}">
                    <a16:creationId xmlns:a16="http://schemas.microsoft.com/office/drawing/2014/main" id="{8E5448F1-7782-4C78-8A9F-6F2EACFE27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60265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Line 10">
                <a:extLst>
                  <a:ext uri="{FF2B5EF4-FFF2-40B4-BE49-F238E27FC236}">
                    <a16:creationId xmlns:a16="http://schemas.microsoft.com/office/drawing/2014/main" id="{FF3935D7-60FD-4305-8898-20902D4F9A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26990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Line 11">
                <a:extLst>
                  <a:ext uri="{FF2B5EF4-FFF2-40B4-BE49-F238E27FC236}">
                    <a16:creationId xmlns:a16="http://schemas.microsoft.com/office/drawing/2014/main" id="{77E8B587-0EB1-4103-921D-411DD83113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92128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Line 12">
                <a:extLst>
                  <a:ext uri="{FF2B5EF4-FFF2-40B4-BE49-F238E27FC236}">
                    <a16:creationId xmlns:a16="http://schemas.microsoft.com/office/drawing/2014/main" id="{09F5D340-AA5B-48BB-A566-78C85BEB39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4090" y="4365304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Rectangle 13">
                <a:extLst>
                  <a:ext uri="{FF2B5EF4-FFF2-40B4-BE49-F238E27FC236}">
                    <a16:creationId xmlns:a16="http://schemas.microsoft.com/office/drawing/2014/main" id="{9E4AFCE5-063C-497D-BFF3-877A412319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6753" y="4487542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Rectangle 14">
                <a:extLst>
                  <a:ext uri="{FF2B5EF4-FFF2-40B4-BE49-F238E27FC236}">
                    <a16:creationId xmlns:a16="http://schemas.microsoft.com/office/drawing/2014/main" id="{2F47ABBD-432B-44CA-A77C-7D7BA3DD6D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8553" y="44875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15">
                <a:extLst>
                  <a:ext uri="{FF2B5EF4-FFF2-40B4-BE49-F238E27FC236}">
                    <a16:creationId xmlns:a16="http://schemas.microsoft.com/office/drawing/2014/main" id="{608B1101-CB1E-41D2-81BD-89E3CF2FEC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25278" y="44875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Rectangle 16">
                <a:extLst>
                  <a:ext uri="{FF2B5EF4-FFF2-40B4-BE49-F238E27FC236}">
                    <a16:creationId xmlns:a16="http://schemas.microsoft.com/office/drawing/2014/main" id="{ECAF9377-1D19-4E9C-96F7-CD2C7007AA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5653" y="44875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Rectangle 17">
                <a:extLst>
                  <a:ext uri="{FF2B5EF4-FFF2-40B4-BE49-F238E27FC236}">
                    <a16:creationId xmlns:a16="http://schemas.microsoft.com/office/drawing/2014/main" id="{67830047-0808-498D-8A1A-EF910701B7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2378" y="44875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Rectangle 18">
                <a:extLst>
                  <a:ext uri="{FF2B5EF4-FFF2-40B4-BE49-F238E27FC236}">
                    <a16:creationId xmlns:a16="http://schemas.microsoft.com/office/drawing/2014/main" id="{9612D797-2DE8-46DC-A9F4-BAE87074CC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90528" y="4487542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Rectangle 19">
                <a:extLst>
                  <a:ext uri="{FF2B5EF4-FFF2-40B4-BE49-F238E27FC236}">
                    <a16:creationId xmlns:a16="http://schemas.microsoft.com/office/drawing/2014/main" id="{793D39D5-366D-4D2F-A0D4-4A603E55DC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2490" y="4487542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Line 20">
                <a:extLst>
                  <a:ext uri="{FF2B5EF4-FFF2-40B4-BE49-F238E27FC236}">
                    <a16:creationId xmlns:a16="http://schemas.microsoft.com/office/drawing/2014/main" id="{8A4D3D9A-3B83-4A60-95DB-BB29507919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61665" y="1845942"/>
                <a:ext cx="0" cy="24193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Line 21">
                <a:extLst>
                  <a:ext uri="{FF2B5EF4-FFF2-40B4-BE49-F238E27FC236}">
                    <a16:creationId xmlns:a16="http://schemas.microsoft.com/office/drawing/2014/main" id="{6B840E0D-FAC2-4710-8F00-46CCC3E201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02928" y="4265292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Line 22">
                <a:extLst>
                  <a:ext uri="{FF2B5EF4-FFF2-40B4-BE49-F238E27FC236}">
                    <a16:creationId xmlns:a16="http://schemas.microsoft.com/office/drawing/2014/main" id="{547DCCED-C845-42E2-9D1E-7BCDD64576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02928" y="3781104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Line 23">
                <a:extLst>
                  <a:ext uri="{FF2B5EF4-FFF2-40B4-BE49-F238E27FC236}">
                    <a16:creationId xmlns:a16="http://schemas.microsoft.com/office/drawing/2014/main" id="{604B4643-6691-4DD7-9C9E-CF836FD90A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02928" y="3296917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Line 24">
                <a:extLst>
                  <a:ext uri="{FF2B5EF4-FFF2-40B4-BE49-F238E27FC236}">
                    <a16:creationId xmlns:a16="http://schemas.microsoft.com/office/drawing/2014/main" id="{EBD3D619-5E94-4098-984F-412643FC10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02928" y="2814317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Line 25">
                <a:extLst>
                  <a:ext uri="{FF2B5EF4-FFF2-40B4-BE49-F238E27FC236}">
                    <a16:creationId xmlns:a16="http://schemas.microsoft.com/office/drawing/2014/main" id="{B5ADA8D8-E11F-4C01-9DB3-AC6DAAC1AA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02928" y="2330129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Line 26">
                <a:extLst>
                  <a:ext uri="{FF2B5EF4-FFF2-40B4-BE49-F238E27FC236}">
                    <a16:creationId xmlns:a16="http://schemas.microsoft.com/office/drawing/2014/main" id="{8BB69765-275F-4D39-9AE7-659D19F8C5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802928" y="1845942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Rectangle 27">
                <a:extLst>
                  <a:ext uri="{FF2B5EF4-FFF2-40B4-BE49-F238E27FC236}">
                    <a16:creationId xmlns:a16="http://schemas.microsoft.com/office/drawing/2014/main" id="{27317FAC-586E-4404-9F8C-CE13E2CA6C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207" y="4175275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Rectangle 28">
                <a:extLst>
                  <a:ext uri="{FF2B5EF4-FFF2-40B4-BE49-F238E27FC236}">
                    <a16:creationId xmlns:a16="http://schemas.microsoft.com/office/drawing/2014/main" id="{72117163-3F15-44B1-A45C-3457A53CF1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207" y="3691088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Rectangle 29">
                <a:extLst>
                  <a:ext uri="{FF2B5EF4-FFF2-40B4-BE49-F238E27FC236}">
                    <a16:creationId xmlns:a16="http://schemas.microsoft.com/office/drawing/2014/main" id="{4B47E1BF-0375-4A58-9105-10DDEED888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207" y="3206900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Rectangle 30">
                <a:extLst>
                  <a:ext uri="{FF2B5EF4-FFF2-40B4-BE49-F238E27FC236}">
                    <a16:creationId xmlns:a16="http://schemas.microsoft.com/office/drawing/2014/main" id="{D330D6B7-FC03-4B59-989B-5D7B862C5A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207" y="2722713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Rectangle 31">
                <a:extLst>
                  <a:ext uri="{FF2B5EF4-FFF2-40B4-BE49-F238E27FC236}">
                    <a16:creationId xmlns:a16="http://schemas.microsoft.com/office/drawing/2014/main" id="{281A9CB0-D9E4-4B9A-A3D9-04F8B4EB7D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207" y="2238525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Rectangle 32">
                <a:extLst>
                  <a:ext uri="{FF2B5EF4-FFF2-40B4-BE49-F238E27FC236}">
                    <a16:creationId xmlns:a16="http://schemas.microsoft.com/office/drawing/2014/main" id="{0EFF9F69-80C4-47E1-990D-51EC8776DB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0207" y="1755925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Freeform 33">
                <a:extLst>
                  <a:ext uri="{FF2B5EF4-FFF2-40B4-BE49-F238E27FC236}">
                    <a16:creationId xmlns:a16="http://schemas.microsoft.com/office/drawing/2014/main" id="{C253B6C1-F1AB-4436-B00E-E8E2ECC8C6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1665" y="1745929"/>
                <a:ext cx="3001963" cy="2619375"/>
              </a:xfrm>
              <a:custGeom>
                <a:avLst/>
                <a:gdLst>
                  <a:gd name="T0" fmla="*/ 0 w 515"/>
                  <a:gd name="T1" fmla="*/ 0 h 449"/>
                  <a:gd name="T2" fmla="*/ 0 w 515"/>
                  <a:gd name="T3" fmla="*/ 449 h 449"/>
                  <a:gd name="T4" fmla="*/ 515 w 515"/>
                  <a:gd name="T5" fmla="*/ 449 h 4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5" h="449">
                    <a:moveTo>
                      <a:pt x="0" y="0"/>
                    </a:moveTo>
                    <a:lnTo>
                      <a:pt x="0" y="449"/>
                    </a:lnTo>
                    <a:lnTo>
                      <a:pt x="515" y="449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Rectangle 35">
                <a:extLst>
                  <a:ext uri="{FF2B5EF4-FFF2-40B4-BE49-F238E27FC236}">
                    <a16:creationId xmlns:a16="http://schemas.microsoft.com/office/drawing/2014/main" id="{7BDEF244-1E5B-4A3A-B167-B14839318D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36623" y="4079990"/>
                <a:ext cx="48571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nths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36">
                <a:extLst>
                  <a:ext uri="{FF2B5EF4-FFF2-40B4-BE49-F238E27FC236}">
                    <a16:creationId xmlns:a16="http://schemas.microsoft.com/office/drawing/2014/main" id="{FBAA8435-C47F-495F-94E4-1D8BCE2AB4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682058" y="3093303"/>
                <a:ext cx="74263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ability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Freeform 37">
                <a:extLst>
                  <a:ext uri="{FF2B5EF4-FFF2-40B4-BE49-F238E27FC236}">
                    <a16:creationId xmlns:a16="http://schemas.microsoft.com/office/drawing/2014/main" id="{850B1669-3214-490D-83A4-FA9B6D1743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72790" y="1845942"/>
                <a:ext cx="3124200" cy="128588"/>
              </a:xfrm>
              <a:custGeom>
                <a:avLst/>
                <a:gdLst>
                  <a:gd name="T0" fmla="*/ 0 w 536"/>
                  <a:gd name="T1" fmla="*/ 0 h 22"/>
                  <a:gd name="T2" fmla="*/ 28 w 536"/>
                  <a:gd name="T3" fmla="*/ 0 h 22"/>
                  <a:gd name="T4" fmla="*/ 28 w 536"/>
                  <a:gd name="T5" fmla="*/ 1 h 22"/>
                  <a:gd name="T6" fmla="*/ 43 w 536"/>
                  <a:gd name="T7" fmla="*/ 1 h 22"/>
                  <a:gd name="T8" fmla="*/ 43 w 536"/>
                  <a:gd name="T9" fmla="*/ 3 h 22"/>
                  <a:gd name="T10" fmla="*/ 207 w 536"/>
                  <a:gd name="T11" fmla="*/ 3 h 22"/>
                  <a:gd name="T12" fmla="*/ 207 w 536"/>
                  <a:gd name="T13" fmla="*/ 5 h 22"/>
                  <a:gd name="T14" fmla="*/ 226 w 536"/>
                  <a:gd name="T15" fmla="*/ 5 h 22"/>
                  <a:gd name="T16" fmla="*/ 226 w 536"/>
                  <a:gd name="T17" fmla="*/ 10 h 22"/>
                  <a:gd name="T18" fmla="*/ 441 w 536"/>
                  <a:gd name="T19" fmla="*/ 10 h 22"/>
                  <a:gd name="T20" fmla="*/ 441 w 536"/>
                  <a:gd name="T21" fmla="*/ 22 h 22"/>
                  <a:gd name="T22" fmla="*/ 536 w 536"/>
                  <a:gd name="T23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536" h="22">
                    <a:moveTo>
                      <a:pt x="0" y="0"/>
                    </a:moveTo>
                    <a:lnTo>
                      <a:pt x="28" y="0"/>
                    </a:lnTo>
                    <a:lnTo>
                      <a:pt x="28" y="1"/>
                    </a:lnTo>
                    <a:lnTo>
                      <a:pt x="43" y="1"/>
                    </a:lnTo>
                    <a:lnTo>
                      <a:pt x="43" y="3"/>
                    </a:lnTo>
                    <a:lnTo>
                      <a:pt x="207" y="3"/>
                    </a:lnTo>
                    <a:lnTo>
                      <a:pt x="207" y="5"/>
                    </a:lnTo>
                    <a:lnTo>
                      <a:pt x="226" y="5"/>
                    </a:lnTo>
                    <a:lnTo>
                      <a:pt x="226" y="10"/>
                    </a:lnTo>
                    <a:lnTo>
                      <a:pt x="441" y="10"/>
                    </a:lnTo>
                    <a:lnTo>
                      <a:pt x="441" y="22"/>
                    </a:lnTo>
                    <a:lnTo>
                      <a:pt x="536" y="22"/>
                    </a:lnTo>
                  </a:path>
                </a:pathLst>
              </a:custGeom>
              <a:noFill/>
              <a:ln w="285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Freeform 38">
                <a:extLst>
                  <a:ext uri="{FF2B5EF4-FFF2-40B4-BE49-F238E27FC236}">
                    <a16:creationId xmlns:a16="http://schemas.microsoft.com/office/drawing/2014/main" id="{BB2B0A25-FF4E-4513-82B6-25B1F5033C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72790" y="1845942"/>
                <a:ext cx="3124200" cy="98425"/>
              </a:xfrm>
              <a:custGeom>
                <a:avLst/>
                <a:gdLst>
                  <a:gd name="T0" fmla="*/ 0 w 536"/>
                  <a:gd name="T1" fmla="*/ 0 h 17"/>
                  <a:gd name="T2" fmla="*/ 167 w 536"/>
                  <a:gd name="T3" fmla="*/ 0 h 17"/>
                  <a:gd name="T4" fmla="*/ 167 w 536"/>
                  <a:gd name="T5" fmla="*/ 2 h 17"/>
                  <a:gd name="T6" fmla="*/ 258 w 536"/>
                  <a:gd name="T7" fmla="*/ 2 h 17"/>
                  <a:gd name="T8" fmla="*/ 258 w 536"/>
                  <a:gd name="T9" fmla="*/ 5 h 17"/>
                  <a:gd name="T10" fmla="*/ 322 w 536"/>
                  <a:gd name="T11" fmla="*/ 5 h 17"/>
                  <a:gd name="T12" fmla="*/ 322 w 536"/>
                  <a:gd name="T13" fmla="*/ 10 h 17"/>
                  <a:gd name="T14" fmla="*/ 350 w 536"/>
                  <a:gd name="T15" fmla="*/ 10 h 17"/>
                  <a:gd name="T16" fmla="*/ 350 w 536"/>
                  <a:gd name="T17" fmla="*/ 17 h 17"/>
                  <a:gd name="T18" fmla="*/ 536 w 536"/>
                  <a:gd name="T19" fmla="*/ 17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536" h="17">
                    <a:moveTo>
                      <a:pt x="0" y="0"/>
                    </a:moveTo>
                    <a:lnTo>
                      <a:pt x="167" y="0"/>
                    </a:lnTo>
                    <a:lnTo>
                      <a:pt x="167" y="2"/>
                    </a:lnTo>
                    <a:lnTo>
                      <a:pt x="258" y="2"/>
                    </a:lnTo>
                    <a:lnTo>
                      <a:pt x="258" y="5"/>
                    </a:lnTo>
                    <a:lnTo>
                      <a:pt x="322" y="5"/>
                    </a:lnTo>
                    <a:lnTo>
                      <a:pt x="322" y="10"/>
                    </a:lnTo>
                    <a:lnTo>
                      <a:pt x="350" y="10"/>
                    </a:lnTo>
                    <a:lnTo>
                      <a:pt x="350" y="17"/>
                    </a:lnTo>
                    <a:lnTo>
                      <a:pt x="536" y="17"/>
                    </a:lnTo>
                  </a:path>
                </a:pathLst>
              </a:custGeom>
              <a:noFill/>
              <a:ln w="28575" cap="rnd">
                <a:solidFill>
                  <a:srgbClr val="DF536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Rectangle 39">
                <a:extLst>
                  <a:ext uri="{FF2B5EF4-FFF2-40B4-BE49-F238E27FC236}">
                    <a16:creationId xmlns:a16="http://schemas.microsoft.com/office/drawing/2014/main" id="{EEFC84B1-BBA8-4E8F-A817-4AB34FA2F9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1190" y="4760642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95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Rectangle 40">
                <a:extLst>
                  <a:ext uri="{FF2B5EF4-FFF2-40B4-BE49-F238E27FC236}">
                    <a16:creationId xmlns:a16="http://schemas.microsoft.com/office/drawing/2014/main" id="{BD4C4324-AA58-4DBA-99F0-3C994ECCF0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1565" y="4760642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7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Rectangle 41">
                <a:extLst>
                  <a:ext uri="{FF2B5EF4-FFF2-40B4-BE49-F238E27FC236}">
                    <a16:creationId xmlns:a16="http://schemas.microsoft.com/office/drawing/2014/main" id="{C8956E20-DEAF-43CE-AB9D-7D2C767C41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8290" y="4760642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4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Rectangle 42">
                <a:extLst>
                  <a:ext uri="{FF2B5EF4-FFF2-40B4-BE49-F238E27FC236}">
                    <a16:creationId xmlns:a16="http://schemas.microsoft.com/office/drawing/2014/main" id="{14D2D1A5-7060-4E4A-8EDE-E716D8A968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8665" y="4760642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4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Rectangle 43">
                <a:extLst>
                  <a:ext uri="{FF2B5EF4-FFF2-40B4-BE49-F238E27FC236}">
                    <a16:creationId xmlns:a16="http://schemas.microsoft.com/office/drawing/2014/main" id="{1DDBA81F-DA61-4CD6-9FF8-24CB18CE92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2378" y="47606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1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Rectangle 44">
                <a:extLst>
                  <a:ext uri="{FF2B5EF4-FFF2-40B4-BE49-F238E27FC236}">
                    <a16:creationId xmlns:a16="http://schemas.microsoft.com/office/drawing/2014/main" id="{6376C323-3A4B-4354-B9FD-6B92D17E83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17515" y="47606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Rectangle 45">
                <a:extLst>
                  <a:ext uri="{FF2B5EF4-FFF2-40B4-BE49-F238E27FC236}">
                    <a16:creationId xmlns:a16="http://schemas.microsoft.com/office/drawing/2014/main" id="{29C21275-82F9-4454-A03E-A8496C160E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9478" y="4760642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Rectangle 46">
                <a:extLst>
                  <a:ext uri="{FF2B5EF4-FFF2-40B4-BE49-F238E27FC236}">
                    <a16:creationId xmlns:a16="http://schemas.microsoft.com/office/drawing/2014/main" id="{B629F4CB-C79C-4F4E-A580-AD79B1C1D2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71190" y="5047929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4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Rectangle 47">
                <a:extLst>
                  <a:ext uri="{FF2B5EF4-FFF2-40B4-BE49-F238E27FC236}">
                    <a16:creationId xmlns:a16="http://schemas.microsoft.com/office/drawing/2014/main" id="{68917A57-1F18-4771-8736-88D6D7233E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1565" y="5047929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9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Rectangle 48">
                <a:extLst>
                  <a:ext uri="{FF2B5EF4-FFF2-40B4-BE49-F238E27FC236}">
                    <a16:creationId xmlns:a16="http://schemas.microsoft.com/office/drawing/2014/main" id="{16822499-58E9-4DEE-A671-70A4E01360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8290" y="5047929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1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Rectangle 49">
                <a:extLst>
                  <a:ext uri="{FF2B5EF4-FFF2-40B4-BE49-F238E27FC236}">
                    <a16:creationId xmlns:a16="http://schemas.microsoft.com/office/drawing/2014/main" id="{F033A2EB-5785-463C-982B-84DD4F6BD3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8665" y="5047929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2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Rectangle 50">
                <a:extLst>
                  <a:ext uri="{FF2B5EF4-FFF2-40B4-BE49-F238E27FC236}">
                    <a16:creationId xmlns:a16="http://schemas.microsoft.com/office/drawing/2014/main" id="{C579E65E-D16C-49AA-B41C-9CE3287CAB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2378" y="504792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7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Rectangle 51">
                <a:extLst>
                  <a:ext uri="{FF2B5EF4-FFF2-40B4-BE49-F238E27FC236}">
                    <a16:creationId xmlns:a16="http://schemas.microsoft.com/office/drawing/2014/main" id="{DEBF79B9-6227-4994-ACB8-4E445078C4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17515" y="504792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Rectangle 52">
                <a:extLst>
                  <a:ext uri="{FF2B5EF4-FFF2-40B4-BE49-F238E27FC236}">
                    <a16:creationId xmlns:a16="http://schemas.microsoft.com/office/drawing/2014/main" id="{1E241332-19AD-4E50-965C-5471B2D121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9478" y="5047929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Rectangle 53">
                <a:extLst>
                  <a:ext uri="{FF2B5EF4-FFF2-40B4-BE49-F238E27FC236}">
                    <a16:creationId xmlns:a16="http://schemas.microsoft.com/office/drawing/2014/main" id="{282D1F70-B20D-48FC-87E6-FBC4D5EC3C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7049" y="4760642"/>
                <a:ext cx="59035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T</a:t>
                </a: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oost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Rectangle 54">
                <a:extLst>
                  <a:ext uri="{FF2B5EF4-FFF2-40B4-BE49-F238E27FC236}">
                    <a16:creationId xmlns:a16="http://schemas.microsoft.com/office/drawing/2014/main" id="{D1475963-36BB-4ACF-8940-24F25D226D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2299" y="5043629"/>
                <a:ext cx="41299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BRT</a:t>
                </a:r>
                <a:endParaRPr kumimoji="0" lang="ja-JP" altLang="ja-JP" sz="12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Line 55">
                <a:extLst>
                  <a:ext uri="{FF2B5EF4-FFF2-40B4-BE49-F238E27FC236}">
                    <a16:creationId xmlns:a16="http://schemas.microsoft.com/office/drawing/2014/main" id="{536B1DE2-9E69-4F34-872D-034EE1B5DD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91283" y="2385556"/>
                <a:ext cx="163513" cy="0"/>
              </a:xfrm>
              <a:prstGeom prst="line">
                <a:avLst/>
              </a:prstGeom>
              <a:noFill/>
              <a:ln w="285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Line 56">
                <a:extLst>
                  <a:ext uri="{FF2B5EF4-FFF2-40B4-BE49-F238E27FC236}">
                    <a16:creationId xmlns:a16="http://schemas.microsoft.com/office/drawing/2014/main" id="{D000E90B-9873-403B-8703-B855B5FD32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1043" y="2650287"/>
                <a:ext cx="163513" cy="0"/>
              </a:xfrm>
              <a:prstGeom prst="line">
                <a:avLst/>
              </a:prstGeom>
              <a:noFill/>
              <a:ln w="28575" cap="rnd">
                <a:solidFill>
                  <a:srgbClr val="DF536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Rectangle 58">
                <a:extLst>
                  <a:ext uri="{FF2B5EF4-FFF2-40B4-BE49-F238E27FC236}">
                    <a16:creationId xmlns:a16="http://schemas.microsoft.com/office/drawing/2014/main" id="{F2757776-9257-40C7-AD1C-1D557B32DF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27674" y="2276277"/>
                <a:ext cx="59035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T</a:t>
                </a: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oost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Rectangle 59">
                <a:extLst>
                  <a:ext uri="{FF2B5EF4-FFF2-40B4-BE49-F238E27FC236}">
                    <a16:creationId xmlns:a16="http://schemas.microsoft.com/office/drawing/2014/main" id="{2E9656BF-26F4-45E3-807C-F1B391279E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31868" y="2551877"/>
                <a:ext cx="41299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BRT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9" name="Rectangle 72">
              <a:extLst>
                <a:ext uri="{FF2B5EF4-FFF2-40B4-BE49-F238E27FC236}">
                  <a16:creationId xmlns:a16="http://schemas.microsoft.com/office/drawing/2014/main" id="{45442BB1-18F2-44BA-AB45-091EE84ABD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8765" y="4312756"/>
              <a:ext cx="1421840" cy="226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5334B6C0-B5CE-01DA-A0BF-B1FCDC922906}"/>
                </a:ext>
              </a:extLst>
            </p:cNvPr>
            <p:cNvSpPr txBox="1"/>
            <p:nvPr/>
          </p:nvSpPr>
          <p:spPr>
            <a:xfrm>
              <a:off x="1745810" y="1062408"/>
              <a:ext cx="44114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kumimoji="1"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24544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787353D-A0B0-4CFC-86E0-57967C4EEE3F}"/>
              </a:ext>
            </a:extLst>
          </p:cNvPr>
          <p:cNvGrpSpPr/>
          <p:nvPr/>
        </p:nvGrpSpPr>
        <p:grpSpPr>
          <a:xfrm>
            <a:off x="2063496" y="1490389"/>
            <a:ext cx="4026564" cy="3512235"/>
            <a:chOff x="1466186" y="1173298"/>
            <a:chExt cx="4026564" cy="3512235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8077E347-39F5-4828-B652-E0696B071419}"/>
                </a:ext>
              </a:extLst>
            </p:cNvPr>
            <p:cNvSpPr txBox="1"/>
            <p:nvPr/>
          </p:nvSpPr>
          <p:spPr>
            <a:xfrm>
              <a:off x="2759416" y="2855297"/>
              <a:ext cx="99322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</a:t>
              </a:r>
              <a:r>
                <a:rPr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77</a:t>
              </a:r>
            </a:p>
          </p:txBody>
        </p:sp>
        <p:sp>
          <p:nvSpPr>
            <p:cNvPr id="9" name="Line 5">
              <a:extLst>
                <a:ext uri="{FF2B5EF4-FFF2-40B4-BE49-F238E27FC236}">
                  <a16:creationId xmlns:a16="http://schemas.microsoft.com/office/drawing/2014/main" id="{B73CC162-5146-42FE-84E3-DBA7903B50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8550" y="3803650"/>
              <a:ext cx="27813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6">
              <a:extLst>
                <a:ext uri="{FF2B5EF4-FFF2-40B4-BE49-F238E27FC236}">
                  <a16:creationId xmlns:a16="http://schemas.microsoft.com/office/drawing/2014/main" id="{44DF828C-B0ED-4DEE-A25E-8AA8E9CE9C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8550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7">
              <a:extLst>
                <a:ext uri="{FF2B5EF4-FFF2-40B4-BE49-F238E27FC236}">
                  <a16:creationId xmlns:a16="http://schemas.microsoft.com/office/drawing/2014/main" id="{ED35EE48-B06B-4878-9DD9-DC1F81279A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8925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8">
              <a:extLst>
                <a:ext uri="{FF2B5EF4-FFF2-40B4-BE49-F238E27FC236}">
                  <a16:creationId xmlns:a16="http://schemas.microsoft.com/office/drawing/2014/main" id="{BD7B36C1-98DF-49E5-85CC-917093818B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5650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9">
              <a:extLst>
                <a:ext uri="{FF2B5EF4-FFF2-40B4-BE49-F238E27FC236}">
                  <a16:creationId xmlns:a16="http://schemas.microsoft.com/office/drawing/2014/main" id="{65BE5EC2-F679-4AAA-B9FB-E8D447B7E7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6025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0">
              <a:extLst>
                <a:ext uri="{FF2B5EF4-FFF2-40B4-BE49-F238E27FC236}">
                  <a16:creationId xmlns:a16="http://schemas.microsoft.com/office/drawing/2014/main" id="{53530F0C-9460-4219-8C4D-1DE731F538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22750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1">
              <a:extLst>
                <a:ext uri="{FF2B5EF4-FFF2-40B4-BE49-F238E27FC236}">
                  <a16:creationId xmlns:a16="http://schemas.microsoft.com/office/drawing/2014/main" id="{71FA8142-B9A7-4DFC-BA9F-5F5DCDF11B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7888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Line 12">
              <a:extLst>
                <a:ext uri="{FF2B5EF4-FFF2-40B4-BE49-F238E27FC236}">
                  <a16:creationId xmlns:a16="http://schemas.microsoft.com/office/drawing/2014/main" id="{D2DFA398-BD38-48AD-BD2B-5DC9B2BE9B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49850" y="3803650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3">
              <a:extLst>
                <a:ext uri="{FF2B5EF4-FFF2-40B4-BE49-F238E27FC236}">
                  <a16:creationId xmlns:a16="http://schemas.microsoft.com/office/drawing/2014/main" id="{3F6DA7F8-50E3-4DE7-A200-16EA9CA5CA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2513" y="3925888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4">
              <a:extLst>
                <a:ext uri="{FF2B5EF4-FFF2-40B4-BE49-F238E27FC236}">
                  <a16:creationId xmlns:a16="http://schemas.microsoft.com/office/drawing/2014/main" id="{C1D17710-E51C-4E23-879F-8325C0175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4313" y="392588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5">
              <a:extLst>
                <a:ext uri="{FF2B5EF4-FFF2-40B4-BE49-F238E27FC236}">
                  <a16:creationId xmlns:a16="http://schemas.microsoft.com/office/drawing/2014/main" id="{10540D9C-EE8B-4352-BCE5-D3A496D1ED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1038" y="392588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6">
              <a:extLst>
                <a:ext uri="{FF2B5EF4-FFF2-40B4-BE49-F238E27FC236}">
                  <a16:creationId xmlns:a16="http://schemas.microsoft.com/office/drawing/2014/main" id="{D5DEB1B7-69BC-4F53-A70A-2C91D3DA01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1413" y="392588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7">
              <a:extLst>
                <a:ext uri="{FF2B5EF4-FFF2-40B4-BE49-F238E27FC236}">
                  <a16:creationId xmlns:a16="http://schemas.microsoft.com/office/drawing/2014/main" id="{9E29BE4D-0F77-4D15-91B4-BC1A570B52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8138" y="392588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8">
              <a:extLst>
                <a:ext uri="{FF2B5EF4-FFF2-40B4-BE49-F238E27FC236}">
                  <a16:creationId xmlns:a16="http://schemas.microsoft.com/office/drawing/2014/main" id="{E750F25C-540D-4253-8D44-E2FB172C45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288" y="392588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19">
              <a:extLst>
                <a:ext uri="{FF2B5EF4-FFF2-40B4-BE49-F238E27FC236}">
                  <a16:creationId xmlns:a16="http://schemas.microsoft.com/office/drawing/2014/main" id="{7FDBD083-4CB6-48D0-8CDA-2CD6064AE9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8250" y="392588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0">
              <a:extLst>
                <a:ext uri="{FF2B5EF4-FFF2-40B4-BE49-F238E27FC236}">
                  <a16:creationId xmlns:a16="http://schemas.microsoft.com/office/drawing/2014/main" id="{26F38B2D-733C-4F91-B359-D8A0CAD4E1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57425" y="1284288"/>
              <a:ext cx="0" cy="24193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1">
              <a:extLst>
                <a:ext uri="{FF2B5EF4-FFF2-40B4-BE49-F238E27FC236}">
                  <a16:creationId xmlns:a16="http://schemas.microsoft.com/office/drawing/2014/main" id="{A0842631-491A-4083-8B73-7FBEBA8589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8688" y="3703638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2">
              <a:extLst>
                <a:ext uri="{FF2B5EF4-FFF2-40B4-BE49-F238E27FC236}">
                  <a16:creationId xmlns:a16="http://schemas.microsoft.com/office/drawing/2014/main" id="{55E3C1F4-D16A-4198-B691-4A285436E2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8688" y="321945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3">
              <a:extLst>
                <a:ext uri="{FF2B5EF4-FFF2-40B4-BE49-F238E27FC236}">
                  <a16:creationId xmlns:a16="http://schemas.microsoft.com/office/drawing/2014/main" id="{8707E5DC-D82C-44F3-AD07-D6A9D38365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8688" y="2735263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4">
              <a:extLst>
                <a:ext uri="{FF2B5EF4-FFF2-40B4-BE49-F238E27FC236}">
                  <a16:creationId xmlns:a16="http://schemas.microsoft.com/office/drawing/2014/main" id="{426466CE-EB36-44D5-96CA-9B97D0D2EE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8688" y="2252663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5">
              <a:extLst>
                <a:ext uri="{FF2B5EF4-FFF2-40B4-BE49-F238E27FC236}">
                  <a16:creationId xmlns:a16="http://schemas.microsoft.com/office/drawing/2014/main" id="{EB0F3AD5-05ED-4CAB-AF30-EC2D78FC8E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8688" y="1768475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Line 26">
              <a:extLst>
                <a:ext uri="{FF2B5EF4-FFF2-40B4-BE49-F238E27FC236}">
                  <a16:creationId xmlns:a16="http://schemas.microsoft.com/office/drawing/2014/main" id="{79A840ED-27A3-43B5-9ADB-59069C9DC1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8688" y="1284288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7">
              <a:extLst>
                <a:ext uri="{FF2B5EF4-FFF2-40B4-BE49-F238E27FC236}">
                  <a16:creationId xmlns:a16="http://schemas.microsoft.com/office/drawing/2014/main" id="{73FB3C80-90C0-4DBD-BD46-E31AE1E728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0799" y="359264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8">
              <a:extLst>
                <a:ext uri="{FF2B5EF4-FFF2-40B4-BE49-F238E27FC236}">
                  <a16:creationId xmlns:a16="http://schemas.microsoft.com/office/drawing/2014/main" id="{B7305ABF-A086-488E-975F-9F6482EF2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0799" y="310846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29">
              <a:extLst>
                <a:ext uri="{FF2B5EF4-FFF2-40B4-BE49-F238E27FC236}">
                  <a16:creationId xmlns:a16="http://schemas.microsoft.com/office/drawing/2014/main" id="{FE306CB8-EA36-499C-AC9B-255D942F99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0799" y="262427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0">
              <a:extLst>
                <a:ext uri="{FF2B5EF4-FFF2-40B4-BE49-F238E27FC236}">
                  <a16:creationId xmlns:a16="http://schemas.microsoft.com/office/drawing/2014/main" id="{F355E857-4DCA-4631-B4F0-A1CD8DC44F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0799" y="214008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1">
              <a:extLst>
                <a:ext uri="{FF2B5EF4-FFF2-40B4-BE49-F238E27FC236}">
                  <a16:creationId xmlns:a16="http://schemas.microsoft.com/office/drawing/2014/main" id="{1652FCED-9866-461E-8C9F-FC1DD5916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0799" y="165589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2">
              <a:extLst>
                <a:ext uri="{FF2B5EF4-FFF2-40B4-BE49-F238E27FC236}">
                  <a16:creationId xmlns:a16="http://schemas.microsoft.com/office/drawing/2014/main" id="{1B4C0221-24E2-4761-A7DB-68D06E11C6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0799" y="117329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33">
              <a:extLst>
                <a:ext uri="{FF2B5EF4-FFF2-40B4-BE49-F238E27FC236}">
                  <a16:creationId xmlns:a16="http://schemas.microsoft.com/office/drawing/2014/main" id="{66609476-66DD-4FFB-8306-357CBD9101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7425" y="1184275"/>
              <a:ext cx="3001963" cy="2619375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5">
              <a:extLst>
                <a:ext uri="{FF2B5EF4-FFF2-40B4-BE49-F238E27FC236}">
                  <a16:creationId xmlns:a16="http://schemas.microsoft.com/office/drawing/2014/main" id="{F75A6BA9-4950-457D-9FD8-CDDF0922D4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6995" y="3491726"/>
              <a:ext cx="48571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6">
              <a:extLst>
                <a:ext uri="{FF2B5EF4-FFF2-40B4-BE49-F238E27FC236}">
                  <a16:creationId xmlns:a16="http://schemas.microsoft.com/office/drawing/2014/main" id="{415088C7-CBA1-4DF9-BF14-50D46BA1841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93968" y="2488942"/>
              <a:ext cx="74263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37">
              <a:extLst>
                <a:ext uri="{FF2B5EF4-FFF2-40B4-BE49-F238E27FC236}">
                  <a16:creationId xmlns:a16="http://schemas.microsoft.com/office/drawing/2014/main" id="{DB9D8FF8-C284-464B-B941-177E71A0B5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8550" y="1284288"/>
              <a:ext cx="3124200" cy="58738"/>
            </a:xfrm>
            <a:custGeom>
              <a:avLst/>
              <a:gdLst>
                <a:gd name="T0" fmla="*/ 0 w 536"/>
                <a:gd name="T1" fmla="*/ 0 h 10"/>
                <a:gd name="T2" fmla="*/ 254 w 536"/>
                <a:gd name="T3" fmla="*/ 0 h 10"/>
                <a:gd name="T4" fmla="*/ 254 w 536"/>
                <a:gd name="T5" fmla="*/ 1 h 10"/>
                <a:gd name="T6" fmla="*/ 318 w 536"/>
                <a:gd name="T7" fmla="*/ 1 h 10"/>
                <a:gd name="T8" fmla="*/ 318 w 536"/>
                <a:gd name="T9" fmla="*/ 3 h 10"/>
                <a:gd name="T10" fmla="*/ 358 w 536"/>
                <a:gd name="T11" fmla="*/ 3 h 10"/>
                <a:gd name="T12" fmla="*/ 358 w 536"/>
                <a:gd name="T13" fmla="*/ 6 h 10"/>
                <a:gd name="T14" fmla="*/ 402 w 536"/>
                <a:gd name="T15" fmla="*/ 6 h 10"/>
                <a:gd name="T16" fmla="*/ 402 w 536"/>
                <a:gd name="T17" fmla="*/ 10 h 10"/>
                <a:gd name="T18" fmla="*/ 536 w 536"/>
                <a:gd name="T19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36" h="10">
                  <a:moveTo>
                    <a:pt x="0" y="0"/>
                  </a:moveTo>
                  <a:lnTo>
                    <a:pt x="254" y="0"/>
                  </a:lnTo>
                  <a:lnTo>
                    <a:pt x="254" y="1"/>
                  </a:lnTo>
                  <a:lnTo>
                    <a:pt x="318" y="1"/>
                  </a:lnTo>
                  <a:lnTo>
                    <a:pt x="318" y="3"/>
                  </a:lnTo>
                  <a:lnTo>
                    <a:pt x="358" y="3"/>
                  </a:lnTo>
                  <a:lnTo>
                    <a:pt x="358" y="6"/>
                  </a:lnTo>
                  <a:lnTo>
                    <a:pt x="402" y="6"/>
                  </a:lnTo>
                  <a:lnTo>
                    <a:pt x="402" y="10"/>
                  </a:lnTo>
                  <a:lnTo>
                    <a:pt x="536" y="10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38">
              <a:extLst>
                <a:ext uri="{FF2B5EF4-FFF2-40B4-BE49-F238E27FC236}">
                  <a16:creationId xmlns:a16="http://schemas.microsoft.com/office/drawing/2014/main" id="{8EF5C21A-386A-4BA5-A2F3-4A6E8275218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8550" y="1284288"/>
              <a:ext cx="3124200" cy="6350"/>
            </a:xfrm>
            <a:custGeom>
              <a:avLst/>
              <a:gdLst>
                <a:gd name="T0" fmla="*/ 0 w 536"/>
                <a:gd name="T1" fmla="*/ 0 h 1"/>
                <a:gd name="T2" fmla="*/ 63 w 536"/>
                <a:gd name="T3" fmla="*/ 0 h 1"/>
                <a:gd name="T4" fmla="*/ 63 w 536"/>
                <a:gd name="T5" fmla="*/ 1 h 1"/>
                <a:gd name="T6" fmla="*/ 536 w 536"/>
                <a:gd name="T7" fmla="*/ 1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6" h="1">
                  <a:moveTo>
                    <a:pt x="0" y="0"/>
                  </a:moveTo>
                  <a:lnTo>
                    <a:pt x="63" y="0"/>
                  </a:lnTo>
                  <a:lnTo>
                    <a:pt x="63" y="1"/>
                  </a:lnTo>
                  <a:lnTo>
                    <a:pt x="536" y="1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39">
              <a:extLst>
                <a:ext uri="{FF2B5EF4-FFF2-40B4-BE49-F238E27FC236}">
                  <a16:creationId xmlns:a16="http://schemas.microsoft.com/office/drawing/2014/main" id="{53C71A1D-3590-4428-8B93-A7CF407332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6950" y="425770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21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0">
              <a:extLst>
                <a:ext uri="{FF2B5EF4-FFF2-40B4-BE49-F238E27FC236}">
                  <a16:creationId xmlns:a16="http://schemas.microsoft.com/office/drawing/2014/main" id="{CE221F0D-990F-44EC-81F2-5A4C8E2F7A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7325" y="425770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1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1">
              <a:extLst>
                <a:ext uri="{FF2B5EF4-FFF2-40B4-BE49-F238E27FC236}">
                  <a16:creationId xmlns:a16="http://schemas.microsoft.com/office/drawing/2014/main" id="{13EB183F-2AAA-4FFA-9C0F-0B96DF945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4050" y="425770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33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2">
              <a:extLst>
                <a:ext uri="{FF2B5EF4-FFF2-40B4-BE49-F238E27FC236}">
                  <a16:creationId xmlns:a16="http://schemas.microsoft.com/office/drawing/2014/main" id="{24DA7B5D-0132-4982-BEAE-3A4A0A3B6E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4425" y="425770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24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3">
              <a:extLst>
                <a:ext uri="{FF2B5EF4-FFF2-40B4-BE49-F238E27FC236}">
                  <a16:creationId xmlns:a16="http://schemas.microsoft.com/office/drawing/2014/main" id="{CEF97765-9BAE-4598-BA78-9B05EB503D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150" y="425770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8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4">
              <a:extLst>
                <a:ext uri="{FF2B5EF4-FFF2-40B4-BE49-F238E27FC236}">
                  <a16:creationId xmlns:a16="http://schemas.microsoft.com/office/drawing/2014/main" id="{9BB4CB8A-1DD3-4EC2-ADCC-2853DFFAA2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6288" y="4257708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9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5">
              <a:extLst>
                <a:ext uri="{FF2B5EF4-FFF2-40B4-BE49-F238E27FC236}">
                  <a16:creationId xmlns:a16="http://schemas.microsoft.com/office/drawing/2014/main" id="{BB391075-FF01-47A3-91FC-EF43E65D93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5238" y="425770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9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6">
              <a:extLst>
                <a:ext uri="{FF2B5EF4-FFF2-40B4-BE49-F238E27FC236}">
                  <a16:creationId xmlns:a16="http://schemas.microsoft.com/office/drawing/2014/main" id="{B4CC68AB-7E89-4B07-93A3-8ED71E0C0B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6950" y="4486275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73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47">
              <a:extLst>
                <a:ext uri="{FF2B5EF4-FFF2-40B4-BE49-F238E27FC236}">
                  <a16:creationId xmlns:a16="http://schemas.microsoft.com/office/drawing/2014/main" id="{47768961-04D6-4F0F-9EE8-CBEEC00051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7325" y="4486275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9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48">
              <a:extLst>
                <a:ext uri="{FF2B5EF4-FFF2-40B4-BE49-F238E27FC236}">
                  <a16:creationId xmlns:a16="http://schemas.microsoft.com/office/drawing/2014/main" id="{EC327562-1E6F-4657-B6C7-178A0DDD1F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4050" y="4486275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49">
              <a:extLst>
                <a:ext uri="{FF2B5EF4-FFF2-40B4-BE49-F238E27FC236}">
                  <a16:creationId xmlns:a16="http://schemas.microsoft.com/office/drawing/2014/main" id="{5B4256EA-3A9D-4F19-A8AA-8C0ADA64A6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4425" y="4486275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5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0">
              <a:extLst>
                <a:ext uri="{FF2B5EF4-FFF2-40B4-BE49-F238E27FC236}">
                  <a16:creationId xmlns:a16="http://schemas.microsoft.com/office/drawing/2014/main" id="{F3B3054D-DF95-4DBC-BED7-73553A346D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8138" y="448627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7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1">
              <a:extLst>
                <a:ext uri="{FF2B5EF4-FFF2-40B4-BE49-F238E27FC236}">
                  <a16:creationId xmlns:a16="http://schemas.microsoft.com/office/drawing/2014/main" id="{EA157EEA-59EE-48E0-8C9D-CB19CD8EEA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3275" y="448627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52">
              <a:extLst>
                <a:ext uri="{FF2B5EF4-FFF2-40B4-BE49-F238E27FC236}">
                  <a16:creationId xmlns:a16="http://schemas.microsoft.com/office/drawing/2014/main" id="{9AA3ECA7-646A-472C-AAF7-3ED1593E6D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5238" y="448627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55">
              <a:extLst>
                <a:ext uri="{FF2B5EF4-FFF2-40B4-BE49-F238E27FC236}">
                  <a16:creationId xmlns:a16="http://schemas.microsoft.com/office/drawing/2014/main" id="{658324BB-DCFF-4D94-817A-CBF39C493D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4125" y="2105071"/>
              <a:ext cx="163513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Line 56">
              <a:extLst>
                <a:ext uri="{FF2B5EF4-FFF2-40B4-BE49-F238E27FC236}">
                  <a16:creationId xmlns:a16="http://schemas.microsoft.com/office/drawing/2014/main" id="{EB3534B0-E101-4DA2-A361-401156BEF6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93885" y="2369802"/>
              <a:ext cx="163513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58">
              <a:extLst>
                <a:ext uri="{FF2B5EF4-FFF2-40B4-BE49-F238E27FC236}">
                  <a16:creationId xmlns:a16="http://schemas.microsoft.com/office/drawing/2014/main" id="{C67A3CC9-DAA5-4C6B-8E73-4381D978AA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0516" y="1995792"/>
              <a:ext cx="5903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59">
              <a:extLst>
                <a:ext uri="{FF2B5EF4-FFF2-40B4-BE49-F238E27FC236}">
                  <a16:creationId xmlns:a16="http://schemas.microsoft.com/office/drawing/2014/main" id="{4D59F4A7-A11B-41F8-8804-BEA5732EB4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4710" y="2271392"/>
              <a:ext cx="412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53">
              <a:extLst>
                <a:ext uri="{FF2B5EF4-FFF2-40B4-BE49-F238E27FC236}">
                  <a16:creationId xmlns:a16="http://schemas.microsoft.com/office/drawing/2014/main" id="{0CAE333E-74D4-4578-B40A-884E1AE297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6186" y="4241894"/>
              <a:ext cx="5903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54">
              <a:extLst>
                <a:ext uri="{FF2B5EF4-FFF2-40B4-BE49-F238E27FC236}">
                  <a16:creationId xmlns:a16="http://schemas.microsoft.com/office/drawing/2014/main" id="{D71B3AA2-1B35-4C59-BC7D-C90B19F0F0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816" y="4500867"/>
              <a:ext cx="412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Rectangle 72">
            <a:extLst>
              <a:ext uri="{FF2B5EF4-FFF2-40B4-BE49-F238E27FC236}">
                <a16:creationId xmlns:a16="http://schemas.microsoft.com/office/drawing/2014/main" id="{CEEEC3F2-4353-466C-9131-F0A37D2886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3365" y="4251754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BF6C81B-7786-D588-88C2-D8C7A3448155}"/>
              </a:ext>
            </a:extLst>
          </p:cNvPr>
          <p:cNvSpPr txBox="1"/>
          <p:nvPr/>
        </p:nvSpPr>
        <p:spPr>
          <a:xfrm>
            <a:off x="1745810" y="1062408"/>
            <a:ext cx="458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75470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BF9E595-4D17-4899-B2B6-0A47746C1700}"/>
              </a:ext>
            </a:extLst>
          </p:cNvPr>
          <p:cNvGrpSpPr/>
          <p:nvPr/>
        </p:nvGrpSpPr>
        <p:grpSpPr>
          <a:xfrm>
            <a:off x="2351647" y="1593883"/>
            <a:ext cx="4224723" cy="3466344"/>
            <a:chOff x="2277905" y="1792986"/>
            <a:chExt cx="4224723" cy="3466344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D562087A-2DC7-4658-B259-BDAB37834FC1}"/>
                </a:ext>
              </a:extLst>
            </p:cNvPr>
            <p:cNvSpPr txBox="1"/>
            <p:nvPr/>
          </p:nvSpPr>
          <p:spPr>
            <a:xfrm>
              <a:off x="3663016" y="3142231"/>
              <a:ext cx="118639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</a:t>
              </a:r>
              <a:r>
                <a:rPr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0</a:t>
              </a:r>
            </a:p>
          </p:txBody>
        </p:sp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3FF09E82-396D-4B5A-9BFF-6FEA41FF48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6965" y="4318680"/>
              <a:ext cx="302101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11E67622-4E94-4A50-8BE5-4E34A77BF0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6965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id="{3B8C3087-157D-40B7-96A7-EA16146725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7027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74C32A5B-AA97-42C1-8B96-C96666B5A7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3440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726B3088-B61E-4A61-A656-24FB097B7C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5090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490C38A3-45B1-4357-8624-21BC19F2B4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1502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F65367A2-2007-4959-B2D1-2C1718C5B0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27915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78145132-684E-42C4-99FD-7C10397E41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27977" y="4318680"/>
              <a:ext cx="0" cy="571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D123C3ED-A08A-4D1E-A508-75777E2021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6165" y="4445680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9E9491AF-277D-4C17-AEA6-4CD9F70561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7652" y="44456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C33D91FD-1732-4154-9542-05AC0B2C08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4065" y="44456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7D3235D2-DE17-4EF2-93AB-F1ADA54BB6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5715" y="44456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F0D906DD-00BB-422C-AE61-E3FB72D254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2127" y="44456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0ACB05D2-8CCE-42D3-8C83-D8B986F70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9965" y="4445680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688BEAB4-F471-44C5-97E8-2DD54DDE4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0027" y="4445680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0">
              <a:extLst>
                <a:ext uri="{FF2B5EF4-FFF2-40B4-BE49-F238E27FC236}">
                  <a16:creationId xmlns:a16="http://schemas.microsoft.com/office/drawing/2014/main" id="{9E8AFDC0-3364-4B71-A3B2-3E0C14D857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6315" y="1902505"/>
              <a:ext cx="0" cy="232092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25837025-9BAB-4496-B4F3-C1778FD520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2815" y="4223430"/>
              <a:ext cx="635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A069F495-8EDB-40E1-AD9E-D1560DF4AA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2815" y="3761467"/>
              <a:ext cx="635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782A2E04-ABAE-4E31-A29A-EB2177A261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2815" y="3297917"/>
              <a:ext cx="635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B11562EC-D662-45DC-B387-71EE9F5F1E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2815" y="2828017"/>
              <a:ext cx="635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EB50894D-7668-4355-992E-0663DE395D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2815" y="2366055"/>
              <a:ext cx="635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id="{ACDDF017-0011-4158-A8ED-06ED594931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2815" y="1902505"/>
              <a:ext cx="635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52CC1ADF-7C23-407E-BC03-BCD94FFFB8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621" y="411391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A4ED6EBD-F523-4C7C-ACB0-C661BA1E44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621" y="365036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368AB2F3-4B92-471A-B56A-0405867B12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621" y="318839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20E250F2-175E-4044-9279-6EA49B0D3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621" y="272484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74A7BD42-FC17-4D6C-A79F-2327666C2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621" y="226288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6261215B-9871-4C51-9327-C7708589EA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4621" y="179298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41E7C0BA-712A-4B5D-B3D8-FF8B40BECED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86315" y="1808842"/>
              <a:ext cx="3262313" cy="2509838"/>
            </a:xfrm>
            <a:custGeom>
              <a:avLst/>
              <a:gdLst>
                <a:gd name="T0" fmla="*/ 0 w 515"/>
                <a:gd name="T1" fmla="*/ 0 h 396"/>
                <a:gd name="T2" fmla="*/ 0 w 515"/>
                <a:gd name="T3" fmla="*/ 396 h 396"/>
                <a:gd name="T4" fmla="*/ 515 w 515"/>
                <a:gd name="T5" fmla="*/ 396 h 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396">
                  <a:moveTo>
                    <a:pt x="0" y="0"/>
                  </a:moveTo>
                  <a:lnTo>
                    <a:pt x="0" y="396"/>
                  </a:lnTo>
                  <a:lnTo>
                    <a:pt x="515" y="396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695326A1-7E41-4300-B372-1234D02CBC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4027" y="3976307"/>
              <a:ext cx="48571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BF52F426-609C-468B-9BEC-551932CB6C2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998918" y="2970634"/>
              <a:ext cx="74263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Line 37">
              <a:extLst>
                <a:ext uri="{FF2B5EF4-FFF2-40B4-BE49-F238E27FC236}">
                  <a16:creationId xmlns:a16="http://schemas.microsoft.com/office/drawing/2014/main" id="{CD8D65CE-A325-4E7B-AA4E-FE910688F9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6965" y="1902505"/>
              <a:ext cx="3395663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Line 38">
              <a:extLst>
                <a:ext uri="{FF2B5EF4-FFF2-40B4-BE49-F238E27FC236}">
                  <a16:creationId xmlns:a16="http://schemas.microsoft.com/office/drawing/2014/main" id="{43AB40DE-4707-43F1-9E3E-6101866B64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6965" y="1902505"/>
              <a:ext cx="3395663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D0C43EA1-9EB0-46F0-87EE-3022AEF111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015" y="4786242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9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0976B195-F9A5-4130-A62F-774148F828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9077" y="4786242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44F9967F-09FC-4E3F-B70F-57D30F24B1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490" y="4786242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9B16A20A-32C2-4BF6-B96D-BE380EDAF9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7140" y="4786242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3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81118D74-2098-4750-966C-8E2C9D96A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3552" y="4786242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5C3BD5C5-1EDB-494C-8C3B-46EE89EB05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8540" y="478624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37C4B60D-94D1-428D-980D-E32AFEF778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8602" y="4786242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11B4CA66-B99B-4E75-B818-42357922DF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015" y="5074664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1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19DB7EE0-47BA-4D3A-ADAB-5E4231A17C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9077" y="5074664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6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3824769A-5D42-48BD-93DA-D7488F874A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5490" y="5074664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D785CA7A-3A8E-4565-AE7D-C5AE335EB0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7140" y="5074664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1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CDA1B147-9FB3-42C0-83CC-CC79E8C56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2127" y="507466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282E92CA-E70D-4193-A7F9-01285FB79C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8540" y="507466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21317BDE-C192-489A-9205-232BA428C3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8602" y="5074664"/>
              <a:ext cx="14542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53">
              <a:extLst>
                <a:ext uri="{FF2B5EF4-FFF2-40B4-BE49-F238E27FC236}">
                  <a16:creationId xmlns:a16="http://schemas.microsoft.com/office/drawing/2014/main" id="{74C7BFBD-43C2-46C5-951B-768148FCE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687" y="4796400"/>
              <a:ext cx="5903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54">
              <a:extLst>
                <a:ext uri="{FF2B5EF4-FFF2-40B4-BE49-F238E27FC236}">
                  <a16:creationId xmlns:a16="http://schemas.microsoft.com/office/drawing/2014/main" id="{F61FAAF7-6237-4F3A-929A-70927F696D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0388" y="5071367"/>
              <a:ext cx="412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Line 55">
              <a:extLst>
                <a:ext uri="{FF2B5EF4-FFF2-40B4-BE49-F238E27FC236}">
                  <a16:creationId xmlns:a16="http://schemas.microsoft.com/office/drawing/2014/main" id="{6488D84C-3D68-44C3-BB6F-AD4633BB31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37697" y="2810098"/>
              <a:ext cx="163513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56">
              <a:extLst>
                <a:ext uri="{FF2B5EF4-FFF2-40B4-BE49-F238E27FC236}">
                  <a16:creationId xmlns:a16="http://schemas.microsoft.com/office/drawing/2014/main" id="{E22BE948-73CA-4E48-94FF-7FD92D3B6A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27457" y="3074829"/>
              <a:ext cx="163513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58">
              <a:extLst>
                <a:ext uri="{FF2B5EF4-FFF2-40B4-BE49-F238E27FC236}">
                  <a16:creationId xmlns:a16="http://schemas.microsoft.com/office/drawing/2014/main" id="{AFD43054-F3EF-4402-872C-B01CF180E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4088" y="2700819"/>
              <a:ext cx="59035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59">
              <a:extLst>
                <a:ext uri="{FF2B5EF4-FFF2-40B4-BE49-F238E27FC236}">
                  <a16:creationId xmlns:a16="http://schemas.microsoft.com/office/drawing/2014/main" id="{F74B44E9-6CDC-4A84-AA8F-18E0435506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8282" y="2976419"/>
              <a:ext cx="4129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Rectangle 72">
            <a:extLst>
              <a:ext uri="{FF2B5EF4-FFF2-40B4-BE49-F238E27FC236}">
                <a16:creationId xmlns:a16="http://schemas.microsoft.com/office/drawing/2014/main" id="{2E5ABD55-A56D-4B3B-899F-A6E98E95D6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6686" y="4246577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8C1DB7D-551C-BF09-3E2A-317F916D823A}"/>
              </a:ext>
            </a:extLst>
          </p:cNvPr>
          <p:cNvSpPr txBox="1"/>
          <p:nvPr/>
        </p:nvSpPr>
        <p:spPr>
          <a:xfrm>
            <a:off x="2139889" y="1363050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C956D20-7EDD-415A-B6AF-FA2307F80D5D}"/>
              </a:ext>
            </a:extLst>
          </p:cNvPr>
          <p:cNvSpPr txBox="1"/>
          <p:nvPr/>
        </p:nvSpPr>
        <p:spPr>
          <a:xfrm>
            <a:off x="321733" y="5350933"/>
            <a:ext cx="8356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. Prostate cancer specific survival rate (PCS), </a:t>
            </a:r>
            <a:r>
              <a:rPr lang="en-US" b="1" dirty="0"/>
              <a:t>a</a:t>
            </a:r>
            <a:r>
              <a:rPr lang="en-US" dirty="0"/>
              <a:t>) Comparison of PCS between EBRT and BT-boost in VHR-1 group. </a:t>
            </a:r>
            <a:r>
              <a:rPr lang="en-US" b="1" dirty="0"/>
              <a:t>b</a:t>
            </a:r>
            <a:r>
              <a:rPr lang="en-US" dirty="0"/>
              <a:t>) Comparison of PCS between EBRT and BT-boost in VHR-0 group. </a:t>
            </a:r>
            <a:r>
              <a:rPr lang="en-US" b="1" dirty="0"/>
              <a:t>c</a:t>
            </a:r>
            <a:r>
              <a:rPr lang="en-US" dirty="0"/>
              <a:t>) Comparison of PCS between EBRT and BT-boost in intermediate-risk group</a:t>
            </a:r>
          </a:p>
        </p:txBody>
      </p:sp>
    </p:spTree>
    <p:extLst>
      <p:ext uri="{BB962C8B-B14F-4D97-AF65-F5344CB8AC3E}">
        <p14:creationId xmlns:p14="http://schemas.microsoft.com/office/powerpoint/2010/main" val="14946076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534BDA5E-3729-415D-83E6-1E2E4334D577}"/>
              </a:ext>
            </a:extLst>
          </p:cNvPr>
          <p:cNvSpPr>
            <a:spLocks noChangeShapeType="1"/>
          </p:cNvSpPr>
          <p:nvPr/>
        </p:nvSpPr>
        <p:spPr bwMode="auto">
          <a:xfrm>
            <a:off x="2947623" y="4738687"/>
            <a:ext cx="27813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B24064F0-9DF4-4FF6-BB10-F5E976F65D8C}"/>
              </a:ext>
            </a:extLst>
          </p:cNvPr>
          <p:cNvSpPr>
            <a:spLocks noChangeShapeType="1"/>
          </p:cNvSpPr>
          <p:nvPr/>
        </p:nvSpPr>
        <p:spPr bwMode="auto">
          <a:xfrm>
            <a:off x="2947623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83B30DFF-5549-4A1A-8A79-AFD2BF7DDAA9}"/>
              </a:ext>
            </a:extLst>
          </p:cNvPr>
          <p:cNvSpPr>
            <a:spLocks noChangeShapeType="1"/>
          </p:cNvSpPr>
          <p:nvPr/>
        </p:nvSpPr>
        <p:spPr bwMode="auto">
          <a:xfrm>
            <a:off x="3407998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247CE1C1-A761-48C8-A5D7-FA0114C59003}"/>
              </a:ext>
            </a:extLst>
          </p:cNvPr>
          <p:cNvSpPr>
            <a:spLocks noChangeShapeType="1"/>
          </p:cNvSpPr>
          <p:nvPr/>
        </p:nvSpPr>
        <p:spPr bwMode="auto">
          <a:xfrm>
            <a:off x="3874723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AA07F598-2192-421E-B5C4-EBE19D810402}"/>
              </a:ext>
            </a:extLst>
          </p:cNvPr>
          <p:cNvSpPr>
            <a:spLocks noChangeShapeType="1"/>
          </p:cNvSpPr>
          <p:nvPr/>
        </p:nvSpPr>
        <p:spPr bwMode="auto">
          <a:xfrm>
            <a:off x="4335098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39592627-A623-48CD-8428-43B226F1692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01823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AD6A2EB1-3DC4-4510-AC34-75DA3369A308}"/>
              </a:ext>
            </a:extLst>
          </p:cNvPr>
          <p:cNvSpPr>
            <a:spLocks noChangeShapeType="1"/>
          </p:cNvSpPr>
          <p:nvPr/>
        </p:nvSpPr>
        <p:spPr bwMode="auto">
          <a:xfrm>
            <a:off x="5266961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2">
            <a:extLst>
              <a:ext uri="{FF2B5EF4-FFF2-40B4-BE49-F238E27FC236}">
                <a16:creationId xmlns:a16="http://schemas.microsoft.com/office/drawing/2014/main" id="{1FA841BC-E97E-4C17-9C82-D23819430CEE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8923" y="473868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AD06058-EB6F-4D32-B378-1B0324B901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01586" y="4860925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00F51B5-EB8F-471B-8646-7D7FF004CD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3386" y="4860925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B6B0175-7D1F-447C-9B17-E521AF6AB9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0111" y="4860925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402650E-C663-4479-9C92-A9C8D6685E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0486" y="4860925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317CAD5-FE35-4482-A117-0FD3666529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7211" y="4860925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E501FC7-42BD-4109-8935-E5687ECCC3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65361" y="486092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9252221-D020-4C5E-BBBD-8A30C0DB33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27323" y="486092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927D36B6-A10D-4C56-AF55-7780115B254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36498" y="2219325"/>
            <a:ext cx="0" cy="241935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0A4CF215-E7A5-496F-9251-504C5C6C406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77761" y="4638675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DEC9C001-39E2-4636-A180-754B0A12173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77761" y="4154487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A92F60B0-257C-4503-87F5-DBF162152BE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77761" y="3670300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E1003334-3E0C-4B7F-96E1-FCD728FF413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77761" y="3187700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5">
            <a:extLst>
              <a:ext uri="{FF2B5EF4-FFF2-40B4-BE49-F238E27FC236}">
                <a16:creationId xmlns:a16="http://schemas.microsoft.com/office/drawing/2014/main" id="{C83C15A3-96CE-4C91-A1FC-498A503D5C1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77761" y="2703512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6">
            <a:extLst>
              <a:ext uri="{FF2B5EF4-FFF2-40B4-BE49-F238E27FC236}">
                <a16:creationId xmlns:a16="http://schemas.microsoft.com/office/drawing/2014/main" id="{62B9F7C1-99F5-48FA-BE79-B3DFCD670AD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777761" y="2219325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C04CC4D-2CB6-489D-9A22-4B08726E49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04" y="4561239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D116924-41DF-46CF-8624-8C12761A18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04" y="4077052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292FBCA-D55C-400C-991A-94AE7D182A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04" y="3592864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70AAC1B-0FC0-4AC5-B84E-7D0E30E15F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04" y="3108677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D30742F-2574-42B3-A75E-39749D0CB0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04" y="2624489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FCFFC5CA-02E3-4C55-8438-691BC9A4B4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04" y="2141889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Freeform 33">
            <a:extLst>
              <a:ext uri="{FF2B5EF4-FFF2-40B4-BE49-F238E27FC236}">
                <a16:creationId xmlns:a16="http://schemas.microsoft.com/office/drawing/2014/main" id="{C5FCA329-0CC5-4C8A-9287-69FFD2677C67}"/>
              </a:ext>
            </a:extLst>
          </p:cNvPr>
          <p:cNvSpPr>
            <a:spLocks/>
          </p:cNvSpPr>
          <p:nvPr/>
        </p:nvSpPr>
        <p:spPr bwMode="auto">
          <a:xfrm>
            <a:off x="2836498" y="2119312"/>
            <a:ext cx="3001963" cy="2619375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9BDFF924-F572-481F-A0A9-F123F42FC48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869313" y="3368417"/>
            <a:ext cx="74263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reeform 37">
            <a:extLst>
              <a:ext uri="{FF2B5EF4-FFF2-40B4-BE49-F238E27FC236}">
                <a16:creationId xmlns:a16="http://schemas.microsoft.com/office/drawing/2014/main" id="{44DB2FF6-18E2-40E9-B43E-68952B20A031}"/>
              </a:ext>
            </a:extLst>
          </p:cNvPr>
          <p:cNvSpPr>
            <a:spLocks/>
          </p:cNvSpPr>
          <p:nvPr/>
        </p:nvSpPr>
        <p:spPr bwMode="auto">
          <a:xfrm>
            <a:off x="2947623" y="2219325"/>
            <a:ext cx="3124200" cy="309563"/>
          </a:xfrm>
          <a:custGeom>
            <a:avLst/>
            <a:gdLst>
              <a:gd name="T0" fmla="*/ 0 w 536"/>
              <a:gd name="T1" fmla="*/ 0 h 53"/>
              <a:gd name="T2" fmla="*/ 8 w 536"/>
              <a:gd name="T3" fmla="*/ 0 h 53"/>
              <a:gd name="T4" fmla="*/ 8 w 536"/>
              <a:gd name="T5" fmla="*/ 1 h 53"/>
              <a:gd name="T6" fmla="*/ 16 w 536"/>
              <a:gd name="T7" fmla="*/ 1 h 53"/>
              <a:gd name="T8" fmla="*/ 16 w 536"/>
              <a:gd name="T9" fmla="*/ 3 h 53"/>
              <a:gd name="T10" fmla="*/ 28 w 536"/>
              <a:gd name="T11" fmla="*/ 3 h 53"/>
              <a:gd name="T12" fmla="*/ 28 w 536"/>
              <a:gd name="T13" fmla="*/ 4 h 53"/>
              <a:gd name="T14" fmla="*/ 43 w 536"/>
              <a:gd name="T15" fmla="*/ 4 h 53"/>
              <a:gd name="T16" fmla="*/ 43 w 536"/>
              <a:gd name="T17" fmla="*/ 5 h 53"/>
              <a:gd name="T18" fmla="*/ 51 w 536"/>
              <a:gd name="T19" fmla="*/ 5 h 53"/>
              <a:gd name="T20" fmla="*/ 51 w 536"/>
              <a:gd name="T21" fmla="*/ 7 h 53"/>
              <a:gd name="T22" fmla="*/ 59 w 536"/>
              <a:gd name="T23" fmla="*/ 7 h 53"/>
              <a:gd name="T24" fmla="*/ 59 w 536"/>
              <a:gd name="T25" fmla="*/ 8 h 53"/>
              <a:gd name="T26" fmla="*/ 67 w 536"/>
              <a:gd name="T27" fmla="*/ 8 h 53"/>
              <a:gd name="T28" fmla="*/ 67 w 536"/>
              <a:gd name="T29" fmla="*/ 10 h 53"/>
              <a:gd name="T30" fmla="*/ 75 w 536"/>
              <a:gd name="T31" fmla="*/ 10 h 53"/>
              <a:gd name="T32" fmla="*/ 75 w 536"/>
              <a:gd name="T33" fmla="*/ 11 h 53"/>
              <a:gd name="T34" fmla="*/ 83 w 536"/>
              <a:gd name="T35" fmla="*/ 11 h 53"/>
              <a:gd name="T36" fmla="*/ 83 w 536"/>
              <a:gd name="T37" fmla="*/ 12 h 53"/>
              <a:gd name="T38" fmla="*/ 115 w 536"/>
              <a:gd name="T39" fmla="*/ 12 h 53"/>
              <a:gd name="T40" fmla="*/ 115 w 536"/>
              <a:gd name="T41" fmla="*/ 14 h 53"/>
              <a:gd name="T42" fmla="*/ 127 w 536"/>
              <a:gd name="T43" fmla="*/ 14 h 53"/>
              <a:gd name="T44" fmla="*/ 127 w 536"/>
              <a:gd name="T45" fmla="*/ 16 h 53"/>
              <a:gd name="T46" fmla="*/ 167 w 536"/>
              <a:gd name="T47" fmla="*/ 16 h 53"/>
              <a:gd name="T48" fmla="*/ 167 w 536"/>
              <a:gd name="T49" fmla="*/ 18 h 53"/>
              <a:gd name="T50" fmla="*/ 187 w 536"/>
              <a:gd name="T51" fmla="*/ 18 h 53"/>
              <a:gd name="T52" fmla="*/ 187 w 536"/>
              <a:gd name="T53" fmla="*/ 20 h 53"/>
              <a:gd name="T54" fmla="*/ 207 w 536"/>
              <a:gd name="T55" fmla="*/ 20 h 53"/>
              <a:gd name="T56" fmla="*/ 207 w 536"/>
              <a:gd name="T57" fmla="*/ 22 h 53"/>
              <a:gd name="T58" fmla="*/ 226 w 536"/>
              <a:gd name="T59" fmla="*/ 22 h 53"/>
              <a:gd name="T60" fmla="*/ 226 w 536"/>
              <a:gd name="T61" fmla="*/ 26 h 53"/>
              <a:gd name="T62" fmla="*/ 246 w 536"/>
              <a:gd name="T63" fmla="*/ 26 h 53"/>
              <a:gd name="T64" fmla="*/ 246 w 536"/>
              <a:gd name="T65" fmla="*/ 32 h 53"/>
              <a:gd name="T66" fmla="*/ 417 w 536"/>
              <a:gd name="T67" fmla="*/ 32 h 53"/>
              <a:gd name="T68" fmla="*/ 417 w 536"/>
              <a:gd name="T69" fmla="*/ 41 h 53"/>
              <a:gd name="T70" fmla="*/ 441 w 536"/>
              <a:gd name="T71" fmla="*/ 41 h 53"/>
              <a:gd name="T72" fmla="*/ 441 w 536"/>
              <a:gd name="T73" fmla="*/ 53 h 53"/>
              <a:gd name="T74" fmla="*/ 536 w 536"/>
              <a:gd name="T75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</a:cxnLst>
            <a:rect l="0" t="0" r="r" b="b"/>
            <a:pathLst>
              <a:path w="536" h="53">
                <a:moveTo>
                  <a:pt x="0" y="0"/>
                </a:moveTo>
                <a:lnTo>
                  <a:pt x="8" y="0"/>
                </a:lnTo>
                <a:lnTo>
                  <a:pt x="8" y="1"/>
                </a:lnTo>
                <a:lnTo>
                  <a:pt x="16" y="1"/>
                </a:lnTo>
                <a:lnTo>
                  <a:pt x="16" y="3"/>
                </a:lnTo>
                <a:lnTo>
                  <a:pt x="28" y="3"/>
                </a:lnTo>
                <a:lnTo>
                  <a:pt x="28" y="4"/>
                </a:lnTo>
                <a:lnTo>
                  <a:pt x="43" y="4"/>
                </a:lnTo>
                <a:lnTo>
                  <a:pt x="43" y="5"/>
                </a:lnTo>
                <a:lnTo>
                  <a:pt x="51" y="5"/>
                </a:lnTo>
                <a:lnTo>
                  <a:pt x="51" y="7"/>
                </a:lnTo>
                <a:lnTo>
                  <a:pt x="59" y="7"/>
                </a:lnTo>
                <a:lnTo>
                  <a:pt x="59" y="8"/>
                </a:lnTo>
                <a:lnTo>
                  <a:pt x="67" y="8"/>
                </a:lnTo>
                <a:lnTo>
                  <a:pt x="67" y="10"/>
                </a:lnTo>
                <a:lnTo>
                  <a:pt x="75" y="10"/>
                </a:lnTo>
                <a:lnTo>
                  <a:pt x="75" y="11"/>
                </a:lnTo>
                <a:lnTo>
                  <a:pt x="83" y="11"/>
                </a:lnTo>
                <a:lnTo>
                  <a:pt x="83" y="12"/>
                </a:lnTo>
                <a:lnTo>
                  <a:pt x="115" y="12"/>
                </a:lnTo>
                <a:lnTo>
                  <a:pt x="115" y="14"/>
                </a:lnTo>
                <a:lnTo>
                  <a:pt x="127" y="14"/>
                </a:lnTo>
                <a:lnTo>
                  <a:pt x="127" y="16"/>
                </a:lnTo>
                <a:lnTo>
                  <a:pt x="167" y="16"/>
                </a:lnTo>
                <a:lnTo>
                  <a:pt x="167" y="18"/>
                </a:lnTo>
                <a:lnTo>
                  <a:pt x="187" y="18"/>
                </a:lnTo>
                <a:lnTo>
                  <a:pt x="187" y="20"/>
                </a:lnTo>
                <a:lnTo>
                  <a:pt x="207" y="20"/>
                </a:lnTo>
                <a:lnTo>
                  <a:pt x="207" y="22"/>
                </a:lnTo>
                <a:lnTo>
                  <a:pt x="226" y="22"/>
                </a:lnTo>
                <a:lnTo>
                  <a:pt x="226" y="26"/>
                </a:lnTo>
                <a:lnTo>
                  <a:pt x="246" y="26"/>
                </a:lnTo>
                <a:lnTo>
                  <a:pt x="246" y="32"/>
                </a:lnTo>
                <a:lnTo>
                  <a:pt x="417" y="32"/>
                </a:lnTo>
                <a:lnTo>
                  <a:pt x="417" y="41"/>
                </a:lnTo>
                <a:lnTo>
                  <a:pt x="441" y="41"/>
                </a:lnTo>
                <a:lnTo>
                  <a:pt x="441" y="53"/>
                </a:lnTo>
                <a:lnTo>
                  <a:pt x="536" y="53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Freeform 38">
            <a:extLst>
              <a:ext uri="{FF2B5EF4-FFF2-40B4-BE49-F238E27FC236}">
                <a16:creationId xmlns:a16="http://schemas.microsoft.com/office/drawing/2014/main" id="{31A2073D-C0BF-4770-A1B1-F6C457A8C427}"/>
              </a:ext>
            </a:extLst>
          </p:cNvPr>
          <p:cNvSpPr>
            <a:spLocks/>
          </p:cNvSpPr>
          <p:nvPr/>
        </p:nvSpPr>
        <p:spPr bwMode="auto">
          <a:xfrm>
            <a:off x="2947623" y="2219325"/>
            <a:ext cx="3124200" cy="349250"/>
          </a:xfrm>
          <a:custGeom>
            <a:avLst/>
            <a:gdLst>
              <a:gd name="T0" fmla="*/ 0 w 536"/>
              <a:gd name="T1" fmla="*/ 0 h 60"/>
              <a:gd name="T2" fmla="*/ 167 w 536"/>
              <a:gd name="T3" fmla="*/ 0 h 60"/>
              <a:gd name="T4" fmla="*/ 167 w 536"/>
              <a:gd name="T5" fmla="*/ 2 h 60"/>
              <a:gd name="T6" fmla="*/ 205 w 536"/>
              <a:gd name="T7" fmla="*/ 2 h 60"/>
              <a:gd name="T8" fmla="*/ 205 w 536"/>
              <a:gd name="T9" fmla="*/ 5 h 60"/>
              <a:gd name="T10" fmla="*/ 257 w 536"/>
              <a:gd name="T11" fmla="*/ 5 h 60"/>
              <a:gd name="T12" fmla="*/ 257 w 536"/>
              <a:gd name="T13" fmla="*/ 8 h 60"/>
              <a:gd name="T14" fmla="*/ 274 w 536"/>
              <a:gd name="T15" fmla="*/ 8 h 60"/>
              <a:gd name="T16" fmla="*/ 274 w 536"/>
              <a:gd name="T17" fmla="*/ 11 h 60"/>
              <a:gd name="T18" fmla="*/ 282 w 536"/>
              <a:gd name="T19" fmla="*/ 11 h 60"/>
              <a:gd name="T20" fmla="*/ 282 w 536"/>
              <a:gd name="T21" fmla="*/ 15 h 60"/>
              <a:gd name="T22" fmla="*/ 285 w 536"/>
              <a:gd name="T23" fmla="*/ 15 h 60"/>
              <a:gd name="T24" fmla="*/ 285 w 536"/>
              <a:gd name="T25" fmla="*/ 18 h 60"/>
              <a:gd name="T26" fmla="*/ 306 w 536"/>
              <a:gd name="T27" fmla="*/ 18 h 60"/>
              <a:gd name="T28" fmla="*/ 306 w 536"/>
              <a:gd name="T29" fmla="*/ 23 h 60"/>
              <a:gd name="T30" fmla="*/ 322 w 536"/>
              <a:gd name="T31" fmla="*/ 23 h 60"/>
              <a:gd name="T32" fmla="*/ 322 w 536"/>
              <a:gd name="T33" fmla="*/ 27 h 60"/>
              <a:gd name="T34" fmla="*/ 350 w 536"/>
              <a:gd name="T35" fmla="*/ 27 h 60"/>
              <a:gd name="T36" fmla="*/ 350 w 536"/>
              <a:gd name="T37" fmla="*/ 34 h 60"/>
              <a:gd name="T38" fmla="*/ 364 w 536"/>
              <a:gd name="T39" fmla="*/ 34 h 60"/>
              <a:gd name="T40" fmla="*/ 364 w 536"/>
              <a:gd name="T41" fmla="*/ 42 h 60"/>
              <a:gd name="T42" fmla="*/ 479 w 536"/>
              <a:gd name="T43" fmla="*/ 42 h 60"/>
              <a:gd name="T44" fmla="*/ 479 w 536"/>
              <a:gd name="T45" fmla="*/ 60 h 60"/>
              <a:gd name="T46" fmla="*/ 536 w 536"/>
              <a:gd name="T47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</a:cxnLst>
            <a:rect l="0" t="0" r="r" b="b"/>
            <a:pathLst>
              <a:path w="536" h="60">
                <a:moveTo>
                  <a:pt x="0" y="0"/>
                </a:moveTo>
                <a:lnTo>
                  <a:pt x="167" y="0"/>
                </a:lnTo>
                <a:lnTo>
                  <a:pt x="167" y="2"/>
                </a:lnTo>
                <a:lnTo>
                  <a:pt x="205" y="2"/>
                </a:lnTo>
                <a:lnTo>
                  <a:pt x="205" y="5"/>
                </a:lnTo>
                <a:lnTo>
                  <a:pt x="257" y="5"/>
                </a:lnTo>
                <a:lnTo>
                  <a:pt x="257" y="8"/>
                </a:lnTo>
                <a:lnTo>
                  <a:pt x="274" y="8"/>
                </a:lnTo>
                <a:lnTo>
                  <a:pt x="274" y="11"/>
                </a:lnTo>
                <a:lnTo>
                  <a:pt x="282" y="11"/>
                </a:lnTo>
                <a:lnTo>
                  <a:pt x="282" y="15"/>
                </a:lnTo>
                <a:lnTo>
                  <a:pt x="285" y="15"/>
                </a:lnTo>
                <a:lnTo>
                  <a:pt x="285" y="18"/>
                </a:lnTo>
                <a:lnTo>
                  <a:pt x="306" y="18"/>
                </a:lnTo>
                <a:lnTo>
                  <a:pt x="306" y="23"/>
                </a:lnTo>
                <a:lnTo>
                  <a:pt x="322" y="23"/>
                </a:lnTo>
                <a:lnTo>
                  <a:pt x="322" y="27"/>
                </a:lnTo>
                <a:lnTo>
                  <a:pt x="350" y="27"/>
                </a:lnTo>
                <a:lnTo>
                  <a:pt x="350" y="34"/>
                </a:lnTo>
                <a:lnTo>
                  <a:pt x="364" y="34"/>
                </a:lnTo>
                <a:lnTo>
                  <a:pt x="364" y="42"/>
                </a:lnTo>
                <a:lnTo>
                  <a:pt x="479" y="42"/>
                </a:lnTo>
                <a:lnTo>
                  <a:pt x="479" y="60"/>
                </a:lnTo>
                <a:lnTo>
                  <a:pt x="536" y="60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A1805D5D-C0C7-4F3C-A2CE-B642AE6498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6023" y="5159189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9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0B7AEBE4-1286-47CC-AEE7-2F721704E6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6398" y="5159189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87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CE1C9DD2-6B54-419A-B09A-EE0877D4CB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3123" y="5159189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1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0B3474D6-01B2-4B69-B767-6BE3F76DA8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3498" y="5159189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6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382E4D35-ABE5-4F88-B404-114EA85059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7211" y="5159189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3B498CE-4BED-42D4-85C3-F050083736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2348" y="5159189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E38765A-0670-46BF-AA25-9136BF6AD1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4311" y="5159189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AF45B90B-4D12-478E-A70E-98A92622C3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6023" y="5421312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2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127B4D8A-341C-4429-8FF7-A1CDB783BB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6398" y="5421312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19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8F562E4-2308-46F8-B475-F550084255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3123" y="5421312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43AB82D-9F94-42FB-8067-E44484429A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3498" y="5421312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5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5D84A3A4-8714-4DC2-8725-10B6E0F585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7211" y="54213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AD42B92F-7C46-4D3A-B05E-271758D7A2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2348" y="54213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7D90E91C-828E-4911-8F24-17C53B52FF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4311" y="54213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DFED82A9-D083-404F-9D70-677039FBF1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9299" y="5150200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E440FAA9-EB0B-4F38-9A19-5D3A9E537C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8504" y="5421312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55">
            <a:extLst>
              <a:ext uri="{FF2B5EF4-FFF2-40B4-BE49-F238E27FC236}">
                <a16:creationId xmlns:a16="http://schemas.microsoft.com/office/drawing/2014/main" id="{52DD9252-EC61-44AE-B3EF-47A37401F391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6273" y="3217882"/>
            <a:ext cx="16351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6">
            <a:extLst>
              <a:ext uri="{FF2B5EF4-FFF2-40B4-BE49-F238E27FC236}">
                <a16:creationId xmlns:a16="http://schemas.microsoft.com/office/drawing/2014/main" id="{67FFCCCB-8FC2-4C4D-97AF-FC50A2548CE4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6273" y="3423890"/>
            <a:ext cx="163513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58">
            <a:extLst>
              <a:ext uri="{FF2B5EF4-FFF2-40B4-BE49-F238E27FC236}">
                <a16:creationId xmlns:a16="http://schemas.microsoft.com/office/drawing/2014/main" id="{8898A92D-AA04-4CDC-ABF6-DEC489ECC1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9134" y="3088426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59">
            <a:extLst>
              <a:ext uri="{FF2B5EF4-FFF2-40B4-BE49-F238E27FC236}">
                <a16:creationId xmlns:a16="http://schemas.microsoft.com/office/drawing/2014/main" id="{9A82177E-3338-4018-9573-644CAB452B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7098" y="3325480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35">
            <a:extLst>
              <a:ext uri="{FF2B5EF4-FFF2-40B4-BE49-F238E27FC236}">
                <a16:creationId xmlns:a16="http://schemas.microsoft.com/office/drawing/2014/main" id="{F54E7903-0032-48FC-A844-29EEA815DA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6068" y="4431783"/>
            <a:ext cx="4857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9FD0FDA5-13DB-431C-A31C-5BF91C73C111}"/>
              </a:ext>
            </a:extLst>
          </p:cNvPr>
          <p:cNvSpPr txBox="1"/>
          <p:nvPr/>
        </p:nvSpPr>
        <p:spPr>
          <a:xfrm>
            <a:off x="3306939" y="3425586"/>
            <a:ext cx="11360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7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72">
            <a:extLst>
              <a:ext uri="{FF2B5EF4-FFF2-40B4-BE49-F238E27FC236}">
                <a16:creationId xmlns:a16="http://schemas.microsoft.com/office/drawing/2014/main" id="{A0E4A5B6-30DB-4C66-BAA3-8E091EF215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55128" y="4853735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B958BD9-1F5D-1B33-EFBD-54F6202974B0}"/>
              </a:ext>
            </a:extLst>
          </p:cNvPr>
          <p:cNvSpPr txBox="1"/>
          <p:nvPr/>
        </p:nvSpPr>
        <p:spPr>
          <a:xfrm>
            <a:off x="1817296" y="1680224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68994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186FE2C8-25B6-40B8-9B54-E17735E1B711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9539" y="4554056"/>
            <a:ext cx="27813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877DE7A5-0F69-4880-B890-D240C0073BF4}"/>
              </a:ext>
            </a:extLst>
          </p:cNvPr>
          <p:cNvSpPr>
            <a:spLocks noChangeShapeType="1"/>
          </p:cNvSpPr>
          <p:nvPr/>
        </p:nvSpPr>
        <p:spPr bwMode="auto">
          <a:xfrm>
            <a:off x="2859539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11B50CF4-AAC6-482D-8C89-B1F5AED6F597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9914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62457D32-5617-4588-A30A-4EB07CCE5B5C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6639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6F6B4090-5230-4332-B37B-6CEB57512F87}"/>
              </a:ext>
            </a:extLst>
          </p:cNvPr>
          <p:cNvSpPr>
            <a:spLocks noChangeShapeType="1"/>
          </p:cNvSpPr>
          <p:nvPr/>
        </p:nvSpPr>
        <p:spPr bwMode="auto">
          <a:xfrm>
            <a:off x="4247014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0173B6CB-2916-489E-8911-4B800520CD2D}"/>
              </a:ext>
            </a:extLst>
          </p:cNvPr>
          <p:cNvSpPr>
            <a:spLocks noChangeShapeType="1"/>
          </p:cNvSpPr>
          <p:nvPr/>
        </p:nvSpPr>
        <p:spPr bwMode="auto">
          <a:xfrm>
            <a:off x="4713739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01474185-6151-4BAD-961E-C152E14EFFED}"/>
              </a:ext>
            </a:extLst>
          </p:cNvPr>
          <p:cNvSpPr>
            <a:spLocks noChangeShapeType="1"/>
          </p:cNvSpPr>
          <p:nvPr/>
        </p:nvSpPr>
        <p:spPr bwMode="auto">
          <a:xfrm>
            <a:off x="5178877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2">
            <a:extLst>
              <a:ext uri="{FF2B5EF4-FFF2-40B4-BE49-F238E27FC236}">
                <a16:creationId xmlns:a16="http://schemas.microsoft.com/office/drawing/2014/main" id="{BBF2B8D2-59A4-4C96-8105-29A6A87CCC37}"/>
              </a:ext>
            </a:extLst>
          </p:cNvPr>
          <p:cNvSpPr>
            <a:spLocks noChangeShapeType="1"/>
          </p:cNvSpPr>
          <p:nvPr/>
        </p:nvSpPr>
        <p:spPr bwMode="auto">
          <a:xfrm>
            <a:off x="5640839" y="4554056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A677990-FAF3-4147-9555-5BB9C50651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13502" y="4676294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EB7C48C-D3F9-4BD4-A7E9-E48A1C1DEB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302" y="4676294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E6246EF-C791-4FC5-839C-99CD36FA01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2027" y="4676294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53C91DE-1307-4B0B-BBB5-DE3B5D89DA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2402" y="4676294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671219D-6546-4D8E-B48A-EA98E1D1D5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9127" y="4676294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2F3C5DD-FC25-4135-8496-82DBBF48D0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7277" y="467629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EDC8885-D268-434F-AA10-01EF49F158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9239" y="4676294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624F1065-35CE-42AF-94ED-A62938DE5B8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48414" y="2034694"/>
            <a:ext cx="0" cy="241935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DC350BE7-891E-4829-8910-69DD72D56C2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9677" y="4454044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60D02C22-52D0-4C79-8FA1-A93EF44F227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9677" y="3969856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811E5EAE-5495-42E2-9534-86E189F9C6A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9677" y="3485669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E132150A-95F1-4F09-B6AC-CA9F754CD96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9677" y="3003069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5">
            <a:extLst>
              <a:ext uri="{FF2B5EF4-FFF2-40B4-BE49-F238E27FC236}">
                <a16:creationId xmlns:a16="http://schemas.microsoft.com/office/drawing/2014/main" id="{F6AE64B1-0B85-4BE8-9ED0-CB7222DDE27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9677" y="2518881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6">
            <a:extLst>
              <a:ext uri="{FF2B5EF4-FFF2-40B4-BE49-F238E27FC236}">
                <a16:creationId xmlns:a16="http://schemas.microsoft.com/office/drawing/2014/main" id="{72B43AA2-642D-4A81-8FB4-FF039AFC79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89677" y="2034694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55A577A6-97E2-416A-9401-DD0D885068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6314" y="4389192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2377A55-2D8B-4CB9-A020-FB8E94D2BB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6314" y="3905005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A3FDC88-38AD-4979-B3B4-643B0E1360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6314" y="3420817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7F8FE24-9CEE-43EC-9E1A-BE4ECF780E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6314" y="2936630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FD04E3B-BFCE-4CA2-882C-6F5FA844C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6314" y="2452442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A1D5339C-64E8-4C3A-A713-083219A464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6314" y="1969842"/>
            <a:ext cx="192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Freeform 33">
            <a:extLst>
              <a:ext uri="{FF2B5EF4-FFF2-40B4-BE49-F238E27FC236}">
                <a16:creationId xmlns:a16="http://schemas.microsoft.com/office/drawing/2014/main" id="{758A72AA-70B2-48A4-A41C-F3FF2731E042}"/>
              </a:ext>
            </a:extLst>
          </p:cNvPr>
          <p:cNvSpPr>
            <a:spLocks/>
          </p:cNvSpPr>
          <p:nvPr/>
        </p:nvSpPr>
        <p:spPr bwMode="auto">
          <a:xfrm>
            <a:off x="2748414" y="1934681"/>
            <a:ext cx="3001963" cy="2619375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8E56545-7B20-4C56-B905-51390A6A32E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656291" y="2952331"/>
            <a:ext cx="74263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reeform 37">
            <a:extLst>
              <a:ext uri="{FF2B5EF4-FFF2-40B4-BE49-F238E27FC236}">
                <a16:creationId xmlns:a16="http://schemas.microsoft.com/office/drawing/2014/main" id="{B61B7617-DD4D-4DA9-A7C7-1E847AA47116}"/>
              </a:ext>
            </a:extLst>
          </p:cNvPr>
          <p:cNvSpPr>
            <a:spLocks/>
          </p:cNvSpPr>
          <p:nvPr/>
        </p:nvSpPr>
        <p:spPr bwMode="auto">
          <a:xfrm>
            <a:off x="2859539" y="2034694"/>
            <a:ext cx="3124200" cy="233363"/>
          </a:xfrm>
          <a:custGeom>
            <a:avLst/>
            <a:gdLst>
              <a:gd name="T0" fmla="*/ 0 w 536"/>
              <a:gd name="T1" fmla="*/ 0 h 40"/>
              <a:gd name="T2" fmla="*/ 67 w 536"/>
              <a:gd name="T3" fmla="*/ 0 h 40"/>
              <a:gd name="T4" fmla="*/ 67 w 536"/>
              <a:gd name="T5" fmla="*/ 1 h 40"/>
              <a:gd name="T6" fmla="*/ 71 w 536"/>
              <a:gd name="T7" fmla="*/ 1 h 40"/>
              <a:gd name="T8" fmla="*/ 71 w 536"/>
              <a:gd name="T9" fmla="*/ 2 h 40"/>
              <a:gd name="T10" fmla="*/ 95 w 536"/>
              <a:gd name="T11" fmla="*/ 2 h 40"/>
              <a:gd name="T12" fmla="*/ 95 w 536"/>
              <a:gd name="T13" fmla="*/ 3 h 40"/>
              <a:gd name="T14" fmla="*/ 147 w 536"/>
              <a:gd name="T15" fmla="*/ 3 h 40"/>
              <a:gd name="T16" fmla="*/ 147 w 536"/>
              <a:gd name="T17" fmla="*/ 4 h 40"/>
              <a:gd name="T18" fmla="*/ 171 w 536"/>
              <a:gd name="T19" fmla="*/ 4 h 40"/>
              <a:gd name="T20" fmla="*/ 171 w 536"/>
              <a:gd name="T21" fmla="*/ 5 h 40"/>
              <a:gd name="T22" fmla="*/ 215 w 536"/>
              <a:gd name="T23" fmla="*/ 5 h 40"/>
              <a:gd name="T24" fmla="*/ 215 w 536"/>
              <a:gd name="T25" fmla="*/ 6 h 40"/>
              <a:gd name="T26" fmla="*/ 222 w 536"/>
              <a:gd name="T27" fmla="*/ 6 h 40"/>
              <a:gd name="T28" fmla="*/ 222 w 536"/>
              <a:gd name="T29" fmla="*/ 7 h 40"/>
              <a:gd name="T30" fmla="*/ 226 w 536"/>
              <a:gd name="T31" fmla="*/ 7 h 40"/>
              <a:gd name="T32" fmla="*/ 226 w 536"/>
              <a:gd name="T33" fmla="*/ 8 h 40"/>
              <a:gd name="T34" fmla="*/ 238 w 536"/>
              <a:gd name="T35" fmla="*/ 8 h 40"/>
              <a:gd name="T36" fmla="*/ 238 w 536"/>
              <a:gd name="T37" fmla="*/ 10 h 40"/>
              <a:gd name="T38" fmla="*/ 254 w 536"/>
              <a:gd name="T39" fmla="*/ 10 h 40"/>
              <a:gd name="T40" fmla="*/ 254 w 536"/>
              <a:gd name="T41" fmla="*/ 11 h 40"/>
              <a:gd name="T42" fmla="*/ 314 w 536"/>
              <a:gd name="T43" fmla="*/ 11 h 40"/>
              <a:gd name="T44" fmla="*/ 314 w 536"/>
              <a:gd name="T45" fmla="*/ 15 h 40"/>
              <a:gd name="T46" fmla="*/ 318 w 536"/>
              <a:gd name="T47" fmla="*/ 15 h 40"/>
              <a:gd name="T48" fmla="*/ 318 w 536"/>
              <a:gd name="T49" fmla="*/ 17 h 40"/>
              <a:gd name="T50" fmla="*/ 358 w 536"/>
              <a:gd name="T51" fmla="*/ 17 h 40"/>
              <a:gd name="T52" fmla="*/ 358 w 536"/>
              <a:gd name="T53" fmla="*/ 20 h 40"/>
              <a:gd name="T54" fmla="*/ 394 w 536"/>
              <a:gd name="T55" fmla="*/ 20 h 40"/>
              <a:gd name="T56" fmla="*/ 394 w 536"/>
              <a:gd name="T57" fmla="*/ 24 h 40"/>
              <a:gd name="T58" fmla="*/ 398 w 536"/>
              <a:gd name="T59" fmla="*/ 24 h 40"/>
              <a:gd name="T60" fmla="*/ 398 w 536"/>
              <a:gd name="T61" fmla="*/ 27 h 40"/>
              <a:gd name="T62" fmla="*/ 402 w 536"/>
              <a:gd name="T63" fmla="*/ 27 h 40"/>
              <a:gd name="T64" fmla="*/ 402 w 536"/>
              <a:gd name="T65" fmla="*/ 31 h 40"/>
              <a:gd name="T66" fmla="*/ 425 w 536"/>
              <a:gd name="T67" fmla="*/ 31 h 40"/>
              <a:gd name="T68" fmla="*/ 425 w 536"/>
              <a:gd name="T69" fmla="*/ 35 h 40"/>
              <a:gd name="T70" fmla="*/ 437 w 536"/>
              <a:gd name="T71" fmla="*/ 35 h 40"/>
              <a:gd name="T72" fmla="*/ 437 w 536"/>
              <a:gd name="T73" fmla="*/ 40 h 40"/>
              <a:gd name="T74" fmla="*/ 536 w 536"/>
              <a:gd name="T75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</a:cxnLst>
            <a:rect l="0" t="0" r="r" b="b"/>
            <a:pathLst>
              <a:path w="536" h="40">
                <a:moveTo>
                  <a:pt x="0" y="0"/>
                </a:moveTo>
                <a:lnTo>
                  <a:pt x="67" y="0"/>
                </a:lnTo>
                <a:lnTo>
                  <a:pt x="67" y="1"/>
                </a:lnTo>
                <a:lnTo>
                  <a:pt x="71" y="1"/>
                </a:lnTo>
                <a:lnTo>
                  <a:pt x="71" y="2"/>
                </a:lnTo>
                <a:lnTo>
                  <a:pt x="95" y="2"/>
                </a:lnTo>
                <a:lnTo>
                  <a:pt x="95" y="3"/>
                </a:lnTo>
                <a:lnTo>
                  <a:pt x="147" y="3"/>
                </a:lnTo>
                <a:lnTo>
                  <a:pt x="147" y="4"/>
                </a:lnTo>
                <a:lnTo>
                  <a:pt x="171" y="4"/>
                </a:lnTo>
                <a:lnTo>
                  <a:pt x="171" y="5"/>
                </a:lnTo>
                <a:lnTo>
                  <a:pt x="215" y="5"/>
                </a:lnTo>
                <a:lnTo>
                  <a:pt x="215" y="6"/>
                </a:lnTo>
                <a:lnTo>
                  <a:pt x="222" y="6"/>
                </a:lnTo>
                <a:lnTo>
                  <a:pt x="222" y="7"/>
                </a:lnTo>
                <a:lnTo>
                  <a:pt x="226" y="7"/>
                </a:lnTo>
                <a:lnTo>
                  <a:pt x="226" y="8"/>
                </a:lnTo>
                <a:lnTo>
                  <a:pt x="238" y="8"/>
                </a:lnTo>
                <a:lnTo>
                  <a:pt x="238" y="10"/>
                </a:lnTo>
                <a:lnTo>
                  <a:pt x="254" y="10"/>
                </a:lnTo>
                <a:lnTo>
                  <a:pt x="254" y="11"/>
                </a:lnTo>
                <a:lnTo>
                  <a:pt x="314" y="11"/>
                </a:lnTo>
                <a:lnTo>
                  <a:pt x="314" y="15"/>
                </a:lnTo>
                <a:lnTo>
                  <a:pt x="318" y="15"/>
                </a:lnTo>
                <a:lnTo>
                  <a:pt x="318" y="17"/>
                </a:lnTo>
                <a:lnTo>
                  <a:pt x="358" y="17"/>
                </a:lnTo>
                <a:lnTo>
                  <a:pt x="358" y="20"/>
                </a:lnTo>
                <a:lnTo>
                  <a:pt x="394" y="20"/>
                </a:lnTo>
                <a:lnTo>
                  <a:pt x="394" y="24"/>
                </a:lnTo>
                <a:lnTo>
                  <a:pt x="398" y="24"/>
                </a:lnTo>
                <a:lnTo>
                  <a:pt x="398" y="27"/>
                </a:lnTo>
                <a:lnTo>
                  <a:pt x="402" y="27"/>
                </a:lnTo>
                <a:lnTo>
                  <a:pt x="402" y="31"/>
                </a:lnTo>
                <a:lnTo>
                  <a:pt x="425" y="31"/>
                </a:lnTo>
                <a:lnTo>
                  <a:pt x="425" y="35"/>
                </a:lnTo>
                <a:lnTo>
                  <a:pt x="437" y="35"/>
                </a:lnTo>
                <a:lnTo>
                  <a:pt x="437" y="40"/>
                </a:lnTo>
                <a:lnTo>
                  <a:pt x="536" y="40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Freeform 38">
            <a:extLst>
              <a:ext uri="{FF2B5EF4-FFF2-40B4-BE49-F238E27FC236}">
                <a16:creationId xmlns:a16="http://schemas.microsoft.com/office/drawing/2014/main" id="{F93E9231-16CA-4918-83B5-9416271D3CEA}"/>
              </a:ext>
            </a:extLst>
          </p:cNvPr>
          <p:cNvSpPr>
            <a:spLocks/>
          </p:cNvSpPr>
          <p:nvPr/>
        </p:nvSpPr>
        <p:spPr bwMode="auto">
          <a:xfrm>
            <a:off x="2859539" y="2034694"/>
            <a:ext cx="3124200" cy="52388"/>
          </a:xfrm>
          <a:custGeom>
            <a:avLst/>
            <a:gdLst>
              <a:gd name="T0" fmla="*/ 0 w 536"/>
              <a:gd name="T1" fmla="*/ 0 h 9"/>
              <a:gd name="T2" fmla="*/ 36 w 536"/>
              <a:gd name="T3" fmla="*/ 0 h 9"/>
              <a:gd name="T4" fmla="*/ 36 w 536"/>
              <a:gd name="T5" fmla="*/ 1 h 9"/>
              <a:gd name="T6" fmla="*/ 62 w 536"/>
              <a:gd name="T7" fmla="*/ 1 h 9"/>
              <a:gd name="T8" fmla="*/ 62 w 536"/>
              <a:gd name="T9" fmla="*/ 3 h 9"/>
              <a:gd name="T10" fmla="*/ 142 w 536"/>
              <a:gd name="T11" fmla="*/ 3 h 9"/>
              <a:gd name="T12" fmla="*/ 142 w 536"/>
              <a:gd name="T13" fmla="*/ 5 h 9"/>
              <a:gd name="T14" fmla="*/ 205 w 536"/>
              <a:gd name="T15" fmla="*/ 5 h 9"/>
              <a:gd name="T16" fmla="*/ 205 w 536"/>
              <a:gd name="T17" fmla="*/ 7 h 9"/>
              <a:gd name="T18" fmla="*/ 222 w 536"/>
              <a:gd name="T19" fmla="*/ 7 h 9"/>
              <a:gd name="T20" fmla="*/ 222 w 536"/>
              <a:gd name="T21" fmla="*/ 9 h 9"/>
              <a:gd name="T22" fmla="*/ 536 w 536"/>
              <a:gd name="T23" fmla="*/ 9 h 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536" h="9">
                <a:moveTo>
                  <a:pt x="0" y="0"/>
                </a:moveTo>
                <a:lnTo>
                  <a:pt x="36" y="0"/>
                </a:lnTo>
                <a:lnTo>
                  <a:pt x="36" y="1"/>
                </a:lnTo>
                <a:lnTo>
                  <a:pt x="62" y="1"/>
                </a:lnTo>
                <a:lnTo>
                  <a:pt x="62" y="3"/>
                </a:lnTo>
                <a:lnTo>
                  <a:pt x="142" y="3"/>
                </a:lnTo>
                <a:lnTo>
                  <a:pt x="142" y="5"/>
                </a:lnTo>
                <a:lnTo>
                  <a:pt x="205" y="5"/>
                </a:lnTo>
                <a:lnTo>
                  <a:pt x="205" y="7"/>
                </a:lnTo>
                <a:lnTo>
                  <a:pt x="222" y="7"/>
                </a:lnTo>
                <a:lnTo>
                  <a:pt x="222" y="9"/>
                </a:lnTo>
                <a:lnTo>
                  <a:pt x="536" y="9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B20B9CD8-831C-4E5C-B905-3E12483178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939" y="497036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2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302A7444-E193-4080-A1F3-79FC6E394F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8314" y="497036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1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FEDFB1F-9509-477F-A595-6F59A12854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5039" y="497036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33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ECC8AFC1-BFCB-4726-87D9-FB4EF68754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5414" y="497036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24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5DE586D-C675-4E27-B85A-77C933BA99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2139" y="497036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8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F84354C2-CD4E-42BE-A3AF-EA07B644F8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7277" y="4970365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9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F7C71969-6C6D-4883-B6E2-2D566CB607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6227" y="4970365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46D59E5A-6910-485F-97F7-0FE4D4FF91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7939" y="5236681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73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5E4135C4-3BB4-414D-999D-19AE16A1FD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8314" y="5236681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69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9B18CA8F-EBC3-4D38-B98C-C98E901B90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5039" y="5236681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21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833E561-5883-434B-BA6B-C083E0B1D3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5414" y="5236681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6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21FD3E5D-B0D2-41B2-B2F4-442715D4C5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9127" y="5236681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96703819-E091-454F-A3EA-AB32A22317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4264" y="5236681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BDA38DD8-916F-4B61-92C5-BFB41BFCCA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6227" y="5236681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5554CD4F-B381-4810-AE8A-F2E00B8D77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5706" y="4970365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4C65DE73-7388-4AC7-81CC-DF7748800A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8199" y="5236681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5">
            <a:extLst>
              <a:ext uri="{FF2B5EF4-FFF2-40B4-BE49-F238E27FC236}">
                <a16:creationId xmlns:a16="http://schemas.microsoft.com/office/drawing/2014/main" id="{0397CBB3-1D41-4B34-8C02-136686BD8619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6273" y="3217882"/>
            <a:ext cx="16351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56">
            <a:extLst>
              <a:ext uri="{FF2B5EF4-FFF2-40B4-BE49-F238E27FC236}">
                <a16:creationId xmlns:a16="http://schemas.microsoft.com/office/drawing/2014/main" id="{8FCFA66D-DA95-4FB2-8F11-96BD4FB2D12A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6273" y="3423890"/>
            <a:ext cx="163513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58">
            <a:extLst>
              <a:ext uri="{FF2B5EF4-FFF2-40B4-BE49-F238E27FC236}">
                <a16:creationId xmlns:a16="http://schemas.microsoft.com/office/drawing/2014/main" id="{4EAFAAAE-A8D6-4E22-8585-E17B4D5F40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9134" y="3088426"/>
            <a:ext cx="5903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os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59">
            <a:extLst>
              <a:ext uri="{FF2B5EF4-FFF2-40B4-BE49-F238E27FC236}">
                <a16:creationId xmlns:a16="http://schemas.microsoft.com/office/drawing/2014/main" id="{37B9501C-19CF-4DDB-8F97-89C1BF3074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7098" y="3325480"/>
            <a:ext cx="41299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BRT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35">
            <a:extLst>
              <a:ext uri="{FF2B5EF4-FFF2-40B4-BE49-F238E27FC236}">
                <a16:creationId xmlns:a16="http://schemas.microsoft.com/office/drawing/2014/main" id="{F991D47A-E8FA-47F2-B0F3-967CA2ADD1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1348" y="4295242"/>
            <a:ext cx="4857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ED2D7791-7645-479D-8FB6-28032261F91C}"/>
              </a:ext>
            </a:extLst>
          </p:cNvPr>
          <p:cNvSpPr txBox="1"/>
          <p:nvPr/>
        </p:nvSpPr>
        <p:spPr>
          <a:xfrm>
            <a:off x="3407998" y="3388097"/>
            <a:ext cx="11360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2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72">
            <a:extLst>
              <a:ext uri="{FF2B5EF4-FFF2-40B4-BE49-F238E27FC236}">
                <a16:creationId xmlns:a16="http://schemas.microsoft.com/office/drawing/2014/main" id="{7A4C6FA4-D929-40BD-A8D0-5C2F9DD366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7044" y="4650067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7291C5F-441C-9248-ECE7-0CEF330FD00D}"/>
              </a:ext>
            </a:extLst>
          </p:cNvPr>
          <p:cNvSpPr txBox="1"/>
          <p:nvPr/>
        </p:nvSpPr>
        <p:spPr>
          <a:xfrm>
            <a:off x="1796316" y="1573029"/>
            <a:ext cx="458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32368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2FCFB67-544D-4466-A873-FEC737CCBA80}"/>
              </a:ext>
            </a:extLst>
          </p:cNvPr>
          <p:cNvGrpSpPr/>
          <p:nvPr/>
        </p:nvGrpSpPr>
        <p:grpSpPr>
          <a:xfrm>
            <a:off x="2050737" y="1047994"/>
            <a:ext cx="4636097" cy="3619960"/>
            <a:chOff x="2286711" y="1530361"/>
            <a:chExt cx="4764538" cy="3565481"/>
          </a:xfrm>
        </p:grpSpPr>
        <p:sp>
          <p:nvSpPr>
            <p:cNvPr id="6" name="Line 5">
              <a:extLst>
                <a:ext uri="{FF2B5EF4-FFF2-40B4-BE49-F238E27FC236}">
                  <a16:creationId xmlns:a16="http://schemas.microsoft.com/office/drawing/2014/main" id="{39FE1D2C-8EAC-4B7A-B7C6-737D5A3463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6126" y="4172946"/>
              <a:ext cx="33251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Line 6">
              <a:extLst>
                <a:ext uri="{FF2B5EF4-FFF2-40B4-BE49-F238E27FC236}">
                  <a16:creationId xmlns:a16="http://schemas.microsoft.com/office/drawing/2014/main" id="{FC42CE01-F43A-4AC7-96AB-66625E4B74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6126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Line 7">
              <a:extLst>
                <a:ext uri="{FF2B5EF4-FFF2-40B4-BE49-F238E27FC236}">
                  <a16:creationId xmlns:a16="http://schemas.microsoft.com/office/drawing/2014/main" id="{0FF54752-946E-4D1C-839B-BA6220DDEF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6692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8">
              <a:extLst>
                <a:ext uri="{FF2B5EF4-FFF2-40B4-BE49-F238E27FC236}">
                  <a16:creationId xmlns:a16="http://schemas.microsoft.com/office/drawing/2014/main" id="{29284937-659E-47E1-A873-1AB046D609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65013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9">
              <a:extLst>
                <a:ext uri="{FF2B5EF4-FFF2-40B4-BE49-F238E27FC236}">
                  <a16:creationId xmlns:a16="http://schemas.microsoft.com/office/drawing/2014/main" id="{1678F69E-0A0C-4546-BD29-F9E1EE7580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15580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10">
              <a:extLst>
                <a:ext uri="{FF2B5EF4-FFF2-40B4-BE49-F238E27FC236}">
                  <a16:creationId xmlns:a16="http://schemas.microsoft.com/office/drawing/2014/main" id="{0BA90923-C189-4931-8591-0428D43F4C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2349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11">
              <a:extLst>
                <a:ext uri="{FF2B5EF4-FFF2-40B4-BE49-F238E27FC236}">
                  <a16:creationId xmlns:a16="http://schemas.microsoft.com/office/drawing/2014/main" id="{AC31C0D0-D148-4CC5-82D7-4B63DA08A5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0670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2">
              <a:extLst>
                <a:ext uri="{FF2B5EF4-FFF2-40B4-BE49-F238E27FC236}">
                  <a16:creationId xmlns:a16="http://schemas.microsoft.com/office/drawing/2014/main" id="{2F0708FB-ECD5-4289-8B4F-E660CA3B84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81237" y="4172946"/>
              <a:ext cx="0" cy="7190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251FBB38-C703-4AC9-9802-8C35057DF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0294" y="4341928"/>
              <a:ext cx="9225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F67C9E9-A2E1-44FD-9189-325DB2F343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9842" y="4341928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15D1525-F15B-407C-8831-688B9370C8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8163" y="4341928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F811A0F-7606-46CF-A11A-31F8FBDE9F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8730" y="4341928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68C96E1C-B77A-4B4E-9851-0B61E54E7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5499" y="4341928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D554EE75-CB6E-4FC8-82EF-A98FBC6117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2802" y="4341928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D55B978-B64B-4E0C-88FF-E52656807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3369" y="4341928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20">
              <a:extLst>
                <a:ext uri="{FF2B5EF4-FFF2-40B4-BE49-F238E27FC236}">
                  <a16:creationId xmlns:a16="http://schemas.microsoft.com/office/drawing/2014/main" id="{2E2A192B-E889-4A69-8B92-78CAA52909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4299" y="1627436"/>
              <a:ext cx="0" cy="243944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21">
              <a:extLst>
                <a:ext uri="{FF2B5EF4-FFF2-40B4-BE49-F238E27FC236}">
                  <a16:creationId xmlns:a16="http://schemas.microsoft.com/office/drawing/2014/main" id="{EDA4CFCA-3A87-4D89-BCFB-409589A374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54510" y="4066883"/>
              <a:ext cx="697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2">
              <a:extLst>
                <a:ext uri="{FF2B5EF4-FFF2-40B4-BE49-F238E27FC236}">
                  <a16:creationId xmlns:a16="http://schemas.microsoft.com/office/drawing/2014/main" id="{68ADAC74-8101-40E9-AA40-8313A83AA6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54510" y="3583308"/>
              <a:ext cx="697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3">
              <a:extLst>
                <a:ext uri="{FF2B5EF4-FFF2-40B4-BE49-F238E27FC236}">
                  <a16:creationId xmlns:a16="http://schemas.microsoft.com/office/drawing/2014/main" id="{3DAE8363-7C7B-4276-9251-199CA6FD62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54510" y="3097935"/>
              <a:ext cx="697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4">
              <a:extLst>
                <a:ext uri="{FF2B5EF4-FFF2-40B4-BE49-F238E27FC236}">
                  <a16:creationId xmlns:a16="http://schemas.microsoft.com/office/drawing/2014/main" id="{73D856ED-8207-4EB5-8A32-D4B6E76C0A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54510" y="2605372"/>
              <a:ext cx="697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5">
              <a:extLst>
                <a:ext uri="{FF2B5EF4-FFF2-40B4-BE49-F238E27FC236}">
                  <a16:creationId xmlns:a16="http://schemas.microsoft.com/office/drawing/2014/main" id="{EBD6C716-CBD3-49D5-A388-73BB02AB28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54510" y="2119999"/>
              <a:ext cx="697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6">
              <a:extLst>
                <a:ext uri="{FF2B5EF4-FFF2-40B4-BE49-F238E27FC236}">
                  <a16:creationId xmlns:a16="http://schemas.microsoft.com/office/drawing/2014/main" id="{7112E389-631B-49F5-8714-03FF4E5AE0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54510" y="1627436"/>
              <a:ext cx="697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36E64923-1789-4780-B96C-1A8530E14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3" y="3984794"/>
              <a:ext cx="230637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F06E2895-35F1-4E42-B7E0-A93D081214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3" y="3501218"/>
              <a:ext cx="230637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8ACC6445-E32D-4585-8EAC-C6A8B1A32E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3" y="3006858"/>
              <a:ext cx="230637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B18703E5-8322-43BC-9349-9D2BC8C24E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3" y="2523282"/>
              <a:ext cx="230637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57F65BB0-667E-4C63-943A-EB4CABBE45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3" y="2028921"/>
              <a:ext cx="230637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ED4E8FBF-DE5B-4410-A50C-C22735A5E1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103" y="1545346"/>
              <a:ext cx="230637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34369586-E505-4746-A387-8446A5CA88F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4299" y="1530361"/>
              <a:ext cx="3588763" cy="2642585"/>
            </a:xfrm>
            <a:custGeom>
              <a:avLst/>
              <a:gdLst>
                <a:gd name="T0" fmla="*/ 0 w 515"/>
                <a:gd name="T1" fmla="*/ 0 h 327"/>
                <a:gd name="T2" fmla="*/ 0 w 515"/>
                <a:gd name="T3" fmla="*/ 327 h 327"/>
                <a:gd name="T4" fmla="*/ 515 w 515"/>
                <a:gd name="T5" fmla="*/ 327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327">
                  <a:moveTo>
                    <a:pt x="0" y="0"/>
                  </a:moveTo>
                  <a:lnTo>
                    <a:pt x="0" y="327"/>
                  </a:lnTo>
                  <a:lnTo>
                    <a:pt x="515" y="327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CF4AD3D4-DAE8-47F8-82CD-0D0E2821CF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020229" y="2646402"/>
              <a:ext cx="849374" cy="2214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BDE4D024-8EF0-41C5-B7DE-A96723A84618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6126" y="1627436"/>
              <a:ext cx="3736098" cy="201340"/>
            </a:xfrm>
            <a:custGeom>
              <a:avLst/>
              <a:gdLst>
                <a:gd name="T0" fmla="*/ 0 w 536"/>
                <a:gd name="T1" fmla="*/ 0 h 25"/>
                <a:gd name="T2" fmla="*/ 47 w 536"/>
                <a:gd name="T3" fmla="*/ 0 h 25"/>
                <a:gd name="T4" fmla="*/ 47 w 536"/>
                <a:gd name="T5" fmla="*/ 1 h 25"/>
                <a:gd name="T6" fmla="*/ 123 w 536"/>
                <a:gd name="T7" fmla="*/ 1 h 25"/>
                <a:gd name="T8" fmla="*/ 123 w 536"/>
                <a:gd name="T9" fmla="*/ 2 h 25"/>
                <a:gd name="T10" fmla="*/ 143 w 536"/>
                <a:gd name="T11" fmla="*/ 2 h 25"/>
                <a:gd name="T12" fmla="*/ 143 w 536"/>
                <a:gd name="T13" fmla="*/ 3 h 25"/>
                <a:gd name="T14" fmla="*/ 191 w 536"/>
                <a:gd name="T15" fmla="*/ 3 h 25"/>
                <a:gd name="T16" fmla="*/ 191 w 536"/>
                <a:gd name="T17" fmla="*/ 5 h 25"/>
                <a:gd name="T18" fmla="*/ 219 w 536"/>
                <a:gd name="T19" fmla="*/ 5 h 25"/>
                <a:gd name="T20" fmla="*/ 219 w 536"/>
                <a:gd name="T21" fmla="*/ 6 h 25"/>
                <a:gd name="T22" fmla="*/ 226 w 536"/>
                <a:gd name="T23" fmla="*/ 6 h 25"/>
                <a:gd name="T24" fmla="*/ 226 w 536"/>
                <a:gd name="T25" fmla="*/ 7 h 25"/>
                <a:gd name="T26" fmla="*/ 246 w 536"/>
                <a:gd name="T27" fmla="*/ 7 h 25"/>
                <a:gd name="T28" fmla="*/ 246 w 536"/>
                <a:gd name="T29" fmla="*/ 9 h 25"/>
                <a:gd name="T30" fmla="*/ 282 w 536"/>
                <a:gd name="T31" fmla="*/ 9 h 25"/>
                <a:gd name="T32" fmla="*/ 282 w 536"/>
                <a:gd name="T33" fmla="*/ 10 h 25"/>
                <a:gd name="T34" fmla="*/ 334 w 536"/>
                <a:gd name="T35" fmla="*/ 10 h 25"/>
                <a:gd name="T36" fmla="*/ 334 w 536"/>
                <a:gd name="T37" fmla="*/ 12 h 25"/>
                <a:gd name="T38" fmla="*/ 370 w 536"/>
                <a:gd name="T39" fmla="*/ 12 h 25"/>
                <a:gd name="T40" fmla="*/ 370 w 536"/>
                <a:gd name="T41" fmla="*/ 15 h 25"/>
                <a:gd name="T42" fmla="*/ 485 w 536"/>
                <a:gd name="T43" fmla="*/ 15 h 25"/>
                <a:gd name="T44" fmla="*/ 485 w 536"/>
                <a:gd name="T45" fmla="*/ 20 h 25"/>
                <a:gd name="T46" fmla="*/ 493 w 536"/>
                <a:gd name="T47" fmla="*/ 20 h 25"/>
                <a:gd name="T48" fmla="*/ 493 w 536"/>
                <a:gd name="T49" fmla="*/ 25 h 25"/>
                <a:gd name="T50" fmla="*/ 536 w 536"/>
                <a:gd name="T51" fmla="*/ 25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536" h="25">
                  <a:moveTo>
                    <a:pt x="0" y="0"/>
                  </a:moveTo>
                  <a:lnTo>
                    <a:pt x="47" y="0"/>
                  </a:lnTo>
                  <a:lnTo>
                    <a:pt x="47" y="1"/>
                  </a:lnTo>
                  <a:lnTo>
                    <a:pt x="123" y="1"/>
                  </a:lnTo>
                  <a:lnTo>
                    <a:pt x="123" y="2"/>
                  </a:lnTo>
                  <a:lnTo>
                    <a:pt x="143" y="2"/>
                  </a:lnTo>
                  <a:lnTo>
                    <a:pt x="143" y="3"/>
                  </a:lnTo>
                  <a:lnTo>
                    <a:pt x="191" y="3"/>
                  </a:lnTo>
                  <a:lnTo>
                    <a:pt x="191" y="5"/>
                  </a:lnTo>
                  <a:lnTo>
                    <a:pt x="219" y="5"/>
                  </a:lnTo>
                  <a:lnTo>
                    <a:pt x="219" y="6"/>
                  </a:lnTo>
                  <a:lnTo>
                    <a:pt x="226" y="6"/>
                  </a:lnTo>
                  <a:lnTo>
                    <a:pt x="226" y="7"/>
                  </a:lnTo>
                  <a:lnTo>
                    <a:pt x="246" y="7"/>
                  </a:lnTo>
                  <a:lnTo>
                    <a:pt x="246" y="9"/>
                  </a:lnTo>
                  <a:lnTo>
                    <a:pt x="282" y="9"/>
                  </a:lnTo>
                  <a:lnTo>
                    <a:pt x="282" y="10"/>
                  </a:lnTo>
                  <a:lnTo>
                    <a:pt x="334" y="10"/>
                  </a:lnTo>
                  <a:lnTo>
                    <a:pt x="334" y="12"/>
                  </a:lnTo>
                  <a:lnTo>
                    <a:pt x="370" y="12"/>
                  </a:lnTo>
                  <a:lnTo>
                    <a:pt x="370" y="15"/>
                  </a:lnTo>
                  <a:lnTo>
                    <a:pt x="485" y="15"/>
                  </a:lnTo>
                  <a:lnTo>
                    <a:pt x="485" y="20"/>
                  </a:lnTo>
                  <a:lnTo>
                    <a:pt x="493" y="20"/>
                  </a:lnTo>
                  <a:lnTo>
                    <a:pt x="493" y="25"/>
                  </a:lnTo>
                  <a:lnTo>
                    <a:pt x="536" y="25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578E08A3-0D94-47DA-A94E-87F2C7619811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6126" y="1627436"/>
              <a:ext cx="3736098" cy="120445"/>
            </a:xfrm>
            <a:custGeom>
              <a:avLst/>
              <a:gdLst>
                <a:gd name="T0" fmla="*/ 0 w 536"/>
                <a:gd name="T1" fmla="*/ 0 h 15"/>
                <a:gd name="T2" fmla="*/ 54 w 536"/>
                <a:gd name="T3" fmla="*/ 0 h 15"/>
                <a:gd name="T4" fmla="*/ 54 w 536"/>
                <a:gd name="T5" fmla="*/ 2 h 15"/>
                <a:gd name="T6" fmla="*/ 240 w 536"/>
                <a:gd name="T7" fmla="*/ 2 h 15"/>
                <a:gd name="T8" fmla="*/ 240 w 536"/>
                <a:gd name="T9" fmla="*/ 4 h 15"/>
                <a:gd name="T10" fmla="*/ 278 w 536"/>
                <a:gd name="T11" fmla="*/ 4 h 15"/>
                <a:gd name="T12" fmla="*/ 278 w 536"/>
                <a:gd name="T13" fmla="*/ 6 h 15"/>
                <a:gd name="T14" fmla="*/ 294 w 536"/>
                <a:gd name="T15" fmla="*/ 6 h 15"/>
                <a:gd name="T16" fmla="*/ 294 w 536"/>
                <a:gd name="T17" fmla="*/ 9 h 15"/>
                <a:gd name="T18" fmla="*/ 342 w 536"/>
                <a:gd name="T19" fmla="*/ 9 h 15"/>
                <a:gd name="T20" fmla="*/ 342 w 536"/>
                <a:gd name="T21" fmla="*/ 15 h 15"/>
                <a:gd name="T22" fmla="*/ 536 w 536"/>
                <a:gd name="T23" fmla="*/ 15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36" h="15">
                  <a:moveTo>
                    <a:pt x="0" y="0"/>
                  </a:moveTo>
                  <a:lnTo>
                    <a:pt x="54" y="0"/>
                  </a:lnTo>
                  <a:lnTo>
                    <a:pt x="54" y="2"/>
                  </a:lnTo>
                  <a:lnTo>
                    <a:pt x="240" y="2"/>
                  </a:lnTo>
                  <a:lnTo>
                    <a:pt x="240" y="4"/>
                  </a:lnTo>
                  <a:lnTo>
                    <a:pt x="278" y="4"/>
                  </a:lnTo>
                  <a:lnTo>
                    <a:pt x="278" y="6"/>
                  </a:lnTo>
                  <a:lnTo>
                    <a:pt x="294" y="6"/>
                  </a:lnTo>
                  <a:lnTo>
                    <a:pt x="294" y="9"/>
                  </a:lnTo>
                  <a:lnTo>
                    <a:pt x="342" y="9"/>
                  </a:lnTo>
                  <a:lnTo>
                    <a:pt x="342" y="15"/>
                  </a:lnTo>
                  <a:lnTo>
                    <a:pt x="536" y="15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AEA67AE3-0F13-4F33-97BC-7857157773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8258" y="4624174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9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6C38F374-3E14-49A7-B78F-6F2B64EAE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8824" y="4624174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8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5D4E67E8-191F-4709-A3EC-4829184050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7145" y="4624174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C22108DE-4206-4B50-A7D9-760DC23416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7712" y="4624174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3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C546D3DF-0AE8-42FC-9134-E4BB1F9D85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4482" y="4624174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8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E13B34CF-0E69-435E-8771-4315933C4B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3820" y="4624174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FDC20D6A-4052-4D7E-8998-3E21728473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4387" y="4624174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ACA337A3-2000-4CC7-9E1A-BFBE6B7EAC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8258" y="4883640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D2752575-CBED-4AE0-A569-82FE6C3665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8824" y="4883640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C10FD02C-BDCE-42C8-8EBF-5B813069CE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7145" y="4883640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7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6FD418A2-70A5-40A8-8FE5-C53F94E8A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7712" y="4883640"/>
              <a:ext cx="276765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0DBAC123-0D86-4B7D-B92C-067B71C209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5499" y="4883640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FCD5C5BA-3F82-45BB-A9E9-A60BAF9B98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3820" y="4883640"/>
              <a:ext cx="184510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7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19F05AC-EB4D-4BC2-8630-63E80CC723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4387" y="4883640"/>
              <a:ext cx="174362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AB5BCE61-1759-412E-AC9B-726BEAB3C4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6711" y="4624174"/>
              <a:ext cx="709969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5F3358E6-CDBA-471D-B60F-AAC48C2E7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3183" y="4883640"/>
              <a:ext cx="497651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Line 55">
              <a:extLst>
                <a:ext uri="{FF2B5EF4-FFF2-40B4-BE49-F238E27FC236}">
                  <a16:creationId xmlns:a16="http://schemas.microsoft.com/office/drawing/2014/main" id="{333B5DE7-D65A-4F1F-BB9B-DBBB8F7D18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8419" y="2907639"/>
              <a:ext cx="163513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Line 56">
              <a:extLst>
                <a:ext uri="{FF2B5EF4-FFF2-40B4-BE49-F238E27FC236}">
                  <a16:creationId xmlns:a16="http://schemas.microsoft.com/office/drawing/2014/main" id="{43A9933C-FAC9-4D6B-B9C5-3A0444C53F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88419" y="3113647"/>
              <a:ext cx="163513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58">
              <a:extLst>
                <a:ext uri="{FF2B5EF4-FFF2-40B4-BE49-F238E27FC236}">
                  <a16:creationId xmlns:a16="http://schemas.microsoft.com/office/drawing/2014/main" id="{994BC516-8BC6-4A60-8736-13263A30D1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1280" y="2778183"/>
              <a:ext cx="709969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T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boost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59">
              <a:extLst>
                <a:ext uri="{FF2B5EF4-FFF2-40B4-BE49-F238E27FC236}">
                  <a16:creationId xmlns:a16="http://schemas.microsoft.com/office/drawing/2014/main" id="{C88D81D3-716F-41BD-BBDA-6AD5203AB8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9244" y="3015237"/>
              <a:ext cx="497651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BRT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35">
              <a:extLst>
                <a:ext uri="{FF2B5EF4-FFF2-40B4-BE49-F238E27FC236}">
                  <a16:creationId xmlns:a16="http://schemas.microsoft.com/office/drawing/2014/main" id="{1551F2E7-C891-415C-AC21-5E4120DF8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66532" y="3859382"/>
              <a:ext cx="583184" cy="212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1BEF8F78-1816-45A1-95CB-C5D10D93057C}"/>
                </a:ext>
              </a:extLst>
            </p:cNvPr>
            <p:cNvSpPr txBox="1"/>
            <p:nvPr/>
          </p:nvSpPr>
          <p:spPr>
            <a:xfrm>
              <a:off x="3407998" y="3388097"/>
              <a:ext cx="113600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</a:t>
              </a: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87</a:t>
              </a:r>
              <a:endPara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Rectangle 72">
            <a:extLst>
              <a:ext uri="{FF2B5EF4-FFF2-40B4-BE49-F238E27FC236}">
                <a16:creationId xmlns:a16="http://schemas.microsoft.com/office/drawing/2014/main" id="{DCC5DAB6-64A7-4C1D-90B5-69A9DCE5B6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5507" y="3890123"/>
            <a:ext cx="1421840" cy="22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0" lang="ja-JP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21BE3A4-533E-A656-A2E0-43C75373108E}"/>
              </a:ext>
            </a:extLst>
          </p:cNvPr>
          <p:cNvSpPr txBox="1"/>
          <p:nvPr/>
        </p:nvSpPr>
        <p:spPr>
          <a:xfrm>
            <a:off x="1815507" y="807172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D75A264-51AE-4B06-B3A9-D83135454238}"/>
              </a:ext>
            </a:extLst>
          </p:cNvPr>
          <p:cNvSpPr txBox="1"/>
          <p:nvPr/>
        </p:nvSpPr>
        <p:spPr>
          <a:xfrm>
            <a:off x="338667" y="4978400"/>
            <a:ext cx="82211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. </a:t>
            </a:r>
            <a:r>
              <a:rPr lang="en-US" dirty="0"/>
              <a:t>Overall survival rate (OS), a) Comparison of </a:t>
            </a:r>
            <a:r>
              <a:rPr lang="en-US" dirty="0" err="1"/>
              <a:t>bDFS</a:t>
            </a:r>
            <a:r>
              <a:rPr lang="en-US" dirty="0"/>
              <a:t> between EBRT and BT-boost in VHR-1 group. b) Comparison of </a:t>
            </a:r>
            <a:r>
              <a:rPr lang="en-US" dirty="0" err="1"/>
              <a:t>bDFS</a:t>
            </a:r>
            <a:r>
              <a:rPr lang="en-US" dirty="0"/>
              <a:t> between EBRT and BT-boost in VHR-0 group. c) Comparison of </a:t>
            </a:r>
            <a:r>
              <a:rPr lang="en-US" dirty="0" err="1"/>
              <a:t>bDFS</a:t>
            </a:r>
            <a:r>
              <a:rPr lang="en-US" dirty="0"/>
              <a:t> between EBRT and BT-boost in intermediate-risk group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7728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31</TotalTime>
  <Words>1188</Words>
  <Application>Microsoft Office PowerPoint</Application>
  <PresentationFormat>On-screen Show (4:3)</PresentationFormat>
  <Paragraphs>32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ewlett-Packard Company</dc:creator>
  <cp:lastModifiedBy>MDPI</cp:lastModifiedBy>
  <cp:revision>122</cp:revision>
  <cp:lastPrinted>2022-04-27T09:33:05Z</cp:lastPrinted>
  <dcterms:created xsi:type="dcterms:W3CDTF">2022-02-15T07:55:27Z</dcterms:created>
  <dcterms:modified xsi:type="dcterms:W3CDTF">2022-06-17T02:42:29Z</dcterms:modified>
</cp:coreProperties>
</file>